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ags/tag1.xml" ContentType="application/vnd.openxmlformats-officedocument.presentationml.tag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notesSlides/notesSlide4.xml" ContentType="application/vnd.openxmlformats-officedocument.presentationml.notesSlid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notesSlides/notesSlide5.xml" ContentType="application/vnd.openxmlformats-officedocument.presentationml.notesSlid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charts/chart18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ppt/charts/chart19.xml" ContentType="application/vnd.openxmlformats-officedocument.drawingml.chart+xml"/>
  <Override PartName="/ppt/charts/style19.xml" ContentType="application/vnd.ms-office.chartstyle+xml"/>
  <Override PartName="/ppt/charts/colors19.xml" ContentType="application/vnd.ms-office.chartcolorstyle+xml"/>
  <Override PartName="/ppt/charts/chart20.xml" ContentType="application/vnd.openxmlformats-officedocument.drawingml.chart+xml"/>
  <Override PartName="/ppt/charts/style20.xml" ContentType="application/vnd.ms-office.chartstyle+xml"/>
  <Override PartName="/ppt/charts/colors20.xml" ContentType="application/vnd.ms-office.chartcolorstyle+xml"/>
  <Override PartName="/ppt/notesSlides/notesSlide6.xml" ContentType="application/vnd.openxmlformats-officedocument.presentationml.notesSlide+xml"/>
  <Override PartName="/ppt/charts/chart21.xml" ContentType="application/vnd.openxmlformats-officedocument.drawingml.chart+xml"/>
  <Override PartName="/ppt/charts/style21.xml" ContentType="application/vnd.ms-office.chartstyle+xml"/>
  <Override PartName="/ppt/charts/colors21.xml" ContentType="application/vnd.ms-office.chartcolorstyle+xml"/>
  <Override PartName="/ppt/charts/chart22.xml" ContentType="application/vnd.openxmlformats-officedocument.drawingml.chart+xml"/>
  <Override PartName="/ppt/charts/style22.xml" ContentType="application/vnd.ms-office.chartstyle+xml"/>
  <Override PartName="/ppt/charts/colors22.xml" ContentType="application/vnd.ms-office.chartcolorstyle+xml"/>
  <Override PartName="/ppt/charts/chart23.xml" ContentType="application/vnd.openxmlformats-officedocument.drawingml.chart+xml"/>
  <Override PartName="/ppt/charts/style23.xml" ContentType="application/vnd.ms-office.chartstyle+xml"/>
  <Override PartName="/ppt/charts/colors23.xml" ContentType="application/vnd.ms-office.chartcolorstyle+xml"/>
  <Override PartName="/ppt/charts/chart24.xml" ContentType="application/vnd.openxmlformats-officedocument.drawingml.chart+xml"/>
  <Override PartName="/ppt/charts/style24.xml" ContentType="application/vnd.ms-office.chartstyle+xml"/>
  <Override PartName="/ppt/charts/colors24.xml" ContentType="application/vnd.ms-office.chartcolorstyle+xml"/>
  <Override PartName="/ppt/charts/chart25.xml" ContentType="application/vnd.openxmlformats-officedocument.drawingml.chart+xml"/>
  <Override PartName="/ppt/charts/style25.xml" ContentType="application/vnd.ms-office.chartstyle+xml"/>
  <Override PartName="/ppt/charts/colors25.xml" ContentType="application/vnd.ms-office.chartcolorstyle+xml"/>
  <Override PartName="/ppt/charts/chart26.xml" ContentType="application/vnd.openxmlformats-officedocument.drawingml.chart+xml"/>
  <Override PartName="/ppt/charts/style26.xml" ContentType="application/vnd.ms-office.chartstyle+xml"/>
  <Override PartName="/ppt/charts/colors26.xml" ContentType="application/vnd.ms-office.chartcolorstyle+xml"/>
  <Override PartName="/ppt/notesSlides/notesSlide7.xml" ContentType="application/vnd.openxmlformats-officedocument.presentationml.notesSlide+xml"/>
  <Override PartName="/ppt/charts/chart27.xml" ContentType="application/vnd.openxmlformats-officedocument.drawingml.chart+xml"/>
  <Override PartName="/ppt/charts/style27.xml" ContentType="application/vnd.ms-office.chartstyle+xml"/>
  <Override PartName="/ppt/charts/colors27.xml" ContentType="application/vnd.ms-office.chartcolorstyle+xml"/>
  <Override PartName="/ppt/charts/chart28.xml" ContentType="application/vnd.openxmlformats-officedocument.drawingml.chart+xml"/>
  <Override PartName="/ppt/charts/style28.xml" ContentType="application/vnd.ms-office.chartstyle+xml"/>
  <Override PartName="/ppt/charts/colors28.xml" ContentType="application/vnd.ms-office.chartcolorstyle+xml"/>
  <Override PartName="/ppt/charts/chart29.xml" ContentType="application/vnd.openxmlformats-officedocument.drawingml.chart+xml"/>
  <Override PartName="/ppt/charts/style29.xml" ContentType="application/vnd.ms-office.chartstyle+xml"/>
  <Override PartName="/ppt/charts/colors29.xml" ContentType="application/vnd.ms-office.chartcolorstyle+xml"/>
  <Override PartName="/ppt/charts/chart30.xml" ContentType="application/vnd.openxmlformats-officedocument.drawingml.chart+xml"/>
  <Override PartName="/ppt/charts/style30.xml" ContentType="application/vnd.ms-office.chartstyle+xml"/>
  <Override PartName="/ppt/charts/colors30.xml" ContentType="application/vnd.ms-office.chartcolorstyle+xml"/>
  <Override PartName="/ppt/charts/chart31.xml" ContentType="application/vnd.openxmlformats-officedocument.drawingml.chart+xml"/>
  <Override PartName="/ppt/charts/style31.xml" ContentType="application/vnd.ms-office.chartstyle+xml"/>
  <Override PartName="/ppt/charts/colors31.xml" ContentType="application/vnd.ms-office.chartcolorstyle+xml"/>
  <Override PartName="/ppt/charts/chart32.xml" ContentType="application/vnd.openxmlformats-officedocument.drawingml.chart+xml"/>
  <Override PartName="/ppt/charts/style32.xml" ContentType="application/vnd.ms-office.chartstyle+xml"/>
  <Override PartName="/ppt/charts/colors32.xml" ContentType="application/vnd.ms-office.chartcolorstyle+xml"/>
  <Override PartName="/ppt/notesSlides/notesSlide8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2089" r:id="rId2"/>
    <p:sldId id="263" r:id="rId3"/>
    <p:sldId id="270" r:id="rId4"/>
    <p:sldId id="22074" r:id="rId5"/>
    <p:sldId id="22080" r:id="rId6"/>
    <p:sldId id="22081" r:id="rId7"/>
    <p:sldId id="22088" r:id="rId8"/>
    <p:sldId id="22087" r:id="rId9"/>
  </p:sldIdLst>
  <p:sldSz cx="12192000" cy="6858000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石川 麻倫" initials="石川" lastIdx="5" clrIdx="0">
    <p:extLst>
      <p:ext uri="{19B8F6BF-5375-455C-9EA6-DF929625EA0E}">
        <p15:presenceInfo xmlns:p15="http://schemas.microsoft.com/office/powerpoint/2012/main" userId="671b21c72070ca9d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CC"/>
    <a:srgbClr val="C0C0C0"/>
    <a:srgbClr val="FFDDFF"/>
    <a:srgbClr val="EAEAEA"/>
    <a:srgbClr val="CCCCFF"/>
    <a:srgbClr val="CC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76931" autoAdjust="0"/>
  </p:normalViewPr>
  <p:slideViewPr>
    <p:cSldViewPr snapToGrid="0">
      <p:cViewPr varScale="1">
        <p:scale>
          <a:sx n="94" d="100"/>
          <a:sy n="94" d="100"/>
        </p:scale>
        <p:origin x="106" y="11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1282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commentAuthors" Target="commentAuthors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rin Ishikawa" userId="671b21c72070ca9d" providerId="LiveId" clId="{93254D41-9D0D-4885-A6B4-0DBD32CDB9E5}"/>
    <pc:docChg chg="modSld">
      <pc:chgData name="Marin Ishikawa" userId="671b21c72070ca9d" providerId="LiveId" clId="{93254D41-9D0D-4885-A6B4-0DBD32CDB9E5}" dt="2024-04-14T01:18:41.295" v="363" actId="1035"/>
      <pc:docMkLst>
        <pc:docMk/>
      </pc:docMkLst>
      <pc:sldChg chg="modSp mod">
        <pc:chgData name="Marin Ishikawa" userId="671b21c72070ca9d" providerId="LiveId" clId="{93254D41-9D0D-4885-A6B4-0DBD32CDB9E5}" dt="2024-04-14T01:08:21.175" v="11" actId="14100"/>
        <pc:sldMkLst>
          <pc:docMk/>
          <pc:sldMk cId="3098703082" sldId="270"/>
        </pc:sldMkLst>
        <pc:graphicFrameChg chg="mod">
          <ac:chgData name="Marin Ishikawa" userId="671b21c72070ca9d" providerId="LiveId" clId="{93254D41-9D0D-4885-A6B4-0DBD32CDB9E5}" dt="2024-04-14T01:08:21.175" v="11" actId="14100"/>
          <ac:graphicFrameMkLst>
            <pc:docMk/>
            <pc:sldMk cId="3098703082" sldId="270"/>
            <ac:graphicFrameMk id="4" creationId="{21856FE8-3386-EC7E-E188-27082A49C8C1}"/>
          </ac:graphicFrameMkLst>
        </pc:graphicFrameChg>
        <pc:graphicFrameChg chg="mod">
          <ac:chgData name="Marin Ishikawa" userId="671b21c72070ca9d" providerId="LiveId" clId="{93254D41-9D0D-4885-A6B4-0DBD32CDB9E5}" dt="2024-04-14T01:07:25.700" v="3" actId="14100"/>
          <ac:graphicFrameMkLst>
            <pc:docMk/>
            <pc:sldMk cId="3098703082" sldId="270"/>
            <ac:graphicFrameMk id="5" creationId="{09FFD5C0-2BA0-CC08-59A6-38B0D0DC35F7}"/>
          </ac:graphicFrameMkLst>
        </pc:graphicFrameChg>
        <pc:graphicFrameChg chg="mod">
          <ac:chgData name="Marin Ishikawa" userId="671b21c72070ca9d" providerId="LiveId" clId="{93254D41-9D0D-4885-A6B4-0DBD32CDB9E5}" dt="2024-04-14T01:07:50.775" v="7" actId="14100"/>
          <ac:graphicFrameMkLst>
            <pc:docMk/>
            <pc:sldMk cId="3098703082" sldId="270"/>
            <ac:graphicFrameMk id="6" creationId="{042C91B3-A751-0BE8-777B-4DBB806FEA73}"/>
          </ac:graphicFrameMkLst>
        </pc:graphicFrameChg>
        <pc:graphicFrameChg chg="mod">
          <ac:chgData name="Marin Ishikawa" userId="671b21c72070ca9d" providerId="LiveId" clId="{93254D41-9D0D-4885-A6B4-0DBD32CDB9E5}" dt="2024-04-14T01:07:39.070" v="5" actId="14100"/>
          <ac:graphicFrameMkLst>
            <pc:docMk/>
            <pc:sldMk cId="3098703082" sldId="270"/>
            <ac:graphicFrameMk id="7" creationId="{F58D31C5-7D1B-4C71-2649-C7A3A57FF7D8}"/>
          </ac:graphicFrameMkLst>
        </pc:graphicFrameChg>
        <pc:graphicFrameChg chg="mod">
          <ac:chgData name="Marin Ishikawa" userId="671b21c72070ca9d" providerId="LiveId" clId="{93254D41-9D0D-4885-A6B4-0DBD32CDB9E5}" dt="2024-04-14T01:08:12.123" v="10" actId="1076"/>
          <ac:graphicFrameMkLst>
            <pc:docMk/>
            <pc:sldMk cId="3098703082" sldId="270"/>
            <ac:graphicFrameMk id="8" creationId="{FDF66F0C-F2CA-2CFB-348C-1F99E27F522D}"/>
          </ac:graphicFrameMkLst>
        </pc:graphicFrameChg>
      </pc:sldChg>
      <pc:sldChg chg="modSp mod">
        <pc:chgData name="Marin Ishikawa" userId="671b21c72070ca9d" providerId="LiveId" clId="{93254D41-9D0D-4885-A6B4-0DBD32CDB9E5}" dt="2024-04-14T01:10:24.597" v="35" actId="14100"/>
        <pc:sldMkLst>
          <pc:docMk/>
          <pc:sldMk cId="2682245182" sldId="22074"/>
        </pc:sldMkLst>
        <pc:graphicFrameChg chg="mod">
          <ac:chgData name="Marin Ishikawa" userId="671b21c72070ca9d" providerId="LiveId" clId="{93254D41-9D0D-4885-A6B4-0DBD32CDB9E5}" dt="2024-04-14T01:09:25.910" v="21" actId="14100"/>
          <ac:graphicFrameMkLst>
            <pc:docMk/>
            <pc:sldMk cId="2682245182" sldId="22074"/>
            <ac:graphicFrameMk id="3" creationId="{29470230-E339-70B9-58BF-EA991EDA28BA}"/>
          </ac:graphicFrameMkLst>
        </pc:graphicFrameChg>
        <pc:graphicFrameChg chg="mod">
          <ac:chgData name="Marin Ishikawa" userId="671b21c72070ca9d" providerId="LiveId" clId="{93254D41-9D0D-4885-A6B4-0DBD32CDB9E5}" dt="2024-04-14T01:10:24.597" v="35" actId="14100"/>
          <ac:graphicFrameMkLst>
            <pc:docMk/>
            <pc:sldMk cId="2682245182" sldId="22074"/>
            <ac:graphicFrameMk id="4" creationId="{0602FC49-2481-E23A-5D2D-FD2A297A2DAA}"/>
          </ac:graphicFrameMkLst>
        </pc:graphicFrameChg>
        <pc:graphicFrameChg chg="mod">
          <ac:chgData name="Marin Ishikawa" userId="671b21c72070ca9d" providerId="LiveId" clId="{93254D41-9D0D-4885-A6B4-0DBD32CDB9E5}" dt="2024-04-14T01:08:50.922" v="15" actId="14100"/>
          <ac:graphicFrameMkLst>
            <pc:docMk/>
            <pc:sldMk cId="2682245182" sldId="22074"/>
            <ac:graphicFrameMk id="5" creationId="{A0EAE5D2-966C-DE12-F553-B2C5AE4317DD}"/>
          </ac:graphicFrameMkLst>
        </pc:graphicFrameChg>
        <pc:graphicFrameChg chg="mod">
          <ac:chgData name="Marin Ishikawa" userId="671b21c72070ca9d" providerId="LiveId" clId="{93254D41-9D0D-4885-A6B4-0DBD32CDB9E5}" dt="2024-04-14T01:09:51.696" v="28" actId="14100"/>
          <ac:graphicFrameMkLst>
            <pc:docMk/>
            <pc:sldMk cId="2682245182" sldId="22074"/>
            <ac:graphicFrameMk id="6" creationId="{9F1DD313-1037-504A-52B6-CF8F292735B2}"/>
          </ac:graphicFrameMkLst>
        </pc:graphicFrameChg>
        <pc:graphicFrameChg chg="mod">
          <ac:chgData name="Marin Ishikawa" userId="671b21c72070ca9d" providerId="LiveId" clId="{93254D41-9D0D-4885-A6B4-0DBD32CDB9E5}" dt="2024-04-14T01:09:00.628" v="17" actId="14100"/>
          <ac:graphicFrameMkLst>
            <pc:docMk/>
            <pc:sldMk cId="2682245182" sldId="22074"/>
            <ac:graphicFrameMk id="7" creationId="{CB6E56A3-43FC-C138-4F35-938A2D742A5D}"/>
          </ac:graphicFrameMkLst>
        </pc:graphicFrameChg>
        <pc:graphicFrameChg chg="mod">
          <ac:chgData name="Marin Ishikawa" userId="671b21c72070ca9d" providerId="LiveId" clId="{93254D41-9D0D-4885-A6B4-0DBD32CDB9E5}" dt="2024-04-14T01:10:10.176" v="33" actId="14100"/>
          <ac:graphicFrameMkLst>
            <pc:docMk/>
            <pc:sldMk cId="2682245182" sldId="22074"/>
            <ac:graphicFrameMk id="8" creationId="{10FA36D0-2452-E2EF-252E-A47062BB1FCA}"/>
          </ac:graphicFrameMkLst>
        </pc:graphicFrameChg>
      </pc:sldChg>
      <pc:sldChg chg="modSp mod">
        <pc:chgData name="Marin Ishikawa" userId="671b21c72070ca9d" providerId="LiveId" clId="{93254D41-9D0D-4885-A6B4-0DBD32CDB9E5}" dt="2024-04-14T01:12:51.875" v="50" actId="14100"/>
        <pc:sldMkLst>
          <pc:docMk/>
          <pc:sldMk cId="858737660" sldId="22080"/>
        </pc:sldMkLst>
        <pc:graphicFrameChg chg="mod">
          <ac:chgData name="Marin Ishikawa" userId="671b21c72070ca9d" providerId="LiveId" clId="{93254D41-9D0D-4885-A6B4-0DBD32CDB9E5}" dt="2024-04-14T01:11:18.907" v="40" actId="14100"/>
          <ac:graphicFrameMkLst>
            <pc:docMk/>
            <pc:sldMk cId="858737660" sldId="22080"/>
            <ac:graphicFrameMk id="2" creationId="{CFCAF575-69D7-5AAF-A328-B803A0721745}"/>
          </ac:graphicFrameMkLst>
        </pc:graphicFrameChg>
        <pc:graphicFrameChg chg="mod">
          <ac:chgData name="Marin Ishikawa" userId="671b21c72070ca9d" providerId="LiveId" clId="{93254D41-9D0D-4885-A6B4-0DBD32CDB9E5}" dt="2024-04-14T01:12:29.537" v="47"/>
          <ac:graphicFrameMkLst>
            <pc:docMk/>
            <pc:sldMk cId="858737660" sldId="22080"/>
            <ac:graphicFrameMk id="13" creationId="{6476A253-286A-E25C-0DA0-C6F7339E4F85}"/>
          </ac:graphicFrameMkLst>
        </pc:graphicFrameChg>
        <pc:graphicFrameChg chg="mod">
          <ac:chgData name="Marin Ishikawa" userId="671b21c72070ca9d" providerId="LiveId" clId="{93254D41-9D0D-4885-A6B4-0DBD32CDB9E5}" dt="2024-04-14T01:12:51.875" v="50" actId="14100"/>
          <ac:graphicFrameMkLst>
            <pc:docMk/>
            <pc:sldMk cId="858737660" sldId="22080"/>
            <ac:graphicFrameMk id="14" creationId="{57E46507-8120-7C7A-874E-88518BB60BA4}"/>
          </ac:graphicFrameMkLst>
        </pc:graphicFrameChg>
        <pc:graphicFrameChg chg="mod">
          <ac:chgData name="Marin Ishikawa" userId="671b21c72070ca9d" providerId="LiveId" clId="{93254D41-9D0D-4885-A6B4-0DBD32CDB9E5}" dt="2024-04-14T01:11:47.884" v="42" actId="1076"/>
          <ac:graphicFrameMkLst>
            <pc:docMk/>
            <pc:sldMk cId="858737660" sldId="22080"/>
            <ac:graphicFrameMk id="15" creationId="{9E2435AD-3E48-1ED8-4DAC-33111A2F115B}"/>
          </ac:graphicFrameMkLst>
        </pc:graphicFrameChg>
        <pc:graphicFrameChg chg="mod">
          <ac:chgData name="Marin Ishikawa" userId="671b21c72070ca9d" providerId="LiveId" clId="{93254D41-9D0D-4885-A6B4-0DBD32CDB9E5}" dt="2024-04-14T01:12:24.176" v="46"/>
          <ac:graphicFrameMkLst>
            <pc:docMk/>
            <pc:sldMk cId="858737660" sldId="22080"/>
            <ac:graphicFrameMk id="16" creationId="{69C250F8-37C4-F471-5606-6839E9A5E371}"/>
          </ac:graphicFrameMkLst>
        </pc:graphicFrameChg>
      </pc:sldChg>
      <pc:sldChg chg="modSp mod">
        <pc:chgData name="Marin Ishikawa" userId="671b21c72070ca9d" providerId="LiveId" clId="{93254D41-9D0D-4885-A6B4-0DBD32CDB9E5}" dt="2024-04-14T01:13:45.365" v="59" actId="14100"/>
        <pc:sldMkLst>
          <pc:docMk/>
          <pc:sldMk cId="2896525863" sldId="22081"/>
        </pc:sldMkLst>
        <pc:graphicFrameChg chg="mod">
          <ac:chgData name="Marin Ishikawa" userId="671b21c72070ca9d" providerId="LiveId" clId="{93254D41-9D0D-4885-A6B4-0DBD32CDB9E5}" dt="2024-04-14T01:13:45.365" v="59" actId="14100"/>
          <ac:graphicFrameMkLst>
            <pc:docMk/>
            <pc:sldMk cId="2896525863" sldId="22081"/>
            <ac:graphicFrameMk id="8" creationId="{78D4C85D-590E-FB7C-2104-05766C03BC4E}"/>
          </ac:graphicFrameMkLst>
        </pc:graphicFrameChg>
        <pc:graphicFrameChg chg="mod">
          <ac:chgData name="Marin Ishikawa" userId="671b21c72070ca9d" providerId="LiveId" clId="{93254D41-9D0D-4885-A6B4-0DBD32CDB9E5}" dt="2024-04-14T01:13:27.134" v="54" actId="14100"/>
          <ac:graphicFrameMkLst>
            <pc:docMk/>
            <pc:sldMk cId="2896525863" sldId="22081"/>
            <ac:graphicFrameMk id="9" creationId="{519089B1-7349-C2AD-A42F-7B0906FDFF03}"/>
          </ac:graphicFrameMkLst>
        </pc:graphicFrameChg>
      </pc:sldChg>
      <pc:sldChg chg="modSp mod">
        <pc:chgData name="Marin Ishikawa" userId="671b21c72070ca9d" providerId="LiveId" clId="{93254D41-9D0D-4885-A6B4-0DBD32CDB9E5}" dt="2024-04-14T01:18:41.295" v="363" actId="1035"/>
        <pc:sldMkLst>
          <pc:docMk/>
          <pc:sldMk cId="1737679525" sldId="22087"/>
        </pc:sldMkLst>
        <pc:spChg chg="mod">
          <ac:chgData name="Marin Ishikawa" userId="671b21c72070ca9d" providerId="LiveId" clId="{93254D41-9D0D-4885-A6B4-0DBD32CDB9E5}" dt="2024-04-14T01:14:25.753" v="60" actId="255"/>
          <ac:spMkLst>
            <pc:docMk/>
            <pc:sldMk cId="1737679525" sldId="22087"/>
            <ac:spMk id="2" creationId="{F3CE3440-FD31-5983-8181-4BCF0C44F485}"/>
          </ac:spMkLst>
        </pc:spChg>
        <pc:spChg chg="mod">
          <ac:chgData name="Marin Ishikawa" userId="671b21c72070ca9d" providerId="LiveId" clId="{93254D41-9D0D-4885-A6B4-0DBD32CDB9E5}" dt="2024-04-14T01:15:22.594" v="104" actId="1036"/>
          <ac:spMkLst>
            <pc:docMk/>
            <pc:sldMk cId="1737679525" sldId="22087"/>
            <ac:spMk id="11" creationId="{0DE30369-6ECF-4BD3-8C1F-F5CADB5E0E43}"/>
          </ac:spMkLst>
        </pc:spChg>
        <pc:spChg chg="mod">
          <ac:chgData name="Marin Ishikawa" userId="671b21c72070ca9d" providerId="LiveId" clId="{93254D41-9D0D-4885-A6B4-0DBD32CDB9E5}" dt="2024-04-14T01:16:55.466" v="132" actId="1038"/>
          <ac:spMkLst>
            <pc:docMk/>
            <pc:sldMk cId="1737679525" sldId="22087"/>
            <ac:spMk id="12" creationId="{8F6806AA-0428-47FE-A109-6F7BEDE0DDB3}"/>
          </ac:spMkLst>
        </pc:spChg>
        <pc:spChg chg="mod">
          <ac:chgData name="Marin Ishikawa" userId="671b21c72070ca9d" providerId="LiveId" clId="{93254D41-9D0D-4885-A6B4-0DBD32CDB9E5}" dt="2024-04-14T01:15:07.047" v="77" actId="1035"/>
          <ac:spMkLst>
            <pc:docMk/>
            <pc:sldMk cId="1737679525" sldId="22087"/>
            <ac:spMk id="36" creationId="{F789AB20-0D94-4427-A872-C36A4B2CA186}"/>
          </ac:spMkLst>
        </pc:spChg>
        <pc:spChg chg="mod">
          <ac:chgData name="Marin Ishikawa" userId="671b21c72070ca9d" providerId="LiveId" clId="{93254D41-9D0D-4885-A6B4-0DBD32CDB9E5}" dt="2024-04-14T01:15:13.362" v="79" actId="1035"/>
          <ac:spMkLst>
            <pc:docMk/>
            <pc:sldMk cId="1737679525" sldId="22087"/>
            <ac:spMk id="40" creationId="{A9827C4A-5084-4FF5-9044-37CE6EF2FA08}"/>
          </ac:spMkLst>
        </pc:spChg>
        <pc:spChg chg="mod">
          <ac:chgData name="Marin Ishikawa" userId="671b21c72070ca9d" providerId="LiveId" clId="{93254D41-9D0D-4885-A6B4-0DBD32CDB9E5}" dt="2024-04-14T01:17:02.044" v="151" actId="1038"/>
          <ac:spMkLst>
            <pc:docMk/>
            <pc:sldMk cId="1737679525" sldId="22087"/>
            <ac:spMk id="43" creationId="{16B9DCFD-63CE-492F-9A32-91CFC5BAC816}"/>
          </ac:spMkLst>
        </pc:spChg>
        <pc:spChg chg="mod">
          <ac:chgData name="Marin Ishikawa" userId="671b21c72070ca9d" providerId="LiveId" clId="{93254D41-9D0D-4885-A6B4-0DBD32CDB9E5}" dt="2024-04-14T01:18:41.295" v="363" actId="1035"/>
          <ac:spMkLst>
            <pc:docMk/>
            <pc:sldMk cId="1737679525" sldId="22087"/>
            <ac:spMk id="80" creationId="{0D08C79C-FC10-73BF-DC22-70B6EABE885A}"/>
          </ac:spMkLst>
        </pc:spChg>
        <pc:spChg chg="mod">
          <ac:chgData name="Marin Ishikawa" userId="671b21c72070ca9d" providerId="LiveId" clId="{93254D41-9D0D-4885-A6B4-0DBD32CDB9E5}" dt="2024-04-14T01:18:30.507" v="318" actId="1035"/>
          <ac:spMkLst>
            <pc:docMk/>
            <pc:sldMk cId="1737679525" sldId="22087"/>
            <ac:spMk id="81" creationId="{11BD0550-EDEC-E3EE-5947-9B74D1D218D6}"/>
          </ac:spMkLst>
        </pc:spChg>
        <pc:spChg chg="mod">
          <ac:chgData name="Marin Ishikawa" userId="671b21c72070ca9d" providerId="LiveId" clId="{93254D41-9D0D-4885-A6B4-0DBD32CDB9E5}" dt="2024-04-14T01:18:07.661" v="296" actId="1037"/>
          <ac:spMkLst>
            <pc:docMk/>
            <pc:sldMk cId="1737679525" sldId="22087"/>
            <ac:spMk id="127" creationId="{84FBDFA8-C55D-0B4A-FA59-FEBC7F6BF0A4}"/>
          </ac:spMkLst>
        </pc:spChg>
        <pc:spChg chg="mod">
          <ac:chgData name="Marin Ishikawa" userId="671b21c72070ca9d" providerId="LiveId" clId="{93254D41-9D0D-4885-A6B4-0DBD32CDB9E5}" dt="2024-04-14T01:18:18.788" v="310" actId="1038"/>
          <ac:spMkLst>
            <pc:docMk/>
            <pc:sldMk cId="1737679525" sldId="22087"/>
            <ac:spMk id="129" creationId="{4EAF560A-7384-795D-9773-BA4D3557EE92}"/>
          </ac:spMkLst>
        </pc:spChg>
        <pc:spChg chg="mod">
          <ac:chgData name="Marin Ishikawa" userId="671b21c72070ca9d" providerId="LiveId" clId="{93254D41-9D0D-4885-A6B4-0DBD32CDB9E5}" dt="2024-04-14T01:17:50.819" v="271" actId="1037"/>
          <ac:spMkLst>
            <pc:docMk/>
            <pc:sldMk cId="1737679525" sldId="22087"/>
            <ac:spMk id="130" creationId="{0AFDBB23-0B86-A0EA-2F62-341856B478C7}"/>
          </ac:spMkLst>
        </pc:spChg>
        <pc:spChg chg="mod">
          <ac:chgData name="Marin Ishikawa" userId="671b21c72070ca9d" providerId="LiveId" clId="{93254D41-9D0D-4885-A6B4-0DBD32CDB9E5}" dt="2024-04-14T01:17:40.593" v="248" actId="1038"/>
          <ac:spMkLst>
            <pc:docMk/>
            <pc:sldMk cId="1737679525" sldId="22087"/>
            <ac:spMk id="134" creationId="{5308715A-E8DB-EFFF-A201-AC5630A911F3}"/>
          </ac:spMkLst>
        </pc:spChg>
        <pc:cxnChg chg="mod">
          <ac:chgData name="Marin Ishikawa" userId="671b21c72070ca9d" providerId="LiveId" clId="{93254D41-9D0D-4885-A6B4-0DBD32CDB9E5}" dt="2024-04-14T01:16:55.466" v="132" actId="1038"/>
          <ac:cxnSpMkLst>
            <pc:docMk/>
            <pc:sldMk cId="1737679525" sldId="22087"/>
            <ac:cxnSpMk id="17" creationId="{157B3B00-59FD-403D-B1B5-BC9018A7BADB}"/>
          </ac:cxnSpMkLst>
        </pc:cxnChg>
        <pc:cxnChg chg="mod">
          <ac:chgData name="Marin Ishikawa" userId="671b21c72070ca9d" providerId="LiveId" clId="{93254D41-9D0D-4885-A6B4-0DBD32CDB9E5}" dt="2024-04-14T01:16:55.466" v="132" actId="1038"/>
          <ac:cxnSpMkLst>
            <pc:docMk/>
            <pc:sldMk cId="1737679525" sldId="22087"/>
            <ac:cxnSpMk id="21" creationId="{8C2E1130-A145-4449-A346-BA597420D04F}"/>
          </ac:cxnSpMkLst>
        </pc:cxnChg>
        <pc:cxnChg chg="mod">
          <ac:chgData name="Marin Ishikawa" userId="671b21c72070ca9d" providerId="LiveId" clId="{93254D41-9D0D-4885-A6B4-0DBD32CDB9E5}" dt="2024-04-14T01:16:55.466" v="132" actId="1038"/>
          <ac:cxnSpMkLst>
            <pc:docMk/>
            <pc:sldMk cId="1737679525" sldId="22087"/>
            <ac:cxnSpMk id="22" creationId="{5D36EF52-22BA-4066-9AC2-DFCE69C57F1B}"/>
          </ac:cxnSpMkLst>
        </pc:cxnChg>
        <pc:cxnChg chg="mod">
          <ac:chgData name="Marin Ishikawa" userId="671b21c72070ca9d" providerId="LiveId" clId="{93254D41-9D0D-4885-A6B4-0DBD32CDB9E5}" dt="2024-04-14T01:15:22.594" v="104" actId="1036"/>
          <ac:cxnSpMkLst>
            <pc:docMk/>
            <pc:sldMk cId="1737679525" sldId="22087"/>
            <ac:cxnSpMk id="23" creationId="{0BD45DEB-6052-42CE-96C7-40DA2B9DA046}"/>
          </ac:cxnSpMkLst>
        </pc:cxnChg>
        <pc:cxnChg chg="mod">
          <ac:chgData name="Marin Ishikawa" userId="671b21c72070ca9d" providerId="LiveId" clId="{93254D41-9D0D-4885-A6B4-0DBD32CDB9E5}" dt="2024-04-14T01:15:34.750" v="106" actId="14100"/>
          <ac:cxnSpMkLst>
            <pc:docMk/>
            <pc:sldMk cId="1737679525" sldId="22087"/>
            <ac:cxnSpMk id="25" creationId="{EDB0693C-CF8B-4060-A45A-96A1B1C09574}"/>
          </ac:cxnSpMkLst>
        </pc:cxn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671b21c72070ca9d/&#33256;&#24202;&#30740;&#31350;/&#24950;&#25033;/&#12304;2021-1159&#12305;&#20445;&#38522;&#12497;&#12493;&#12523;&#12398;&#12503;&#12525;&#12501;&#12449;&#12452;&#12522;&#12531;&#12464;/&#35542;&#25991;&#20316;&#25104;/Figure%20(20190601-20221031)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671b21c72070ca9d/&#33256;&#24202;&#30740;&#31350;/&#24950;&#25033;/&#12304;2021-1159&#12305;&#20445;&#38522;&#12497;&#12493;&#12523;&#12398;&#12503;&#12525;&#12501;&#12449;&#12452;&#12522;&#12531;&#12464;/&#35542;&#25991;&#20316;&#25104;/Figure%20(20190601-20221031)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671b21c72070ca9d/&#33256;&#24202;&#30740;&#31350;/&#24950;&#25033;/&#12304;2021-1159&#12305;&#20445;&#38522;&#12497;&#12493;&#12523;&#12398;&#12503;&#12525;&#12501;&#12449;&#12452;&#12522;&#12531;&#12464;/&#35542;&#25991;&#20316;&#25104;/Figure%20(20190601-20221031)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671b21c72070ca9d/&#33256;&#24202;&#30740;&#31350;/&#24950;&#25033;/&#12304;2021-1159&#12305;&#20445;&#38522;&#12497;&#12493;&#12523;&#12398;&#12503;&#12525;&#12501;&#12449;&#12452;&#12522;&#12531;&#12464;/&#35542;&#25991;&#20316;&#25104;/Figure%20(20190601-20221031)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671b21c72070ca9d/&#33256;&#24202;&#30740;&#31350;/&#24950;&#25033;/&#12304;2021-1159&#12305;&#20445;&#38522;&#12497;&#12493;&#12523;&#12398;&#12503;&#12525;&#12501;&#12449;&#12452;&#12522;&#12531;&#12464;/&#35542;&#25991;&#20316;&#25104;/Figure%20(20190601-20221031)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671b21c72070ca9d/&#33256;&#24202;&#30740;&#31350;/&#24950;&#25033;/&#12304;2021-1159&#12305;&#20445;&#38522;&#12497;&#12493;&#12523;&#12398;&#12503;&#12525;&#12501;&#12449;&#12452;&#12522;&#12531;&#12464;/&#35542;&#25991;&#20316;&#25104;/Figure%20(20190601-20221031)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671b21c72070ca9d/&#33256;&#24202;&#30740;&#31350;/&#24950;&#25033;/&#12304;2021-1159&#12305;&#20445;&#38522;&#12497;&#12493;&#12523;&#12398;&#12503;&#12525;&#12501;&#12449;&#12452;&#12522;&#12531;&#12464;/Figure%20(20190601-20221031)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671b21c72070ca9d/&#33256;&#24202;&#30740;&#31350;/&#24950;&#25033;/&#12304;2021-1159&#12305;&#20445;&#38522;&#12497;&#12493;&#12523;&#12398;&#12503;&#12525;&#12501;&#12449;&#12452;&#12522;&#12531;&#12464;/Figure%20(20190601-20221031).xlsx" TargetMode="External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671b21c72070ca9d/&#33256;&#24202;&#30740;&#31350;/&#24950;&#25033;/&#12304;2021-1159&#12305;&#20445;&#38522;&#12497;&#12493;&#12523;&#12398;&#12503;&#12525;&#12501;&#12449;&#12452;&#12522;&#12531;&#12464;/Figure%20(20190601-20221031).xlsx" TargetMode="External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671b21c72070ca9d/&#33256;&#24202;&#30740;&#31350;/&#24950;&#25033;/&#12304;2021-1159&#12305;&#20445;&#38522;&#12497;&#12493;&#12523;&#12398;&#12503;&#12525;&#12501;&#12449;&#12452;&#12522;&#12531;&#12464;/Figure%20(20190601-20221031).xlsx" TargetMode="External"/><Relationship Id="rId2" Type="http://schemas.microsoft.com/office/2011/relationships/chartColorStyle" Target="colors18.xml"/><Relationship Id="rId1" Type="http://schemas.microsoft.com/office/2011/relationships/chartStyle" Target="style18.xml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671b21c72070ca9d/&#33256;&#24202;&#30740;&#31350;/&#24950;&#25033;/&#12304;2021-1159&#12305;&#20445;&#38522;&#12497;&#12493;&#12523;&#12398;&#12503;&#12525;&#12501;&#12449;&#12452;&#12522;&#12531;&#12464;/Figure%20(20190601-20221031).xlsx" TargetMode="External"/><Relationship Id="rId2" Type="http://schemas.microsoft.com/office/2011/relationships/chartColorStyle" Target="colors19.xml"/><Relationship Id="rId1" Type="http://schemas.microsoft.com/office/2011/relationships/chartStyle" Target="style19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671b21c72070ca9d/&#33256;&#24202;&#30740;&#31350;/&#24950;&#25033;/&#12304;2021-1159&#12305;&#20445;&#38522;&#12497;&#12493;&#12523;&#12398;&#12503;&#12525;&#12501;&#12449;&#12452;&#12522;&#12531;&#12464;/&#35542;&#25991;&#20316;&#25104;/Figure%20(20190601-20221031)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20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671b21c72070ca9d/&#33256;&#24202;&#30740;&#31350;/&#24950;&#25033;/&#12304;2021-1159&#12305;&#20445;&#38522;&#12497;&#12493;&#12523;&#12398;&#12503;&#12525;&#12501;&#12449;&#12452;&#12522;&#12531;&#12464;/&#35542;&#25991;&#20316;&#25104;/Figure%20(20190601-20221031).xlsx" TargetMode="External"/><Relationship Id="rId2" Type="http://schemas.microsoft.com/office/2011/relationships/chartColorStyle" Target="colors20.xml"/><Relationship Id="rId1" Type="http://schemas.microsoft.com/office/2011/relationships/chartStyle" Target="style20.xml"/></Relationships>
</file>

<file path=ppt/charts/_rels/chart21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671b21c72070ca9d/&#33256;&#24202;&#30740;&#31350;/&#24950;&#25033;/&#12304;2021-1159&#12305;&#20445;&#38522;&#12497;&#12493;&#12523;&#12398;&#12503;&#12525;&#12501;&#12449;&#12452;&#12522;&#12531;&#12464;/Figure%20(20190601-20221031).xlsx" TargetMode="External"/><Relationship Id="rId2" Type="http://schemas.microsoft.com/office/2011/relationships/chartColorStyle" Target="colors21.xml"/><Relationship Id="rId1" Type="http://schemas.microsoft.com/office/2011/relationships/chartStyle" Target="style21.xml"/></Relationships>
</file>

<file path=ppt/charts/_rels/chart22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671b21c72070ca9d/&#33256;&#24202;&#30740;&#31350;/&#24950;&#25033;/&#12304;2021-1159&#12305;&#20445;&#38522;&#12497;&#12493;&#12523;&#12398;&#12503;&#12525;&#12501;&#12449;&#12452;&#12522;&#12531;&#12464;/Figure%20(20190601-20221031).xlsx" TargetMode="External"/><Relationship Id="rId2" Type="http://schemas.microsoft.com/office/2011/relationships/chartColorStyle" Target="colors22.xml"/><Relationship Id="rId1" Type="http://schemas.microsoft.com/office/2011/relationships/chartStyle" Target="style22.xml"/></Relationships>
</file>

<file path=ppt/charts/_rels/chart23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671b21c72070ca9d/&#33256;&#24202;&#30740;&#31350;/&#24950;&#25033;/&#12304;2021-1159&#12305;&#20445;&#38522;&#12497;&#12493;&#12523;&#12398;&#12503;&#12525;&#12501;&#12449;&#12452;&#12522;&#12531;&#12464;/Figure%20(20190601-20221031).xlsx" TargetMode="External"/><Relationship Id="rId2" Type="http://schemas.microsoft.com/office/2011/relationships/chartColorStyle" Target="colors23.xml"/><Relationship Id="rId1" Type="http://schemas.microsoft.com/office/2011/relationships/chartStyle" Target="style23.xml"/></Relationships>
</file>

<file path=ppt/charts/_rels/chart24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671b21c72070ca9d/&#33256;&#24202;&#30740;&#31350;/&#24950;&#25033;/&#12304;2021-1159&#12305;&#20445;&#38522;&#12497;&#12493;&#12523;&#12398;&#12503;&#12525;&#12501;&#12449;&#12452;&#12522;&#12531;&#12464;/Figure%20(20190601-20221031).xlsx" TargetMode="External"/><Relationship Id="rId2" Type="http://schemas.microsoft.com/office/2011/relationships/chartColorStyle" Target="colors24.xml"/><Relationship Id="rId1" Type="http://schemas.microsoft.com/office/2011/relationships/chartStyle" Target="style24.xml"/></Relationships>
</file>

<file path=ppt/charts/_rels/chart25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671b21c72070ca9d/&#33256;&#24202;&#30740;&#31350;/&#24950;&#25033;/&#12304;2021-1159&#12305;&#20445;&#38522;&#12497;&#12493;&#12523;&#12398;&#12503;&#12525;&#12501;&#12449;&#12452;&#12522;&#12531;&#12464;/Figure%20(20190601-20221031).xlsx" TargetMode="External"/><Relationship Id="rId2" Type="http://schemas.microsoft.com/office/2011/relationships/chartColorStyle" Target="colors25.xml"/><Relationship Id="rId1" Type="http://schemas.microsoft.com/office/2011/relationships/chartStyle" Target="style25.xml"/></Relationships>
</file>

<file path=ppt/charts/_rels/chart26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671b21c72070ca9d/&#33256;&#24202;&#30740;&#31350;/&#24950;&#25033;/&#12304;2021-1159&#12305;&#20445;&#38522;&#12497;&#12493;&#12523;&#12398;&#12503;&#12525;&#12501;&#12449;&#12452;&#12522;&#12531;&#12464;/Figure%20(20190601-20221031).xlsx" TargetMode="External"/><Relationship Id="rId2" Type="http://schemas.microsoft.com/office/2011/relationships/chartColorStyle" Target="colors26.xml"/><Relationship Id="rId1" Type="http://schemas.microsoft.com/office/2011/relationships/chartStyle" Target="style26.xml"/></Relationships>
</file>

<file path=ppt/charts/_rels/chart27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671b21c72070ca9d/&#33256;&#24202;&#30740;&#31350;/&#24950;&#25033;/&#12304;2021-1159&#12305;&#20445;&#38522;&#12497;&#12493;&#12523;&#12398;&#12503;&#12525;&#12501;&#12449;&#12452;&#12522;&#12531;&#12464;/&#35542;&#25991;&#20316;&#25104;/Editage/OCEFW_1_2_20230327/Figures%20ver.1.1.xlsx" TargetMode="External"/><Relationship Id="rId2" Type="http://schemas.microsoft.com/office/2011/relationships/chartColorStyle" Target="colors27.xml"/><Relationship Id="rId1" Type="http://schemas.microsoft.com/office/2011/relationships/chartStyle" Target="style27.xml"/></Relationships>
</file>

<file path=ppt/charts/_rels/chart28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671b21c72070ca9d/&#33256;&#24202;&#30740;&#31350;/&#24950;&#25033;/&#12304;2021-1159&#12305;&#20445;&#38522;&#12497;&#12493;&#12523;&#12398;&#12503;&#12525;&#12501;&#12449;&#12452;&#12522;&#12531;&#12464;/&#35542;&#25991;&#20316;&#25104;/Editage/OCEFW_1_2_20230327/Figures%20ver.1.1.xlsx" TargetMode="External"/><Relationship Id="rId2" Type="http://schemas.microsoft.com/office/2011/relationships/chartColorStyle" Target="colors28.xml"/><Relationship Id="rId1" Type="http://schemas.microsoft.com/office/2011/relationships/chartStyle" Target="style28.xml"/></Relationships>
</file>

<file path=ppt/charts/_rels/chart29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671b21c72070ca9d/&#33256;&#24202;&#30740;&#31350;/&#24950;&#25033;/&#12304;2021-1159&#12305;&#20445;&#38522;&#12497;&#12493;&#12523;&#12398;&#12503;&#12525;&#12501;&#12449;&#12452;&#12522;&#12531;&#12464;/&#35542;&#25991;&#20316;&#25104;/Editage/OCEFW_1_2_20230327/Figures%20ver.1.1.xlsx" TargetMode="External"/><Relationship Id="rId2" Type="http://schemas.microsoft.com/office/2011/relationships/chartColorStyle" Target="colors29.xml"/><Relationship Id="rId1" Type="http://schemas.microsoft.com/office/2011/relationships/chartStyle" Target="style29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671b21c72070ca9d/&#33256;&#24202;&#30740;&#31350;/&#24950;&#25033;/&#12304;2021-1159&#12305;&#20445;&#38522;&#12497;&#12493;&#12523;&#12398;&#12503;&#12525;&#12501;&#12449;&#12452;&#12522;&#12531;&#12464;/&#35542;&#25991;&#20316;&#25104;/Figure%20(20190601-20221031)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30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671b21c72070ca9d/&#33256;&#24202;&#30740;&#31350;/&#24950;&#25033;/&#12304;2021-1159&#12305;&#20445;&#38522;&#12497;&#12493;&#12523;&#12398;&#12503;&#12525;&#12501;&#12449;&#12452;&#12522;&#12531;&#12464;/&#35542;&#25991;&#20316;&#25104;/Editage/OCEFW_1_2_20230327/Figures%20ver.1.1.xlsx" TargetMode="External"/><Relationship Id="rId2" Type="http://schemas.microsoft.com/office/2011/relationships/chartColorStyle" Target="colors30.xml"/><Relationship Id="rId1" Type="http://schemas.microsoft.com/office/2011/relationships/chartStyle" Target="style30.xml"/></Relationships>
</file>

<file path=ppt/charts/_rels/chart31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671b21c72070ca9d/&#33256;&#24202;&#30740;&#31350;/&#24950;&#25033;/&#12304;2021-1159&#12305;&#20445;&#38522;&#12497;&#12493;&#12523;&#12398;&#12503;&#12525;&#12501;&#12449;&#12452;&#12522;&#12531;&#12464;/&#35542;&#25991;&#20316;&#25104;/Editage/OCEFW_1_2_20230327/Figures%20ver.1.1.xlsx" TargetMode="External"/><Relationship Id="rId2" Type="http://schemas.microsoft.com/office/2011/relationships/chartColorStyle" Target="colors31.xml"/><Relationship Id="rId1" Type="http://schemas.microsoft.com/office/2011/relationships/chartStyle" Target="style31.xml"/></Relationships>
</file>

<file path=ppt/charts/_rels/chart32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671b21c72070ca9d/&#33256;&#24202;&#30740;&#31350;/&#24950;&#25033;/&#12304;2021-1159&#12305;&#20445;&#38522;&#12497;&#12493;&#12523;&#12398;&#12503;&#12525;&#12501;&#12449;&#12452;&#12522;&#12531;&#12464;/&#35542;&#25991;&#20316;&#25104;/Editage/OCEFW_1_2_20230327/Figures%20ver.1.1.xlsx" TargetMode="External"/><Relationship Id="rId2" Type="http://schemas.microsoft.com/office/2011/relationships/chartColorStyle" Target="colors32.xml"/><Relationship Id="rId1" Type="http://schemas.microsoft.com/office/2011/relationships/chartStyle" Target="style32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671b21c72070ca9d/&#33256;&#24202;&#30740;&#31350;/&#24950;&#25033;/&#12304;2021-1159&#12305;&#20445;&#38522;&#12497;&#12493;&#12523;&#12398;&#12503;&#12525;&#12501;&#12449;&#12452;&#12522;&#12531;&#12464;/&#35542;&#25991;&#20316;&#25104;/Figure%20(20190601-20221031)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671b21c72070ca9d/&#33256;&#24202;&#30740;&#31350;/&#24950;&#25033;/&#12304;2021-1159&#12305;&#20445;&#38522;&#12497;&#12493;&#12523;&#12398;&#12503;&#12525;&#12501;&#12449;&#12452;&#12522;&#12531;&#12464;/&#35542;&#25991;&#20316;&#25104;/Figure%20(20190601-20221031)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671b21c72070ca9d/&#33256;&#24202;&#30740;&#31350;/&#24950;&#25033;/&#12304;2021-1159&#12305;&#20445;&#38522;&#12497;&#12493;&#12523;&#12398;&#12503;&#12525;&#12501;&#12449;&#12452;&#12522;&#12531;&#12464;/&#35542;&#25991;&#20316;&#25104;/Figure%20(20190601-20221031)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671b21c72070ca9d/&#33256;&#24202;&#30740;&#31350;/&#24950;&#25033;/&#12304;2021-1159&#12305;&#20445;&#38522;&#12497;&#12493;&#12523;&#12398;&#12503;&#12525;&#12501;&#12449;&#12452;&#12522;&#12531;&#12464;/&#35542;&#25991;&#20316;&#25104;/Figure%20(20190601-20221031)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671b21c72070ca9d/&#33256;&#24202;&#30740;&#31350;/&#24950;&#25033;/&#12304;2021-1159&#12305;&#20445;&#38522;&#12497;&#12493;&#12523;&#12398;&#12503;&#12525;&#12501;&#12449;&#12452;&#12522;&#12531;&#12464;/&#35542;&#25991;&#20316;&#25104;/Figure%20(20190601-20221031)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671b21c72070ca9d/&#33256;&#24202;&#30740;&#31350;/&#24950;&#25033;/&#12304;2021-1159&#12305;&#20445;&#38522;&#12497;&#12493;&#12523;&#12398;&#12503;&#12525;&#12501;&#12449;&#12452;&#12522;&#12531;&#12464;/&#35542;&#25991;&#20316;&#25104;/Figure%20(20190601-20221031)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4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Esophagu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4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'[Figure (20190601-20221031).xlsx]★変異が多いシグナル伝達経路 (Primary)'!$B$4:$B$9</c:f>
              <c:strCache>
                <c:ptCount val="6"/>
                <c:pt idx="0">
                  <c:v>TP53</c:v>
                </c:pt>
                <c:pt idx="1">
                  <c:v>Cell cycle</c:v>
                </c:pt>
                <c:pt idx="2">
                  <c:v>RTK</c:v>
                </c:pt>
                <c:pt idx="3">
                  <c:v>Epigenetic modification</c:v>
                </c:pt>
                <c:pt idx="4">
                  <c:v>PI3K/Akt/mTOR</c:v>
                </c:pt>
                <c:pt idx="5">
                  <c:v>Metabolic pathway</c:v>
                </c:pt>
              </c:strCache>
            </c:strRef>
          </c:cat>
          <c:val>
            <c:numRef>
              <c:f>'[Figure (20190601-20221031).xlsx]★変異が多いシグナル伝達経路 (Primary)'!$C$4:$C$9</c:f>
              <c:numCache>
                <c:formatCode>0%</c:formatCode>
                <c:ptCount val="6"/>
                <c:pt idx="0">
                  <c:v>0.85</c:v>
                </c:pt>
                <c:pt idx="1">
                  <c:v>0.81</c:v>
                </c:pt>
                <c:pt idx="2">
                  <c:v>0.56000000000000005</c:v>
                </c:pt>
                <c:pt idx="3">
                  <c:v>0.44</c:v>
                </c:pt>
                <c:pt idx="4">
                  <c:v>0.44</c:v>
                </c:pt>
                <c:pt idx="5">
                  <c:v>0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237-4423-AEC1-397593A3F80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460613880"/>
        <c:axId val="460615480"/>
      </c:barChart>
      <c:catAx>
        <c:axId val="460613880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60615480"/>
        <c:crosses val="autoZero"/>
        <c:auto val="1"/>
        <c:lblAlgn val="ctr"/>
        <c:lblOffset val="100"/>
        <c:noMultiLvlLbl val="0"/>
      </c:catAx>
      <c:valAx>
        <c:axId val="460615480"/>
        <c:scaling>
          <c:orientation val="minMax"/>
          <c:max val="1"/>
        </c:scaling>
        <c:delete val="0"/>
        <c:axPos val="t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606138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4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Duodenum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4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'[Figure (20190601-20221031).xlsx]★変異が多い遺伝子 (Primary)'!$B$23:$B$47</c:f>
              <c:strCache>
                <c:ptCount val="25"/>
                <c:pt idx="0">
                  <c:v>TP53</c:v>
                </c:pt>
                <c:pt idx="1">
                  <c:v>CDKN2A</c:v>
                </c:pt>
                <c:pt idx="2">
                  <c:v>BRAF</c:v>
                </c:pt>
                <c:pt idx="3">
                  <c:v>BRCA1</c:v>
                </c:pt>
                <c:pt idx="4">
                  <c:v>CALR</c:v>
                </c:pt>
                <c:pt idx="5">
                  <c:v>CCND3</c:v>
                </c:pt>
                <c:pt idx="6">
                  <c:v>CDK4</c:v>
                </c:pt>
                <c:pt idx="7">
                  <c:v>CDK8</c:v>
                </c:pt>
                <c:pt idx="8">
                  <c:v>CDKN2B</c:v>
                </c:pt>
                <c:pt idx="9">
                  <c:v>CTNNB1</c:v>
                </c:pt>
                <c:pt idx="10">
                  <c:v>ERBB2</c:v>
                </c:pt>
                <c:pt idx="11">
                  <c:v>FGF10</c:v>
                </c:pt>
                <c:pt idx="12">
                  <c:v>FGFR1</c:v>
                </c:pt>
                <c:pt idx="13">
                  <c:v>FLT3</c:v>
                </c:pt>
                <c:pt idx="14">
                  <c:v>GNAS</c:v>
                </c:pt>
                <c:pt idx="15">
                  <c:v>KRAS</c:v>
                </c:pt>
                <c:pt idx="16">
                  <c:v>MDM2</c:v>
                </c:pt>
                <c:pt idx="17">
                  <c:v>MTAP</c:v>
                </c:pt>
                <c:pt idx="18">
                  <c:v>NF1</c:v>
                </c:pt>
                <c:pt idx="19">
                  <c:v>PBRM1</c:v>
                </c:pt>
                <c:pt idx="20">
                  <c:v>RPTOR</c:v>
                </c:pt>
                <c:pt idx="21">
                  <c:v>SMAD4</c:v>
                </c:pt>
                <c:pt idx="22">
                  <c:v>SNCAIP</c:v>
                </c:pt>
                <c:pt idx="23">
                  <c:v>VEGFA</c:v>
                </c:pt>
                <c:pt idx="24">
                  <c:v>WHSC1L1</c:v>
                </c:pt>
              </c:strCache>
            </c:strRef>
          </c:cat>
          <c:val>
            <c:numRef>
              <c:f>'[Figure (20190601-20221031).xlsx]★変異が多い遺伝子 (Primary)'!$C$23:$C$47</c:f>
              <c:numCache>
                <c:formatCode>0%</c:formatCode>
                <c:ptCount val="25"/>
                <c:pt idx="0">
                  <c:v>0.75</c:v>
                </c:pt>
                <c:pt idx="1">
                  <c:v>0.5</c:v>
                </c:pt>
                <c:pt idx="2">
                  <c:v>0.25</c:v>
                </c:pt>
                <c:pt idx="3">
                  <c:v>0.25</c:v>
                </c:pt>
                <c:pt idx="4">
                  <c:v>0.25</c:v>
                </c:pt>
                <c:pt idx="5">
                  <c:v>0.25</c:v>
                </c:pt>
                <c:pt idx="6">
                  <c:v>0.25</c:v>
                </c:pt>
                <c:pt idx="7">
                  <c:v>0.25</c:v>
                </c:pt>
                <c:pt idx="8">
                  <c:v>0.25</c:v>
                </c:pt>
                <c:pt idx="9">
                  <c:v>0.25</c:v>
                </c:pt>
                <c:pt idx="10">
                  <c:v>0.25</c:v>
                </c:pt>
                <c:pt idx="11">
                  <c:v>0.25</c:v>
                </c:pt>
                <c:pt idx="12">
                  <c:v>0.25</c:v>
                </c:pt>
                <c:pt idx="13">
                  <c:v>0.25</c:v>
                </c:pt>
                <c:pt idx="14">
                  <c:v>0.25</c:v>
                </c:pt>
                <c:pt idx="15">
                  <c:v>0.25</c:v>
                </c:pt>
                <c:pt idx="16">
                  <c:v>0.25</c:v>
                </c:pt>
                <c:pt idx="17">
                  <c:v>0.25</c:v>
                </c:pt>
                <c:pt idx="18">
                  <c:v>0.25</c:v>
                </c:pt>
                <c:pt idx="19">
                  <c:v>0.25</c:v>
                </c:pt>
                <c:pt idx="20">
                  <c:v>0.25</c:v>
                </c:pt>
                <c:pt idx="21">
                  <c:v>0.25</c:v>
                </c:pt>
                <c:pt idx="22">
                  <c:v>0.25</c:v>
                </c:pt>
                <c:pt idx="23">
                  <c:v>0.25</c:v>
                </c:pt>
                <c:pt idx="24">
                  <c:v>0.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3A8-45FF-87A2-E4551E67AAE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534925304"/>
        <c:axId val="534923704"/>
      </c:barChart>
      <c:catAx>
        <c:axId val="534925304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34923704"/>
        <c:crosses val="autoZero"/>
        <c:auto val="1"/>
        <c:lblAlgn val="ctr"/>
        <c:lblOffset val="100"/>
        <c:noMultiLvlLbl val="0"/>
      </c:catAx>
      <c:valAx>
        <c:axId val="534923704"/>
        <c:scaling>
          <c:orientation val="minMax"/>
          <c:max val="1"/>
        </c:scaling>
        <c:delete val="0"/>
        <c:axPos val="t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349253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4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Small intestine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4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'[Figure (20190601-20221031).xlsx]★変異が多い遺伝子 (Primary)'!$B$51:$B$53</c:f>
              <c:strCache>
                <c:ptCount val="3"/>
                <c:pt idx="0">
                  <c:v>KRAS</c:v>
                </c:pt>
                <c:pt idx="1">
                  <c:v>NRAS</c:v>
                </c:pt>
                <c:pt idx="2">
                  <c:v>TP53</c:v>
                </c:pt>
              </c:strCache>
            </c:strRef>
          </c:cat>
          <c:val>
            <c:numRef>
              <c:f>'[Figure (20190601-20221031).xlsx]★変異が多い遺伝子 (Primary)'!$C$51:$C$53</c:f>
              <c:numCache>
                <c:formatCode>0%</c:formatCode>
                <c:ptCount val="3"/>
                <c:pt idx="0">
                  <c:v>0.33</c:v>
                </c:pt>
                <c:pt idx="1">
                  <c:v>0.33</c:v>
                </c:pt>
                <c:pt idx="2">
                  <c:v>0.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76A-4FC0-9FA1-82DC7EBC631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551183224"/>
        <c:axId val="551183544"/>
      </c:barChart>
      <c:catAx>
        <c:axId val="551183224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51183544"/>
        <c:crosses val="autoZero"/>
        <c:auto val="1"/>
        <c:lblAlgn val="ctr"/>
        <c:lblOffset val="100"/>
        <c:noMultiLvlLbl val="0"/>
      </c:catAx>
      <c:valAx>
        <c:axId val="551183544"/>
        <c:scaling>
          <c:orientation val="minMax"/>
          <c:max val="1"/>
        </c:scaling>
        <c:delete val="0"/>
        <c:axPos val="t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511832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4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Colorectal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4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'[Figure (20190601-20221031).xlsx]★変異が多い遺伝子 (Primary)'!$B$57:$B$59</c:f>
              <c:strCache>
                <c:ptCount val="3"/>
                <c:pt idx="0">
                  <c:v>TP53</c:v>
                </c:pt>
                <c:pt idx="1">
                  <c:v>APC</c:v>
                </c:pt>
                <c:pt idx="2">
                  <c:v>KRAS</c:v>
                </c:pt>
              </c:strCache>
            </c:strRef>
          </c:cat>
          <c:val>
            <c:numRef>
              <c:f>'[Figure (20190601-20221031).xlsx]★変異が多い遺伝子 (Primary)'!$C$57:$C$59</c:f>
              <c:numCache>
                <c:formatCode>0%</c:formatCode>
                <c:ptCount val="3"/>
                <c:pt idx="0">
                  <c:v>0.81</c:v>
                </c:pt>
                <c:pt idx="1">
                  <c:v>0.79</c:v>
                </c:pt>
                <c:pt idx="2">
                  <c:v>0.4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913-4747-A40E-2AD2870179C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700456264"/>
        <c:axId val="700456584"/>
      </c:barChart>
      <c:catAx>
        <c:axId val="700456264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700456584"/>
        <c:crosses val="autoZero"/>
        <c:auto val="1"/>
        <c:lblAlgn val="ctr"/>
        <c:lblOffset val="100"/>
        <c:noMultiLvlLbl val="0"/>
      </c:catAx>
      <c:valAx>
        <c:axId val="700456584"/>
        <c:scaling>
          <c:orientation val="minMax"/>
          <c:max val="1"/>
        </c:scaling>
        <c:delete val="0"/>
        <c:axPos val="t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7004562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4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Pancreas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4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'[Figure (20190601-20221031).xlsx]★変異が多い遺伝子 (Primary)'!$B$63:$B$68</c:f>
              <c:strCache>
                <c:ptCount val="6"/>
                <c:pt idx="0">
                  <c:v>KRAS</c:v>
                </c:pt>
                <c:pt idx="1">
                  <c:v>TP53</c:v>
                </c:pt>
                <c:pt idx="2">
                  <c:v>CDKN2A</c:v>
                </c:pt>
                <c:pt idx="3">
                  <c:v>CDKN2B</c:v>
                </c:pt>
                <c:pt idx="4">
                  <c:v>SMAD4</c:v>
                </c:pt>
                <c:pt idx="5">
                  <c:v>MTAP</c:v>
                </c:pt>
              </c:strCache>
            </c:strRef>
          </c:cat>
          <c:val>
            <c:numRef>
              <c:f>'[Figure (20190601-20221031).xlsx]★変異が多い遺伝子 (Primary)'!$C$63:$C$68</c:f>
              <c:numCache>
                <c:formatCode>0%</c:formatCode>
                <c:ptCount val="6"/>
                <c:pt idx="0">
                  <c:v>0.87</c:v>
                </c:pt>
                <c:pt idx="1">
                  <c:v>0.69</c:v>
                </c:pt>
                <c:pt idx="2">
                  <c:v>0.46</c:v>
                </c:pt>
                <c:pt idx="3">
                  <c:v>0.28000000000000003</c:v>
                </c:pt>
                <c:pt idx="4">
                  <c:v>0.28000000000000003</c:v>
                </c:pt>
                <c:pt idx="5">
                  <c:v>0.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093-4D1E-BB2C-D311471C4F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700467464"/>
        <c:axId val="700466184"/>
      </c:barChart>
      <c:catAx>
        <c:axId val="700467464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700466184"/>
        <c:crosses val="autoZero"/>
        <c:auto val="1"/>
        <c:lblAlgn val="ctr"/>
        <c:lblOffset val="100"/>
        <c:noMultiLvlLbl val="0"/>
      </c:catAx>
      <c:valAx>
        <c:axId val="700466184"/>
        <c:scaling>
          <c:orientation val="minMax"/>
        </c:scaling>
        <c:delete val="0"/>
        <c:axPos val="t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7004674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4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Biliary tract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4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'[Figure (20190601-20221031).xlsx]★変異が多い遺伝子 (Primary)'!$B$72:$B$75</c:f>
              <c:strCache>
                <c:ptCount val="4"/>
                <c:pt idx="0">
                  <c:v>TP53</c:v>
                </c:pt>
                <c:pt idx="1">
                  <c:v>CDKN2A</c:v>
                </c:pt>
                <c:pt idx="2">
                  <c:v>CDKN2B</c:v>
                </c:pt>
                <c:pt idx="3">
                  <c:v>KRAS</c:v>
                </c:pt>
              </c:strCache>
            </c:strRef>
          </c:cat>
          <c:val>
            <c:numRef>
              <c:f>'[Figure (20190601-20221031).xlsx]★変異が多い遺伝子 (Primary)'!$C$72:$C$75</c:f>
              <c:numCache>
                <c:formatCode>0%</c:formatCode>
                <c:ptCount val="4"/>
                <c:pt idx="0">
                  <c:v>0.49</c:v>
                </c:pt>
                <c:pt idx="1">
                  <c:v>0.32</c:v>
                </c:pt>
                <c:pt idx="2">
                  <c:v>0.21</c:v>
                </c:pt>
                <c:pt idx="3">
                  <c:v>0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F74-4A1D-9B69-2C3BF6D979F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700468744"/>
        <c:axId val="700472264"/>
      </c:barChart>
      <c:catAx>
        <c:axId val="700468744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700472264"/>
        <c:crosses val="autoZero"/>
        <c:auto val="1"/>
        <c:lblAlgn val="ctr"/>
        <c:lblOffset val="100"/>
        <c:noMultiLvlLbl val="0"/>
      </c:catAx>
      <c:valAx>
        <c:axId val="700472264"/>
        <c:scaling>
          <c:orientation val="minMax"/>
          <c:max val="1"/>
        </c:scaling>
        <c:delete val="0"/>
        <c:axPos val="t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70046874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4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Duodenum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4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32542677778555357"/>
          <c:y val="0.25234240838535987"/>
          <c:w val="0.61860135402857985"/>
          <c:h val="0.68869908498254673"/>
        </c:manualLayout>
      </c:layout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'[Figure (20190601-20221031).xlsx]★変異が多いシグナル伝達経路 (Adeno-Primary)'!$B$21:$B$25</c:f>
              <c:strCache>
                <c:ptCount val="5"/>
                <c:pt idx="0">
                  <c:v>TP53</c:v>
                </c:pt>
                <c:pt idx="1">
                  <c:v>RTK</c:v>
                </c:pt>
                <c:pt idx="2">
                  <c:v>Epigenetic modification</c:v>
                </c:pt>
                <c:pt idx="3">
                  <c:v>Cell cycle</c:v>
                </c:pt>
                <c:pt idx="4">
                  <c:v>Ras/Raf/MEK/ERK</c:v>
                </c:pt>
              </c:strCache>
            </c:strRef>
          </c:cat>
          <c:val>
            <c:numRef>
              <c:f>'[Figure (20190601-20221031).xlsx]★変異が多いシグナル伝達経路 (Adeno-Primary)'!$C$21:$C$25</c:f>
              <c:numCache>
                <c:formatCode>0%</c:formatCode>
                <c:ptCount val="5"/>
                <c:pt idx="0">
                  <c:v>1</c:v>
                </c:pt>
                <c:pt idx="1">
                  <c:v>1</c:v>
                </c:pt>
                <c:pt idx="2">
                  <c:v>0.75</c:v>
                </c:pt>
                <c:pt idx="3">
                  <c:v>0.5</c:v>
                </c:pt>
                <c:pt idx="4">
                  <c:v>0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4FF-4193-830F-C4F8CE6482B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528758160"/>
        <c:axId val="528759120"/>
      </c:barChart>
      <c:catAx>
        <c:axId val="528758160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28759120"/>
        <c:crosses val="autoZero"/>
        <c:auto val="1"/>
        <c:lblAlgn val="ctr"/>
        <c:lblOffset val="100"/>
        <c:noMultiLvlLbl val="0"/>
      </c:catAx>
      <c:valAx>
        <c:axId val="528759120"/>
        <c:scaling>
          <c:orientation val="minMax"/>
          <c:max val="1"/>
        </c:scaling>
        <c:delete val="0"/>
        <c:axPos val="t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287581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4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Small intestine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4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'[Figure (20190601-20221031).xlsx]★変異が多いシグナル伝達経路 (Adeno-Primary)'!$B$29:$B$31</c:f>
              <c:strCache>
                <c:ptCount val="3"/>
                <c:pt idx="0">
                  <c:v>Ras/Raf/MEK/ERK</c:v>
                </c:pt>
                <c:pt idx="1">
                  <c:v>TGF-B</c:v>
                </c:pt>
                <c:pt idx="2">
                  <c:v>TP53</c:v>
                </c:pt>
              </c:strCache>
            </c:strRef>
          </c:cat>
          <c:val>
            <c:numRef>
              <c:f>'[Figure (20190601-20221031).xlsx]★変異が多いシグナル伝達経路 (Adeno-Primary)'!$C$29:$C$31</c:f>
              <c:numCache>
                <c:formatCode>0%</c:formatCode>
                <c:ptCount val="3"/>
                <c:pt idx="0">
                  <c:v>1</c:v>
                </c:pt>
                <c:pt idx="1">
                  <c:v>0.5</c:v>
                </c:pt>
                <c:pt idx="2">
                  <c:v>0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865-4356-97F0-7D17161580F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551212664"/>
        <c:axId val="551211384"/>
      </c:barChart>
      <c:catAx>
        <c:axId val="551212664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51211384"/>
        <c:crosses val="autoZero"/>
        <c:auto val="1"/>
        <c:lblAlgn val="ctr"/>
        <c:lblOffset val="100"/>
        <c:noMultiLvlLbl val="0"/>
      </c:catAx>
      <c:valAx>
        <c:axId val="551211384"/>
        <c:scaling>
          <c:orientation val="minMax"/>
          <c:max val="1"/>
        </c:scaling>
        <c:delete val="0"/>
        <c:axPos val="t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512126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4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Colorectal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4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29407802311428077"/>
          <c:y val="0.20251284777075818"/>
          <c:w val="0.63266477604125204"/>
          <c:h val="0.72697432222549596"/>
        </c:manualLayout>
      </c:layout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'[Figure (20190601-20221031).xlsx]★変異が多いシグナル伝達経路 (Adeno-Primary)'!$B$35:$B$39</c:f>
              <c:strCache>
                <c:ptCount val="5"/>
                <c:pt idx="0">
                  <c:v>Wnt/β-catenin</c:v>
                </c:pt>
                <c:pt idx="1">
                  <c:v>TP53</c:v>
                </c:pt>
                <c:pt idx="2">
                  <c:v>Ras/Raf/MEK/ERK</c:v>
                </c:pt>
                <c:pt idx="3">
                  <c:v>RTK</c:v>
                </c:pt>
                <c:pt idx="4">
                  <c:v>PI3K/Akt/mTOR</c:v>
                </c:pt>
              </c:strCache>
            </c:strRef>
          </c:cat>
          <c:val>
            <c:numRef>
              <c:f>'[Figure (20190601-20221031).xlsx]★変異が多いシグナル伝達経路 (Adeno-Primary)'!$C$35:$C$39</c:f>
              <c:numCache>
                <c:formatCode>0%</c:formatCode>
                <c:ptCount val="5"/>
                <c:pt idx="0">
                  <c:v>0.85</c:v>
                </c:pt>
                <c:pt idx="1">
                  <c:v>0.84</c:v>
                </c:pt>
                <c:pt idx="2">
                  <c:v>0.73</c:v>
                </c:pt>
                <c:pt idx="3">
                  <c:v>0.34</c:v>
                </c:pt>
                <c:pt idx="4">
                  <c:v>0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BBA-4D79-AE6F-D95F19E8EC7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460635640"/>
        <c:axId val="460631800"/>
      </c:barChart>
      <c:catAx>
        <c:axId val="460635640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60631800"/>
        <c:crosses val="autoZero"/>
        <c:auto val="1"/>
        <c:lblAlgn val="ctr"/>
        <c:lblOffset val="100"/>
        <c:noMultiLvlLbl val="0"/>
      </c:catAx>
      <c:valAx>
        <c:axId val="460631800"/>
        <c:scaling>
          <c:orientation val="minMax"/>
          <c:max val="1"/>
        </c:scaling>
        <c:delete val="0"/>
        <c:axPos val="t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606356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4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Pancreas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4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30564024970934794"/>
          <c:y val="0.25229321603004312"/>
          <c:w val="0.62176784507090188"/>
          <c:h val="0.68875977087882523"/>
        </c:manualLayout>
      </c:layout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'[Figure (20190601-20221031).xlsx]★変異が多いシグナル伝達経路 (Adeno-Primary)'!$B$43:$B$46</c:f>
              <c:strCache>
                <c:ptCount val="4"/>
                <c:pt idx="0">
                  <c:v>Ras/Raf/MEK/ERK</c:v>
                </c:pt>
                <c:pt idx="1">
                  <c:v>TP53</c:v>
                </c:pt>
                <c:pt idx="2">
                  <c:v>Cell cycle</c:v>
                </c:pt>
                <c:pt idx="3">
                  <c:v>TGF-B</c:v>
                </c:pt>
              </c:strCache>
            </c:strRef>
          </c:cat>
          <c:val>
            <c:numRef>
              <c:f>'[Figure (20190601-20221031).xlsx]★変異が多いシグナル伝達経路 (Adeno-Primary)'!$C$43:$C$46</c:f>
              <c:numCache>
                <c:formatCode>0%</c:formatCode>
                <c:ptCount val="4"/>
                <c:pt idx="0">
                  <c:v>0.95</c:v>
                </c:pt>
                <c:pt idx="1">
                  <c:v>0.77</c:v>
                </c:pt>
                <c:pt idx="2">
                  <c:v>0.52</c:v>
                </c:pt>
                <c:pt idx="3">
                  <c:v>0.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246-4606-BCD0-054C9797D30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554470840"/>
        <c:axId val="554471800"/>
      </c:barChart>
      <c:catAx>
        <c:axId val="554470840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54471800"/>
        <c:crosses val="autoZero"/>
        <c:auto val="1"/>
        <c:lblAlgn val="ctr"/>
        <c:lblOffset val="100"/>
        <c:noMultiLvlLbl val="0"/>
      </c:catAx>
      <c:valAx>
        <c:axId val="554471800"/>
        <c:scaling>
          <c:orientation val="minMax"/>
        </c:scaling>
        <c:delete val="0"/>
        <c:axPos val="t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544708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4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Biliary tract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4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'[Figure (20190601-20221031).xlsx]★変異が多いシグナル伝達経路 (Adeno-Primary)'!$B$51:$B$54</c:f>
              <c:strCache>
                <c:ptCount val="4"/>
                <c:pt idx="0">
                  <c:v>TP53</c:v>
                </c:pt>
                <c:pt idx="1">
                  <c:v>Cell cycle</c:v>
                </c:pt>
                <c:pt idx="2">
                  <c:v>Ras/Raf/MEK/ERK</c:v>
                </c:pt>
                <c:pt idx="3">
                  <c:v>Epigenetic modification</c:v>
                </c:pt>
              </c:strCache>
            </c:strRef>
          </c:cat>
          <c:val>
            <c:numRef>
              <c:f>'[Figure (20190601-20221031).xlsx]★変異が多いシグナル伝達経路 (Adeno-Primary)'!$C$51:$C$54</c:f>
              <c:numCache>
                <c:formatCode>0%</c:formatCode>
                <c:ptCount val="4"/>
                <c:pt idx="0">
                  <c:v>0.56000000000000005</c:v>
                </c:pt>
                <c:pt idx="1">
                  <c:v>0.47</c:v>
                </c:pt>
                <c:pt idx="2">
                  <c:v>0.45</c:v>
                </c:pt>
                <c:pt idx="3">
                  <c:v>0.4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A33-46F7-AC5D-86F6751A15B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487738184"/>
        <c:axId val="487737544"/>
      </c:barChart>
      <c:catAx>
        <c:axId val="487738184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87737544"/>
        <c:crosses val="autoZero"/>
        <c:auto val="1"/>
        <c:lblAlgn val="ctr"/>
        <c:lblOffset val="100"/>
        <c:noMultiLvlLbl val="0"/>
      </c:catAx>
      <c:valAx>
        <c:axId val="487737544"/>
        <c:scaling>
          <c:orientation val="minMax"/>
          <c:max val="1"/>
        </c:scaling>
        <c:delete val="0"/>
        <c:axPos val="t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877381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4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Stomach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4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'[Figure (20190601-20221031).xlsx]★変異が多いシグナル伝達経路 (Primary)'!$B$13:$B$16</c:f>
              <c:strCache>
                <c:ptCount val="4"/>
                <c:pt idx="0">
                  <c:v>TP53</c:v>
                </c:pt>
                <c:pt idx="1">
                  <c:v>RTK</c:v>
                </c:pt>
                <c:pt idx="2">
                  <c:v>Cell cycle</c:v>
                </c:pt>
                <c:pt idx="3">
                  <c:v>Epigenetic modification</c:v>
                </c:pt>
              </c:strCache>
            </c:strRef>
          </c:cat>
          <c:val>
            <c:numRef>
              <c:f>'[Figure (20190601-20221031).xlsx]★変異が多いシグナル伝達経路 (Primary)'!$C$13:$C$16</c:f>
              <c:numCache>
                <c:formatCode>0%</c:formatCode>
                <c:ptCount val="4"/>
                <c:pt idx="0">
                  <c:v>0.72</c:v>
                </c:pt>
                <c:pt idx="1">
                  <c:v>0.63</c:v>
                </c:pt>
                <c:pt idx="2">
                  <c:v>0.6</c:v>
                </c:pt>
                <c:pt idx="3">
                  <c:v>0.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85F-4731-9DD2-F5DCC2BA27A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461979768"/>
        <c:axId val="461975928"/>
      </c:barChart>
      <c:catAx>
        <c:axId val="461979768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61975928"/>
        <c:crosses val="autoZero"/>
        <c:auto val="1"/>
        <c:lblAlgn val="ctr"/>
        <c:lblOffset val="100"/>
        <c:noMultiLvlLbl val="0"/>
      </c:catAx>
      <c:valAx>
        <c:axId val="461975928"/>
        <c:scaling>
          <c:orientation val="minMax"/>
        </c:scaling>
        <c:delete val="0"/>
        <c:axPos val="t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619797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4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Stomach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4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32263723461286198"/>
          <c:y val="0.25928921357114393"/>
          <c:w val="0.6218706854467968"/>
          <c:h val="0.68012919447298137"/>
        </c:manualLayout>
      </c:layout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'[Figure (20190601-20221031).xlsx]★変異が多いシグナル伝達経路 (Adeno-Primary)'!$B$13:$B$16</c:f>
              <c:strCache>
                <c:ptCount val="4"/>
                <c:pt idx="0">
                  <c:v>TP53</c:v>
                </c:pt>
                <c:pt idx="1">
                  <c:v>RTK</c:v>
                </c:pt>
                <c:pt idx="2">
                  <c:v>Cell cycle</c:v>
                </c:pt>
                <c:pt idx="3">
                  <c:v>Epigenetic modification</c:v>
                </c:pt>
              </c:strCache>
            </c:strRef>
          </c:cat>
          <c:val>
            <c:numRef>
              <c:f>'[Figure (20190601-20221031).xlsx]★変異が多いシグナル伝達経路 (Adeno-Primary)'!$C$13:$C$16</c:f>
              <c:numCache>
                <c:formatCode>0%</c:formatCode>
                <c:ptCount val="4"/>
                <c:pt idx="0">
                  <c:v>0.75</c:v>
                </c:pt>
                <c:pt idx="1">
                  <c:v>0.65</c:v>
                </c:pt>
                <c:pt idx="2">
                  <c:v>0.6</c:v>
                </c:pt>
                <c:pt idx="3">
                  <c:v>0.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187-4A55-B7CD-9B6477702E7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534929784"/>
        <c:axId val="534930424"/>
      </c:barChart>
      <c:catAx>
        <c:axId val="534929784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34930424"/>
        <c:crosses val="autoZero"/>
        <c:auto val="1"/>
        <c:lblAlgn val="ctr"/>
        <c:lblOffset val="100"/>
        <c:noMultiLvlLbl val="0"/>
      </c:catAx>
      <c:valAx>
        <c:axId val="534930424"/>
        <c:scaling>
          <c:orientation val="minMax"/>
          <c:max val="1"/>
        </c:scaling>
        <c:delete val="0"/>
        <c:axPos val="t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349297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4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Stomach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4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'[Figure (20190601-20221031).xlsx]★変異が多い遺伝子 (Adeno-Primary)'!$B$8:$B$10</c:f>
              <c:strCache>
                <c:ptCount val="3"/>
                <c:pt idx="0">
                  <c:v>TP53</c:v>
                </c:pt>
                <c:pt idx="1">
                  <c:v>ERBB2</c:v>
                </c:pt>
                <c:pt idx="2">
                  <c:v>CCNE1</c:v>
                </c:pt>
              </c:strCache>
            </c:strRef>
          </c:cat>
          <c:val>
            <c:numRef>
              <c:f>'[Figure (20190601-20221031).xlsx]★変異が多い遺伝子 (Adeno-Primary)'!$C$8:$C$10</c:f>
              <c:numCache>
                <c:formatCode>0%</c:formatCode>
                <c:ptCount val="3"/>
                <c:pt idx="0">
                  <c:v>0.7</c:v>
                </c:pt>
                <c:pt idx="1">
                  <c:v>0.28000000000000003</c:v>
                </c:pt>
                <c:pt idx="2">
                  <c:v>0.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688-45AD-8045-00E766A5C0F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700495304"/>
        <c:axId val="700495624"/>
      </c:barChart>
      <c:catAx>
        <c:axId val="700495304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1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700495624"/>
        <c:crosses val="autoZero"/>
        <c:auto val="1"/>
        <c:lblAlgn val="ctr"/>
        <c:lblOffset val="100"/>
        <c:noMultiLvlLbl val="0"/>
      </c:catAx>
      <c:valAx>
        <c:axId val="700495624"/>
        <c:scaling>
          <c:orientation val="minMax"/>
          <c:max val="1"/>
        </c:scaling>
        <c:delete val="0"/>
        <c:axPos val="t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7004953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4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Duodenum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4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'[Figure (20190601-20221031).xlsx]★変異が多い遺伝子 (Adeno-Primary)'!$B$14:$B$38</c:f>
              <c:strCache>
                <c:ptCount val="25"/>
                <c:pt idx="0">
                  <c:v>TP53</c:v>
                </c:pt>
                <c:pt idx="1">
                  <c:v>CDKN2A</c:v>
                </c:pt>
                <c:pt idx="2">
                  <c:v>BRAF</c:v>
                </c:pt>
                <c:pt idx="3">
                  <c:v>BRCA1</c:v>
                </c:pt>
                <c:pt idx="4">
                  <c:v>CALR</c:v>
                </c:pt>
                <c:pt idx="5">
                  <c:v>CCND3</c:v>
                </c:pt>
                <c:pt idx="6">
                  <c:v>CDK4</c:v>
                </c:pt>
                <c:pt idx="7">
                  <c:v>CDK8</c:v>
                </c:pt>
                <c:pt idx="8">
                  <c:v>CDKN2B</c:v>
                </c:pt>
                <c:pt idx="9">
                  <c:v>CTNNB1</c:v>
                </c:pt>
                <c:pt idx="10">
                  <c:v>ERBB2</c:v>
                </c:pt>
                <c:pt idx="11">
                  <c:v>FGF10</c:v>
                </c:pt>
                <c:pt idx="12">
                  <c:v>FGFR1</c:v>
                </c:pt>
                <c:pt idx="13">
                  <c:v>FLT3</c:v>
                </c:pt>
                <c:pt idx="14">
                  <c:v>GNAS</c:v>
                </c:pt>
                <c:pt idx="15">
                  <c:v>KRAS</c:v>
                </c:pt>
                <c:pt idx="16">
                  <c:v>MDM2</c:v>
                </c:pt>
                <c:pt idx="17">
                  <c:v>MTAP</c:v>
                </c:pt>
                <c:pt idx="18">
                  <c:v>NF1</c:v>
                </c:pt>
                <c:pt idx="19">
                  <c:v>PBRM1</c:v>
                </c:pt>
                <c:pt idx="20">
                  <c:v>RPTOR</c:v>
                </c:pt>
                <c:pt idx="21">
                  <c:v>SMAD4</c:v>
                </c:pt>
                <c:pt idx="22">
                  <c:v>SNCAIP</c:v>
                </c:pt>
                <c:pt idx="23">
                  <c:v>VEGFA</c:v>
                </c:pt>
                <c:pt idx="24">
                  <c:v>WHSC1L1</c:v>
                </c:pt>
              </c:strCache>
            </c:strRef>
          </c:cat>
          <c:val>
            <c:numRef>
              <c:f>'[Figure (20190601-20221031).xlsx]★変異が多い遺伝子 (Adeno-Primary)'!$C$14:$C$38</c:f>
              <c:numCache>
                <c:formatCode>0%</c:formatCode>
                <c:ptCount val="25"/>
                <c:pt idx="0">
                  <c:v>0.75</c:v>
                </c:pt>
                <c:pt idx="1">
                  <c:v>0.5</c:v>
                </c:pt>
                <c:pt idx="2">
                  <c:v>0.25</c:v>
                </c:pt>
                <c:pt idx="3">
                  <c:v>0.25</c:v>
                </c:pt>
                <c:pt idx="4">
                  <c:v>0.25</c:v>
                </c:pt>
                <c:pt idx="5">
                  <c:v>0.25</c:v>
                </c:pt>
                <c:pt idx="6">
                  <c:v>0.25</c:v>
                </c:pt>
                <c:pt idx="7">
                  <c:v>0.25</c:v>
                </c:pt>
                <c:pt idx="8">
                  <c:v>0.25</c:v>
                </c:pt>
                <c:pt idx="9">
                  <c:v>0.25</c:v>
                </c:pt>
                <c:pt idx="10">
                  <c:v>0.25</c:v>
                </c:pt>
                <c:pt idx="11">
                  <c:v>0.25</c:v>
                </c:pt>
                <c:pt idx="12">
                  <c:v>0.25</c:v>
                </c:pt>
                <c:pt idx="13">
                  <c:v>0.25</c:v>
                </c:pt>
                <c:pt idx="14">
                  <c:v>0.25</c:v>
                </c:pt>
                <c:pt idx="15">
                  <c:v>0.25</c:v>
                </c:pt>
                <c:pt idx="16">
                  <c:v>0.25</c:v>
                </c:pt>
                <c:pt idx="17">
                  <c:v>0.25</c:v>
                </c:pt>
                <c:pt idx="18">
                  <c:v>0.25</c:v>
                </c:pt>
                <c:pt idx="19">
                  <c:v>0.25</c:v>
                </c:pt>
                <c:pt idx="20">
                  <c:v>0.25</c:v>
                </c:pt>
                <c:pt idx="21">
                  <c:v>0.25</c:v>
                </c:pt>
                <c:pt idx="22">
                  <c:v>0.25</c:v>
                </c:pt>
                <c:pt idx="23">
                  <c:v>0.25</c:v>
                </c:pt>
                <c:pt idx="24">
                  <c:v>0.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8E2-4B40-BFA1-E5BD613ADBC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551225784"/>
        <c:axId val="551227384"/>
      </c:barChart>
      <c:catAx>
        <c:axId val="551225784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1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51227384"/>
        <c:crosses val="autoZero"/>
        <c:auto val="1"/>
        <c:lblAlgn val="ctr"/>
        <c:lblOffset val="100"/>
        <c:noMultiLvlLbl val="0"/>
      </c:catAx>
      <c:valAx>
        <c:axId val="551227384"/>
        <c:scaling>
          <c:orientation val="minMax"/>
          <c:max val="1"/>
        </c:scaling>
        <c:delete val="0"/>
        <c:axPos val="t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512257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4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Small intestine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4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'[Figure (20190601-20221031).xlsx]★変異が多い遺伝子 (Adeno-Primary)'!$B$42:$B$58</c:f>
              <c:strCache>
                <c:ptCount val="17"/>
                <c:pt idx="0">
                  <c:v>KRAS</c:v>
                </c:pt>
                <c:pt idx="1">
                  <c:v>NRAS</c:v>
                </c:pt>
                <c:pt idx="2">
                  <c:v>TP53</c:v>
                </c:pt>
                <c:pt idx="3">
                  <c:v>ARID1A</c:v>
                </c:pt>
                <c:pt idx="4">
                  <c:v>AURKA</c:v>
                </c:pt>
                <c:pt idx="5">
                  <c:v>BRAF</c:v>
                </c:pt>
                <c:pt idx="6">
                  <c:v>CDKN2A</c:v>
                </c:pt>
                <c:pt idx="7">
                  <c:v>CDKN2B</c:v>
                </c:pt>
                <c:pt idx="8">
                  <c:v>CTCF</c:v>
                </c:pt>
                <c:pt idx="9">
                  <c:v>FBXW7</c:v>
                </c:pt>
                <c:pt idx="10">
                  <c:v>GNAS</c:v>
                </c:pt>
                <c:pt idx="11">
                  <c:v>MTAP</c:v>
                </c:pt>
                <c:pt idx="12">
                  <c:v>PIK3R1</c:v>
                </c:pt>
                <c:pt idx="13">
                  <c:v>PTCH1</c:v>
                </c:pt>
                <c:pt idx="14">
                  <c:v>SMAD4</c:v>
                </c:pt>
                <c:pt idx="15">
                  <c:v>TGFBR2</c:v>
                </c:pt>
                <c:pt idx="16">
                  <c:v>SF3B1</c:v>
                </c:pt>
              </c:strCache>
            </c:strRef>
          </c:cat>
          <c:val>
            <c:numRef>
              <c:f>'[Figure (20190601-20221031).xlsx]★変異が多い遺伝子 (Adeno-Primary)'!$C$42:$C$58</c:f>
              <c:numCache>
                <c:formatCode>0%</c:formatCode>
                <c:ptCount val="17"/>
                <c:pt idx="0">
                  <c:v>0.5</c:v>
                </c:pt>
                <c:pt idx="1">
                  <c:v>0.5</c:v>
                </c:pt>
                <c:pt idx="2">
                  <c:v>0.5</c:v>
                </c:pt>
                <c:pt idx="3">
                  <c:v>0.25</c:v>
                </c:pt>
                <c:pt idx="4">
                  <c:v>0.25</c:v>
                </c:pt>
                <c:pt idx="5">
                  <c:v>0.25</c:v>
                </c:pt>
                <c:pt idx="6">
                  <c:v>0.25</c:v>
                </c:pt>
                <c:pt idx="7">
                  <c:v>0.25</c:v>
                </c:pt>
                <c:pt idx="8">
                  <c:v>0.25</c:v>
                </c:pt>
                <c:pt idx="9">
                  <c:v>0.25</c:v>
                </c:pt>
                <c:pt idx="10">
                  <c:v>0.25</c:v>
                </c:pt>
                <c:pt idx="11">
                  <c:v>0.25</c:v>
                </c:pt>
                <c:pt idx="12">
                  <c:v>0.25</c:v>
                </c:pt>
                <c:pt idx="13">
                  <c:v>0.25</c:v>
                </c:pt>
                <c:pt idx="14">
                  <c:v>0.25</c:v>
                </c:pt>
                <c:pt idx="15">
                  <c:v>0.25</c:v>
                </c:pt>
                <c:pt idx="16">
                  <c:v>0.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E9F-4FF1-8167-E31E097DF63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700499784"/>
        <c:axId val="700500424"/>
      </c:barChart>
      <c:catAx>
        <c:axId val="700499784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1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700500424"/>
        <c:crosses val="autoZero"/>
        <c:auto val="1"/>
        <c:lblAlgn val="ctr"/>
        <c:lblOffset val="100"/>
        <c:noMultiLvlLbl val="0"/>
      </c:catAx>
      <c:valAx>
        <c:axId val="700500424"/>
        <c:scaling>
          <c:orientation val="minMax"/>
          <c:max val="1"/>
        </c:scaling>
        <c:delete val="0"/>
        <c:axPos val="t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7004997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4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Colorectal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4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'[Figure (20190601-20221031).xlsx]★変異が多い遺伝子 (Adeno-Primary)'!$B$62:$B$64</c:f>
              <c:strCache>
                <c:ptCount val="3"/>
                <c:pt idx="0">
                  <c:v>TP53</c:v>
                </c:pt>
                <c:pt idx="1">
                  <c:v>APC</c:v>
                </c:pt>
                <c:pt idx="2">
                  <c:v>KRAS</c:v>
                </c:pt>
              </c:strCache>
            </c:strRef>
          </c:cat>
          <c:val>
            <c:numRef>
              <c:f>'[Figure (20190601-20221031).xlsx]★変異が多い遺伝子 (Adeno-Primary)'!$C$62:$C$64</c:f>
              <c:numCache>
                <c:formatCode>0%</c:formatCode>
                <c:ptCount val="3"/>
                <c:pt idx="0">
                  <c:v>0.79</c:v>
                </c:pt>
                <c:pt idx="1">
                  <c:v>0.78</c:v>
                </c:pt>
                <c:pt idx="2">
                  <c:v>0.4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1A4-4BCA-ABF2-5A657B1219D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534940664"/>
        <c:axId val="534942264"/>
      </c:barChart>
      <c:catAx>
        <c:axId val="534940664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1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34942264"/>
        <c:crosses val="autoZero"/>
        <c:auto val="1"/>
        <c:lblAlgn val="ctr"/>
        <c:lblOffset val="100"/>
        <c:noMultiLvlLbl val="0"/>
      </c:catAx>
      <c:valAx>
        <c:axId val="534942264"/>
        <c:scaling>
          <c:orientation val="minMax"/>
          <c:max val="1"/>
        </c:scaling>
        <c:delete val="0"/>
        <c:axPos val="t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349406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4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Pancreas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4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'[Figure (20190601-20221031).xlsx]★変異が多い遺伝子 (Adeno-Primary)'!$B$69:$B$74</c:f>
              <c:strCache>
                <c:ptCount val="6"/>
                <c:pt idx="0">
                  <c:v>KRAS</c:v>
                </c:pt>
                <c:pt idx="1">
                  <c:v>TP53</c:v>
                </c:pt>
                <c:pt idx="2">
                  <c:v>CDKN2A</c:v>
                </c:pt>
                <c:pt idx="3">
                  <c:v>SMAD4</c:v>
                </c:pt>
                <c:pt idx="4">
                  <c:v>CDKN2B</c:v>
                </c:pt>
                <c:pt idx="5">
                  <c:v>MTAP</c:v>
                </c:pt>
              </c:strCache>
            </c:strRef>
          </c:cat>
          <c:val>
            <c:numRef>
              <c:f>'[Figure (20190601-20221031).xlsx]★変異が多い遺伝子 (Adeno-Primary)'!$C$69:$C$74</c:f>
              <c:numCache>
                <c:formatCode>0%</c:formatCode>
                <c:ptCount val="6"/>
                <c:pt idx="0">
                  <c:v>0.92</c:v>
                </c:pt>
                <c:pt idx="1">
                  <c:v>0.72</c:v>
                </c:pt>
                <c:pt idx="2">
                  <c:v>0.48</c:v>
                </c:pt>
                <c:pt idx="3">
                  <c:v>0.3</c:v>
                </c:pt>
                <c:pt idx="4">
                  <c:v>0.28000000000000003</c:v>
                </c:pt>
                <c:pt idx="5">
                  <c:v>0.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53E-41FA-B323-DA06609AD69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460623800"/>
        <c:axId val="460628920"/>
      </c:barChart>
      <c:catAx>
        <c:axId val="460623800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1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60628920"/>
        <c:crosses val="autoZero"/>
        <c:auto val="1"/>
        <c:lblAlgn val="ctr"/>
        <c:lblOffset val="100"/>
        <c:noMultiLvlLbl val="0"/>
      </c:catAx>
      <c:valAx>
        <c:axId val="460628920"/>
        <c:scaling>
          <c:orientation val="minMax"/>
        </c:scaling>
        <c:delete val="0"/>
        <c:axPos val="t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606238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4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Biliary tract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4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'[Figure (20190601-20221031).xlsx]★変異が多い遺伝子 (Adeno-Primary)'!$B$78:$B$81</c:f>
              <c:strCache>
                <c:ptCount val="4"/>
                <c:pt idx="0">
                  <c:v>TP53</c:v>
                </c:pt>
                <c:pt idx="1">
                  <c:v>CDKN2A</c:v>
                </c:pt>
                <c:pt idx="2">
                  <c:v>CDKN2B</c:v>
                </c:pt>
                <c:pt idx="3">
                  <c:v>KRAS</c:v>
                </c:pt>
              </c:strCache>
            </c:strRef>
          </c:cat>
          <c:val>
            <c:numRef>
              <c:f>'[Figure (20190601-20221031).xlsx]★変異が多い遺伝子 (Adeno-Primary)'!$C$78:$C$81</c:f>
              <c:numCache>
                <c:formatCode>0%</c:formatCode>
                <c:ptCount val="4"/>
                <c:pt idx="0">
                  <c:v>0.48</c:v>
                </c:pt>
                <c:pt idx="1">
                  <c:v>0.32</c:v>
                </c:pt>
                <c:pt idx="2">
                  <c:v>0.21</c:v>
                </c:pt>
                <c:pt idx="3">
                  <c:v>0.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9DA-4381-BB6C-601D5BCEE18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700463944"/>
        <c:axId val="700465224"/>
      </c:barChart>
      <c:catAx>
        <c:axId val="700463944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1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700465224"/>
        <c:crosses val="autoZero"/>
        <c:auto val="1"/>
        <c:lblAlgn val="ctr"/>
        <c:lblOffset val="100"/>
        <c:noMultiLvlLbl val="0"/>
      </c:catAx>
      <c:valAx>
        <c:axId val="700465224"/>
        <c:scaling>
          <c:orientation val="minMax"/>
          <c:max val="1"/>
        </c:scaling>
        <c:delete val="0"/>
        <c:axPos val="t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70046394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4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i="0" dirty="0">
                <a:solidFill>
                  <a:schemeClr val="tx1"/>
                </a:solidFill>
              </a:rPr>
              <a:t>Rate of </a:t>
            </a:r>
            <a:r>
              <a:rPr lang="en-US" i="1" dirty="0">
                <a:solidFill>
                  <a:schemeClr val="tx1"/>
                </a:solidFill>
              </a:rPr>
              <a:t>APC</a:t>
            </a:r>
            <a:r>
              <a:rPr lang="en-US" i="0" dirty="0">
                <a:solidFill>
                  <a:schemeClr val="tx1"/>
                </a:solidFill>
              </a:rPr>
              <a:t> </a:t>
            </a:r>
            <a:r>
              <a:rPr lang="en-US" dirty="0">
                <a:solidFill>
                  <a:schemeClr val="tx1"/>
                </a:solidFill>
              </a:rPr>
              <a:t>alteration presence in </a:t>
            </a:r>
          </a:p>
          <a:p>
            <a:pPr>
              <a:defRPr lang="ja-JP"/>
            </a:pPr>
            <a:r>
              <a:rPr lang="en-US" dirty="0">
                <a:solidFill>
                  <a:schemeClr val="tx1"/>
                </a:solidFill>
              </a:rPr>
              <a:t>digestive adenocarcinoma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4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pieChart>
        <c:varyColors val="1"/>
        <c:ser>
          <c:idx val="0"/>
          <c:order val="0"/>
          <c:tx>
            <c:strRef>
              <c:f>'[Figures ver.1.1.xlsx]★Sup-Figure 5 (partial)'!$B$2</c:f>
              <c:strCache>
                <c:ptCount val="1"/>
                <c:pt idx="0">
                  <c:v>APC alteration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</c:spPr>
          <c:dPt>
            <c:idx val="0"/>
            <c:bubble3D val="0"/>
            <c:spPr>
              <a:solidFill>
                <a:srgbClr val="00B0F0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61B2-43E2-888A-7455BA4320F7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61B2-43E2-888A-7455BA4320F7}"/>
              </c:ext>
            </c:extLst>
          </c:dPt>
          <c:dPt>
            <c:idx val="2"/>
            <c:bubble3D val="0"/>
            <c:spPr>
              <a:solidFill>
                <a:srgbClr val="CC66FF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61B2-43E2-888A-7455BA4320F7}"/>
              </c:ext>
            </c:extLst>
          </c:dPt>
          <c:dPt>
            <c:idx val="3"/>
            <c:bubble3D val="0"/>
            <c:spPr>
              <a:solidFill>
                <a:srgbClr val="00B050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61B2-43E2-888A-7455BA4320F7}"/>
              </c:ext>
            </c:extLst>
          </c:dPt>
          <c:dLbls>
            <c:dLbl>
              <c:idx val="0"/>
              <c:layout>
                <c:manualLayout>
                  <c:x val="0.13788783313143549"/>
                  <c:y val="8.1230917563875939E-3"/>
                </c:manualLayout>
              </c:layout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61B2-43E2-888A-7455BA4320F7}"/>
                </c:ext>
              </c:extLst>
            </c:dLbl>
            <c:dLbl>
              <c:idx val="2"/>
              <c:layout>
                <c:manualLayout>
                  <c:x val="-0.16405993000874891"/>
                  <c:y val="7.6933143773694951E-2"/>
                </c:manualLayout>
              </c:layout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61B2-43E2-888A-7455BA4320F7}"/>
                </c:ext>
              </c:extLst>
            </c:dLbl>
            <c:dLbl>
              <c:idx val="3"/>
              <c:layout>
                <c:manualLayout>
                  <c:x val="-2.7887833131435537E-2"/>
                  <c:y val="-2.169371685682147E-4"/>
                </c:manualLayout>
              </c:layout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61B2-43E2-888A-7455BA4320F7}"/>
                </c:ext>
              </c:extLst>
            </c:dLbl>
            <c:spPr>
              <a:solidFill>
                <a:schemeClr val="bg1"/>
              </a:solidFill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lang="ja-JP"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ja-JP"/>
              </a:p>
            </c:txPr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[Figures ver.1.1.xlsx]★Sup-Figure 5 (partial)'!$C$1:$F$1</c:f>
              <c:strCache>
                <c:ptCount val="4"/>
                <c:pt idx="0">
                  <c:v>Stomach</c:v>
                </c:pt>
                <c:pt idx="1">
                  <c:v>Colorectal</c:v>
                </c:pt>
                <c:pt idx="2">
                  <c:v>Pancreas</c:v>
                </c:pt>
                <c:pt idx="3">
                  <c:v>Biliary tract</c:v>
                </c:pt>
              </c:strCache>
            </c:strRef>
          </c:cat>
          <c:val>
            <c:numRef>
              <c:f>'[Figures ver.1.1.xlsx]★Sup-Figure 5 (partial)'!$C$2:$F$2</c:f>
              <c:numCache>
                <c:formatCode>General</c:formatCode>
                <c:ptCount val="4"/>
                <c:pt idx="0">
                  <c:v>1</c:v>
                </c:pt>
                <c:pt idx="1">
                  <c:v>169</c:v>
                </c:pt>
                <c:pt idx="2">
                  <c:v>2</c:v>
                </c:pt>
                <c:pt idx="3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61B2-43E2-888A-7455BA4320F7}"/>
            </c:ext>
          </c:extLst>
        </c:ser>
        <c:dLbls>
          <c:showLegendKey val="0"/>
          <c:showVal val="0"/>
          <c:showCatName val="1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4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i="0" dirty="0">
                <a:solidFill>
                  <a:schemeClr val="tx1"/>
                </a:solidFill>
              </a:rPr>
              <a:t>Rate of </a:t>
            </a:r>
            <a:r>
              <a:rPr lang="en-US" i="1" dirty="0">
                <a:solidFill>
                  <a:schemeClr val="tx1"/>
                </a:solidFill>
              </a:rPr>
              <a:t>KRAS</a:t>
            </a:r>
            <a:r>
              <a:rPr lang="en-US" dirty="0">
                <a:solidFill>
                  <a:schemeClr val="tx1"/>
                </a:solidFill>
              </a:rPr>
              <a:t> alteration presence in</a:t>
            </a:r>
          </a:p>
          <a:p>
            <a:pPr>
              <a:defRPr lang="ja-JP"/>
            </a:pPr>
            <a:r>
              <a:rPr lang="en-US" dirty="0">
                <a:solidFill>
                  <a:schemeClr val="tx1"/>
                </a:solidFill>
              </a:rPr>
              <a:t>digestive adenocarcinoma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4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pieChart>
        <c:varyColors val="1"/>
        <c:ser>
          <c:idx val="0"/>
          <c:order val="0"/>
          <c:tx>
            <c:strRef>
              <c:f>'[Figures ver.1.1.xlsx]★Sup-Figure 5 (partial)'!$I$2</c:f>
              <c:strCache>
                <c:ptCount val="1"/>
                <c:pt idx="0">
                  <c:v>KRAS alteration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dPt>
            <c:idx val="0"/>
            <c:bubble3D val="0"/>
            <c:spPr>
              <a:solidFill>
                <a:srgbClr val="00B0F0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3F5F-49DC-99B4-760ABDC73211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3F5F-49DC-99B4-760ABDC73211}"/>
              </c:ext>
            </c:extLst>
          </c:dPt>
          <c:dPt>
            <c:idx val="2"/>
            <c:bubble3D val="0"/>
            <c:spPr>
              <a:solidFill>
                <a:srgbClr val="CC66FF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3F5F-49DC-99B4-760ABDC73211}"/>
              </c:ext>
            </c:extLst>
          </c:dPt>
          <c:dPt>
            <c:idx val="3"/>
            <c:bubble3D val="0"/>
            <c:spPr>
              <a:solidFill>
                <a:srgbClr val="00B050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3F5F-49DC-99B4-760ABDC73211}"/>
              </c:ext>
            </c:extLst>
          </c:dPt>
          <c:dLbls>
            <c:dLbl>
              <c:idx val="0"/>
              <c:layout>
                <c:manualLayout>
                  <c:x val="4.3781075277138267E-4"/>
                  <c:y val="-2.4746906636670416E-5"/>
                </c:manualLayout>
              </c:layout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3F5F-49DC-99B4-760ABDC73211}"/>
                </c:ext>
              </c:extLst>
            </c:dLbl>
            <c:spPr>
              <a:solidFill>
                <a:schemeClr val="bg1"/>
              </a:solidFill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lang="ja-JP"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ja-JP"/>
              </a:p>
            </c:txPr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[Figures ver.1.1.xlsx]★Sup-Figure 5 (partial)'!$J$1:$M$1</c:f>
              <c:strCache>
                <c:ptCount val="4"/>
                <c:pt idx="0">
                  <c:v>Stomach</c:v>
                </c:pt>
                <c:pt idx="1">
                  <c:v>Colorectal</c:v>
                </c:pt>
                <c:pt idx="2">
                  <c:v>Pancreas</c:v>
                </c:pt>
                <c:pt idx="3">
                  <c:v>Biliary tract</c:v>
                </c:pt>
              </c:strCache>
            </c:strRef>
          </c:cat>
          <c:val>
            <c:numRef>
              <c:f>'[Figures ver.1.1.xlsx]★Sup-Figure 5 (partial)'!$J$2:$M$2</c:f>
              <c:numCache>
                <c:formatCode>General</c:formatCode>
                <c:ptCount val="4"/>
                <c:pt idx="0">
                  <c:v>8</c:v>
                </c:pt>
                <c:pt idx="1">
                  <c:v>95</c:v>
                </c:pt>
                <c:pt idx="2">
                  <c:v>106</c:v>
                </c:pt>
                <c:pt idx="3">
                  <c:v>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3F5F-49DC-99B4-760ABDC73211}"/>
            </c:ext>
          </c:extLst>
        </c:ser>
        <c:dLbls>
          <c:showLegendKey val="0"/>
          <c:showVal val="0"/>
          <c:showCatName val="1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2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4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i="0" dirty="0">
                <a:solidFill>
                  <a:schemeClr val="tx1"/>
                </a:solidFill>
              </a:rPr>
              <a:t>Rate of </a:t>
            </a:r>
            <a:r>
              <a:rPr lang="en-US" i="1" dirty="0">
                <a:solidFill>
                  <a:schemeClr val="tx1"/>
                </a:solidFill>
              </a:rPr>
              <a:t>CDKN2A</a:t>
            </a:r>
            <a:r>
              <a:rPr lang="en-US" dirty="0">
                <a:solidFill>
                  <a:schemeClr val="tx1"/>
                </a:solidFill>
              </a:rPr>
              <a:t> alteration presence</a:t>
            </a:r>
            <a:r>
              <a:rPr lang="en-US" baseline="0" dirty="0">
                <a:solidFill>
                  <a:schemeClr val="tx1"/>
                </a:solidFill>
              </a:rPr>
              <a:t> in</a:t>
            </a:r>
            <a:endParaRPr lang="en-US" dirty="0">
              <a:solidFill>
                <a:schemeClr val="tx1"/>
              </a:solidFill>
            </a:endParaRPr>
          </a:p>
          <a:p>
            <a:pPr>
              <a:defRPr lang="ja-JP"/>
            </a:pPr>
            <a:r>
              <a:rPr lang="en-US" dirty="0">
                <a:solidFill>
                  <a:schemeClr val="tx1"/>
                </a:solidFill>
              </a:rPr>
              <a:t>digestive adenocarcinoma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4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pieChart>
        <c:varyColors val="1"/>
        <c:ser>
          <c:idx val="0"/>
          <c:order val="0"/>
          <c:tx>
            <c:strRef>
              <c:f>'[Figures ver.1.1.xlsx]★Sup-Figure 5 (partial)'!$P$2</c:f>
              <c:strCache>
                <c:ptCount val="1"/>
                <c:pt idx="0">
                  <c:v>CDKN2A alteration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dPt>
            <c:idx val="0"/>
            <c:bubble3D val="0"/>
            <c:spPr>
              <a:solidFill>
                <a:srgbClr val="00B0F0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E16A-4BFD-ADB3-760D158DEA27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E16A-4BFD-ADB3-760D158DEA27}"/>
              </c:ext>
            </c:extLst>
          </c:dPt>
          <c:dPt>
            <c:idx val="2"/>
            <c:bubble3D val="0"/>
            <c:spPr>
              <a:solidFill>
                <a:srgbClr val="CC66FF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E16A-4BFD-ADB3-760D158DEA27}"/>
              </c:ext>
            </c:extLst>
          </c:dPt>
          <c:dPt>
            <c:idx val="3"/>
            <c:bubble3D val="0"/>
            <c:spPr>
              <a:solidFill>
                <a:srgbClr val="00B050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E16A-4BFD-ADB3-760D158DEA27}"/>
              </c:ext>
            </c:extLst>
          </c:dPt>
          <c:dLbls>
            <c:dLbl>
              <c:idx val="0"/>
              <c:layout>
                <c:manualLayout>
                  <c:x val="-9.3746251620267368E-3"/>
                  <c:y val="1.8492688413948256E-3"/>
                </c:manualLayout>
              </c:layout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E16A-4BFD-ADB3-760D158DEA27}"/>
                </c:ext>
              </c:extLst>
            </c:dLbl>
            <c:spPr>
              <a:solidFill>
                <a:schemeClr val="bg1"/>
              </a:solidFill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lang="ja-JP"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ja-JP"/>
              </a:p>
            </c:txPr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[Figures ver.1.1.xlsx]★Sup-Figure 5 (partial)'!$Q$1:$T$1</c:f>
              <c:strCache>
                <c:ptCount val="4"/>
                <c:pt idx="0">
                  <c:v>Stomach</c:v>
                </c:pt>
                <c:pt idx="1">
                  <c:v>Colorectal</c:v>
                </c:pt>
                <c:pt idx="2">
                  <c:v>Pancreas</c:v>
                </c:pt>
                <c:pt idx="3">
                  <c:v>Biliary tract</c:v>
                </c:pt>
              </c:strCache>
            </c:strRef>
          </c:cat>
          <c:val>
            <c:numRef>
              <c:f>'[Figures ver.1.1.xlsx]★Sup-Figure 5 (partial)'!$Q$2:$T$2</c:f>
              <c:numCache>
                <c:formatCode>General</c:formatCode>
                <c:ptCount val="4"/>
                <c:pt idx="0">
                  <c:v>7</c:v>
                </c:pt>
                <c:pt idx="1">
                  <c:v>3</c:v>
                </c:pt>
                <c:pt idx="2">
                  <c:v>55</c:v>
                </c:pt>
                <c:pt idx="3">
                  <c:v>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E16A-4BFD-ADB3-760D158DEA27}"/>
            </c:ext>
          </c:extLst>
        </c:ser>
        <c:dLbls>
          <c:showLegendKey val="0"/>
          <c:showVal val="0"/>
          <c:showCatName val="1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4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Duodenum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4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'[Figure (20190601-20221031).xlsx]★変異が多いシグナル伝達経路 (Primary)'!$B$20:$B$24</c:f>
              <c:strCache>
                <c:ptCount val="5"/>
                <c:pt idx="0">
                  <c:v>TP53</c:v>
                </c:pt>
                <c:pt idx="1">
                  <c:v>RTK</c:v>
                </c:pt>
                <c:pt idx="2">
                  <c:v>Epigenetic modification</c:v>
                </c:pt>
                <c:pt idx="3">
                  <c:v>Cell cycle</c:v>
                </c:pt>
                <c:pt idx="4">
                  <c:v>Ras/Raf/MEK/ERK</c:v>
                </c:pt>
              </c:strCache>
            </c:strRef>
          </c:cat>
          <c:val>
            <c:numRef>
              <c:f>'[Figure (20190601-20221031).xlsx]★変異が多いシグナル伝達経路 (Primary)'!$C$20:$C$24</c:f>
              <c:numCache>
                <c:formatCode>0%</c:formatCode>
                <c:ptCount val="5"/>
                <c:pt idx="0">
                  <c:v>1</c:v>
                </c:pt>
                <c:pt idx="1">
                  <c:v>1</c:v>
                </c:pt>
                <c:pt idx="2">
                  <c:v>0.75</c:v>
                </c:pt>
                <c:pt idx="3">
                  <c:v>0.5</c:v>
                </c:pt>
                <c:pt idx="4">
                  <c:v>0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E97-4DB2-9E2C-A0EBC29AA53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477082808"/>
        <c:axId val="477083448"/>
      </c:barChart>
      <c:catAx>
        <c:axId val="477082808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77083448"/>
        <c:crosses val="autoZero"/>
        <c:auto val="1"/>
        <c:lblAlgn val="ctr"/>
        <c:lblOffset val="100"/>
        <c:noMultiLvlLbl val="0"/>
      </c:catAx>
      <c:valAx>
        <c:axId val="477083448"/>
        <c:scaling>
          <c:orientation val="minMax"/>
          <c:max val="1"/>
        </c:scaling>
        <c:delete val="0"/>
        <c:axPos val="t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770828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3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4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i="0" dirty="0">
                <a:solidFill>
                  <a:schemeClr val="tx1"/>
                </a:solidFill>
              </a:rPr>
              <a:t>Rate of </a:t>
            </a:r>
            <a:r>
              <a:rPr lang="en-US" i="1" dirty="0">
                <a:solidFill>
                  <a:schemeClr val="tx1"/>
                </a:solidFill>
              </a:rPr>
              <a:t>APC</a:t>
            </a:r>
            <a:r>
              <a:rPr lang="en-US" dirty="0">
                <a:solidFill>
                  <a:schemeClr val="tx1"/>
                </a:solidFill>
              </a:rPr>
              <a:t> alteration absence </a:t>
            </a:r>
          </a:p>
          <a:p>
            <a:pPr>
              <a:defRPr lang="ja-JP">
                <a:solidFill>
                  <a:schemeClr val="tx1"/>
                </a:solidFill>
              </a:defRPr>
            </a:pPr>
            <a:r>
              <a:rPr lang="en-US" dirty="0">
                <a:solidFill>
                  <a:schemeClr val="tx1"/>
                </a:solidFill>
              </a:rPr>
              <a:t>and </a:t>
            </a:r>
            <a:r>
              <a:rPr lang="en-US" i="1" dirty="0">
                <a:solidFill>
                  <a:schemeClr val="tx1"/>
                </a:solidFill>
              </a:rPr>
              <a:t>KRAS</a:t>
            </a:r>
            <a:r>
              <a:rPr lang="en-US" dirty="0">
                <a:solidFill>
                  <a:schemeClr val="tx1"/>
                </a:solidFill>
              </a:rPr>
              <a:t> alteration presence in</a:t>
            </a:r>
          </a:p>
          <a:p>
            <a:pPr>
              <a:defRPr lang="ja-JP">
                <a:solidFill>
                  <a:schemeClr val="tx1"/>
                </a:solidFill>
              </a:defRPr>
            </a:pPr>
            <a:r>
              <a:rPr lang="en-US" dirty="0">
                <a:solidFill>
                  <a:schemeClr val="tx1"/>
                </a:solidFill>
              </a:rPr>
              <a:t>digestive adenocarcinoma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4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pieChart>
        <c:varyColors val="1"/>
        <c:ser>
          <c:idx val="0"/>
          <c:order val="0"/>
          <c:tx>
            <c:strRef>
              <c:f>'[Figures ver.1.1.xlsx]★Sup-Figure 5 (partial)'!$B$23</c:f>
              <c:strCache>
                <c:ptCount val="1"/>
                <c:pt idx="0">
                  <c:v>APC alteration negative and KRAS alteration positive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dPt>
            <c:idx val="0"/>
            <c:bubble3D val="0"/>
            <c:spPr>
              <a:solidFill>
                <a:srgbClr val="00B0F0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6156-415B-88B2-4809C1A74B92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6156-415B-88B2-4809C1A74B92}"/>
              </c:ext>
            </c:extLst>
          </c:dPt>
          <c:dPt>
            <c:idx val="2"/>
            <c:bubble3D val="0"/>
            <c:spPr>
              <a:solidFill>
                <a:srgbClr val="CC66FF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6156-415B-88B2-4809C1A74B92}"/>
              </c:ext>
            </c:extLst>
          </c:dPt>
          <c:dPt>
            <c:idx val="3"/>
            <c:bubble3D val="0"/>
            <c:spPr>
              <a:solidFill>
                <a:srgbClr val="00B050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6156-415B-88B2-4809C1A74B92}"/>
              </c:ext>
            </c:extLst>
          </c:dPt>
          <c:dLbls>
            <c:dLbl>
              <c:idx val="0"/>
              <c:layout>
                <c:manualLayout>
                  <c:x val="3.7081882192610452E-2"/>
                  <c:y val="1.0233215122918795E-2"/>
                </c:manualLayout>
              </c:layout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6156-415B-88B2-4809C1A74B92}"/>
                </c:ext>
              </c:extLst>
            </c:dLbl>
            <c:dLbl>
              <c:idx val="1"/>
              <c:layout>
                <c:manualLayout>
                  <c:x val="2.9528324584426946E-2"/>
                  <c:y val="3.8338436862058911E-3"/>
                </c:manualLayout>
              </c:layout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6156-415B-88B2-4809C1A74B92}"/>
                </c:ext>
              </c:extLst>
            </c:dLbl>
            <c:dLbl>
              <c:idx val="3"/>
              <c:layout>
                <c:manualLayout>
                  <c:x val="9.461917019987881E-2"/>
                  <c:y val="0.14812916992246192"/>
                </c:manualLayout>
              </c:layout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6156-415B-88B2-4809C1A74B92}"/>
                </c:ext>
              </c:extLst>
            </c:dLbl>
            <c:spPr>
              <a:solidFill>
                <a:schemeClr val="bg1"/>
              </a:solidFill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lang="ja-JP" sz="9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ja-JP"/>
              </a:p>
            </c:txPr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[Figures ver.1.1.xlsx]★Sup-Figure 5 (partial)'!$C$22:$F$22</c:f>
              <c:strCache>
                <c:ptCount val="4"/>
                <c:pt idx="0">
                  <c:v>Stomach</c:v>
                </c:pt>
                <c:pt idx="1">
                  <c:v>Colorectal</c:v>
                </c:pt>
                <c:pt idx="2">
                  <c:v>Pancreas</c:v>
                </c:pt>
                <c:pt idx="3">
                  <c:v>Biliary tract</c:v>
                </c:pt>
              </c:strCache>
            </c:strRef>
          </c:cat>
          <c:val>
            <c:numRef>
              <c:f>'[Figures ver.1.1.xlsx]★Sup-Figure 5 (partial)'!$C$23:$F$23</c:f>
              <c:numCache>
                <c:formatCode>General</c:formatCode>
                <c:ptCount val="4"/>
                <c:pt idx="0">
                  <c:v>8</c:v>
                </c:pt>
                <c:pt idx="1">
                  <c:v>17</c:v>
                </c:pt>
                <c:pt idx="2">
                  <c:v>104</c:v>
                </c:pt>
                <c:pt idx="3">
                  <c:v>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6156-415B-88B2-4809C1A74B92}"/>
            </c:ext>
          </c:extLst>
        </c:ser>
        <c:dLbls>
          <c:showLegendKey val="0"/>
          <c:showVal val="0"/>
          <c:showCatName val="1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3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4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i="1" dirty="0">
                <a:solidFill>
                  <a:schemeClr val="tx1"/>
                </a:solidFill>
              </a:rPr>
              <a:t>APC</a:t>
            </a:r>
            <a:r>
              <a:rPr lang="en-US" dirty="0">
                <a:solidFill>
                  <a:schemeClr val="tx1"/>
                </a:solidFill>
              </a:rPr>
              <a:t> and </a:t>
            </a:r>
            <a:r>
              <a:rPr lang="en-US" i="1" dirty="0">
                <a:solidFill>
                  <a:schemeClr val="tx1"/>
                </a:solidFill>
              </a:rPr>
              <a:t>KRAS</a:t>
            </a:r>
            <a:r>
              <a:rPr lang="en-US" dirty="0">
                <a:solidFill>
                  <a:schemeClr val="tx1"/>
                </a:solidFill>
              </a:rPr>
              <a:t> alterations absence  </a:t>
            </a:r>
          </a:p>
          <a:p>
            <a:pPr>
              <a:defRPr lang="ja-JP">
                <a:solidFill>
                  <a:schemeClr val="tx1"/>
                </a:solidFill>
              </a:defRPr>
            </a:pPr>
            <a:r>
              <a:rPr lang="en-US" dirty="0">
                <a:solidFill>
                  <a:schemeClr val="tx1"/>
                </a:solidFill>
              </a:rPr>
              <a:t>and </a:t>
            </a:r>
            <a:r>
              <a:rPr lang="en-US" i="1" dirty="0">
                <a:solidFill>
                  <a:schemeClr val="tx1"/>
                </a:solidFill>
              </a:rPr>
              <a:t>CDKN2A</a:t>
            </a:r>
            <a:r>
              <a:rPr lang="en-US" dirty="0">
                <a:solidFill>
                  <a:schemeClr val="tx1"/>
                </a:solidFill>
              </a:rPr>
              <a:t> alteration presence in</a:t>
            </a:r>
          </a:p>
          <a:p>
            <a:pPr>
              <a:defRPr lang="ja-JP">
                <a:solidFill>
                  <a:schemeClr val="tx1"/>
                </a:solidFill>
              </a:defRPr>
            </a:pPr>
            <a:r>
              <a:rPr lang="en-US" dirty="0">
                <a:solidFill>
                  <a:schemeClr val="tx1"/>
                </a:solidFill>
              </a:rPr>
              <a:t>digestive adenocarcinoma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4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pieChart>
        <c:varyColors val="1"/>
        <c:ser>
          <c:idx val="0"/>
          <c:order val="0"/>
          <c:tx>
            <c:strRef>
              <c:f>'[Figures ver.1.1.xlsx]★Sup-Figure 5 (partial)'!$I$23</c:f>
              <c:strCache>
                <c:ptCount val="1"/>
                <c:pt idx="0">
                  <c:v>APC and KRAS alteration negative, and CDKN2A alteration positive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dPt>
            <c:idx val="0"/>
            <c:bubble3D val="0"/>
            <c:spPr>
              <a:solidFill>
                <a:srgbClr val="00B0F0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3114-403D-B631-CDBFFA6B4801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3114-403D-B631-CDBFFA6B4801}"/>
              </c:ext>
            </c:extLst>
          </c:dPt>
          <c:dPt>
            <c:idx val="2"/>
            <c:bubble3D val="0"/>
            <c:spPr>
              <a:solidFill>
                <a:srgbClr val="CC66FF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3114-403D-B631-CDBFFA6B4801}"/>
              </c:ext>
            </c:extLst>
          </c:dPt>
          <c:dPt>
            <c:idx val="3"/>
            <c:bubble3D val="0"/>
            <c:spPr>
              <a:solidFill>
                <a:srgbClr val="00B050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3114-403D-B631-CDBFFA6B4801}"/>
              </c:ext>
            </c:extLst>
          </c:dPt>
          <c:dLbls>
            <c:dLbl>
              <c:idx val="0"/>
              <c:layout>
                <c:manualLayout>
                  <c:x val="-8.828145253342104E-2"/>
                  <c:y val="0.15405962613451946"/>
                </c:manualLayout>
              </c:layout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3114-403D-B631-CDBFFA6B4801}"/>
                </c:ext>
              </c:extLst>
            </c:dLbl>
            <c:dLbl>
              <c:idx val="2"/>
              <c:layout>
                <c:manualLayout>
                  <c:x val="2.9709208223972005E-2"/>
                  <c:y val="1.4517351997666959E-2"/>
                </c:manualLayout>
              </c:layout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3114-403D-B631-CDBFFA6B4801}"/>
                </c:ext>
              </c:extLst>
            </c:dLbl>
            <c:spPr>
              <a:solidFill>
                <a:schemeClr val="bg1"/>
              </a:solidFill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9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ja-JP"/>
              </a:p>
            </c:txPr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[Figures ver.1.1.xlsx]★Sup-Figure 5 (partial)'!$J$22:$M$22</c:f>
              <c:strCache>
                <c:ptCount val="4"/>
                <c:pt idx="0">
                  <c:v>Stomach</c:v>
                </c:pt>
                <c:pt idx="1">
                  <c:v>Colorectal</c:v>
                </c:pt>
                <c:pt idx="2">
                  <c:v>Pancreas</c:v>
                </c:pt>
                <c:pt idx="3">
                  <c:v>Biliary tract</c:v>
                </c:pt>
              </c:strCache>
            </c:strRef>
          </c:cat>
          <c:val>
            <c:numRef>
              <c:f>'[Figures ver.1.1.xlsx]★Sup-Figure 5 (partial)'!$J$23:$M$23</c:f>
              <c:numCache>
                <c:formatCode>General</c:formatCode>
                <c:ptCount val="4"/>
                <c:pt idx="0">
                  <c:v>6</c:v>
                </c:pt>
                <c:pt idx="1">
                  <c:v>0</c:v>
                </c:pt>
                <c:pt idx="2">
                  <c:v>2</c:v>
                </c:pt>
                <c:pt idx="3">
                  <c:v>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3114-403D-B631-CDBFFA6B4801}"/>
            </c:ext>
          </c:extLst>
        </c:ser>
        <c:dLbls>
          <c:showLegendKey val="0"/>
          <c:showVal val="0"/>
          <c:showCatName val="1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3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4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i="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ate of </a:t>
            </a:r>
            <a:r>
              <a:rPr lang="en-US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PC</a:t>
            </a:r>
            <a:r>
              <a:rPr 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RAS</a:t>
            </a:r>
            <a:r>
              <a:rPr 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KN2A</a:t>
            </a:r>
            <a:r>
              <a:rPr 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>
              <a:defRPr lang="ja-JP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lterations absence in</a:t>
            </a:r>
          </a:p>
          <a:p>
            <a:pPr>
              <a:defRPr lang="ja-JP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gestive adenocarcinoma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4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pieChart>
        <c:varyColors val="1"/>
        <c:ser>
          <c:idx val="0"/>
          <c:order val="0"/>
          <c:tx>
            <c:strRef>
              <c:f>'[Figures ver.1.1.xlsx]★Sup-Figure 5 (partial)'!$P$23</c:f>
              <c:strCache>
                <c:ptCount val="1"/>
                <c:pt idx="0">
                  <c:v>APC, KRAS and CDKN2A alterations negative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dPt>
            <c:idx val="0"/>
            <c:bubble3D val="0"/>
            <c:spPr>
              <a:solidFill>
                <a:srgbClr val="00B0F0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53AE-4450-A343-03B043B7D5E4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53AE-4450-A343-03B043B7D5E4}"/>
              </c:ext>
            </c:extLst>
          </c:dPt>
          <c:dPt>
            <c:idx val="2"/>
            <c:bubble3D val="0"/>
            <c:spPr>
              <a:solidFill>
                <a:srgbClr val="CC66FF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53AE-4450-A343-03B043B7D5E4}"/>
              </c:ext>
            </c:extLst>
          </c:dPt>
          <c:dPt>
            <c:idx val="3"/>
            <c:bubble3D val="0"/>
            <c:spPr>
              <a:solidFill>
                <a:srgbClr val="00B050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53AE-4450-A343-03B043B7D5E4}"/>
              </c:ext>
            </c:extLst>
          </c:dPt>
          <c:dLbls>
            <c:dLbl>
              <c:idx val="0"/>
              <c:layout>
                <c:manualLayout>
                  <c:x val="-8.3108267716535428E-2"/>
                  <c:y val="0.1556813210848644"/>
                </c:manualLayout>
              </c:layout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53AE-4450-A343-03B043B7D5E4}"/>
                </c:ext>
              </c:extLst>
            </c:dLbl>
            <c:dLbl>
              <c:idx val="2"/>
              <c:layout>
                <c:manualLayout>
                  <c:x val="2.7616360454943131E-2"/>
                  <c:y val="2.5882181393992418E-5"/>
                </c:manualLayout>
              </c:layout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53AE-4450-A343-03B043B7D5E4}"/>
                </c:ext>
              </c:extLst>
            </c:dLbl>
            <c:spPr>
              <a:solidFill>
                <a:schemeClr val="bg1"/>
              </a:solidFill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lang="ja-JP"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ja-JP"/>
              </a:p>
            </c:txPr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[Figures ver.1.1.xlsx]★Sup-Figure 5 (partial)'!$Q$22:$T$22</c:f>
              <c:strCache>
                <c:ptCount val="4"/>
                <c:pt idx="0">
                  <c:v>Stomach</c:v>
                </c:pt>
                <c:pt idx="1">
                  <c:v>Colorectal</c:v>
                </c:pt>
                <c:pt idx="2">
                  <c:v>Pancreas</c:v>
                </c:pt>
                <c:pt idx="3">
                  <c:v>Biliary tract</c:v>
                </c:pt>
              </c:strCache>
            </c:strRef>
          </c:cat>
          <c:val>
            <c:numRef>
              <c:f>'[Figures ver.1.1.xlsx]★Sup-Figure 5 (partial)'!$Q$23:$T$23</c:f>
              <c:numCache>
                <c:formatCode>General</c:formatCode>
                <c:ptCount val="4"/>
                <c:pt idx="0">
                  <c:v>26</c:v>
                </c:pt>
                <c:pt idx="1">
                  <c:v>23</c:v>
                </c:pt>
                <c:pt idx="2">
                  <c:v>7</c:v>
                </c:pt>
                <c:pt idx="3">
                  <c:v>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53AE-4450-A343-03B043B7D5E4}"/>
            </c:ext>
          </c:extLst>
        </c:ser>
        <c:dLbls>
          <c:showLegendKey val="0"/>
          <c:showVal val="0"/>
          <c:showCatName val="1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4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Small intestine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4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'[Figure (20190601-20221031).xlsx]★変異が多いシグナル伝達経路 (Primary)'!$B$28:$B$32</c:f>
              <c:strCache>
                <c:ptCount val="5"/>
                <c:pt idx="0">
                  <c:v>Ras/Raf/MEK/ERK</c:v>
                </c:pt>
                <c:pt idx="1">
                  <c:v>Cell cycle</c:v>
                </c:pt>
                <c:pt idx="2">
                  <c:v>Epigenetic modification</c:v>
                </c:pt>
                <c:pt idx="3">
                  <c:v>TGF-B</c:v>
                </c:pt>
                <c:pt idx="4">
                  <c:v>TP53</c:v>
                </c:pt>
              </c:strCache>
            </c:strRef>
          </c:cat>
          <c:val>
            <c:numRef>
              <c:f>'[Figure (20190601-20221031).xlsx]★変異が多いシグナル伝達経路 (Primary)'!$C$28:$C$32</c:f>
              <c:numCache>
                <c:formatCode>0%</c:formatCode>
                <c:ptCount val="5"/>
                <c:pt idx="0">
                  <c:v>0.67</c:v>
                </c:pt>
                <c:pt idx="1">
                  <c:v>0.33</c:v>
                </c:pt>
                <c:pt idx="2">
                  <c:v>0.33</c:v>
                </c:pt>
                <c:pt idx="3">
                  <c:v>0.33</c:v>
                </c:pt>
                <c:pt idx="4">
                  <c:v>0.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3EA-4EFB-9BA2-764A41E45C9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460595960"/>
        <c:axId val="460600120"/>
      </c:barChart>
      <c:catAx>
        <c:axId val="460595960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60600120"/>
        <c:crosses val="autoZero"/>
        <c:auto val="1"/>
        <c:lblAlgn val="ctr"/>
        <c:lblOffset val="100"/>
        <c:noMultiLvlLbl val="0"/>
      </c:catAx>
      <c:valAx>
        <c:axId val="460600120"/>
        <c:scaling>
          <c:orientation val="minMax"/>
          <c:max val="1"/>
        </c:scaling>
        <c:delete val="0"/>
        <c:axPos val="t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605959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4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Colorectal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4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'[Figure (20190601-20221031).xlsx]★変異が多いシグナル伝達経路 (Primary)'!$B$36:$B$39</c:f>
              <c:strCache>
                <c:ptCount val="4"/>
                <c:pt idx="0">
                  <c:v>TP53</c:v>
                </c:pt>
                <c:pt idx="1">
                  <c:v>Wnt/β-catenin</c:v>
                </c:pt>
                <c:pt idx="2">
                  <c:v>Ras/Raf/MEK/ERK</c:v>
                </c:pt>
                <c:pt idx="3">
                  <c:v>RTK</c:v>
                </c:pt>
              </c:strCache>
            </c:strRef>
          </c:cat>
          <c:val>
            <c:numRef>
              <c:f>'[Figure (20190601-20221031).xlsx]★変異が多いシグナル伝達経路 (Primary)'!$C$36:$C$39</c:f>
              <c:numCache>
                <c:formatCode>0%</c:formatCode>
                <c:ptCount val="4"/>
                <c:pt idx="0">
                  <c:v>0.83</c:v>
                </c:pt>
                <c:pt idx="1">
                  <c:v>0.83</c:v>
                </c:pt>
                <c:pt idx="2">
                  <c:v>0.72</c:v>
                </c:pt>
                <c:pt idx="3">
                  <c:v>0.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F4F-49FA-9EC8-1E479EB5666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551176504"/>
        <c:axId val="551177464"/>
      </c:barChart>
      <c:catAx>
        <c:axId val="551176504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51177464"/>
        <c:crosses val="autoZero"/>
        <c:auto val="1"/>
        <c:lblAlgn val="ctr"/>
        <c:lblOffset val="100"/>
        <c:noMultiLvlLbl val="0"/>
      </c:catAx>
      <c:valAx>
        <c:axId val="551177464"/>
        <c:scaling>
          <c:orientation val="minMax"/>
          <c:max val="1"/>
        </c:scaling>
        <c:delete val="0"/>
        <c:axPos val="t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511765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4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Pancereas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4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'[Figure (20190601-20221031).xlsx]★変異が多いシグナル伝達経路 (Primary)'!$B$43:$B$47</c:f>
              <c:strCache>
                <c:ptCount val="5"/>
                <c:pt idx="0">
                  <c:v>Ras/Raf/MEK/ERK</c:v>
                </c:pt>
                <c:pt idx="1">
                  <c:v>TP53</c:v>
                </c:pt>
                <c:pt idx="2">
                  <c:v>Cell cycle</c:v>
                </c:pt>
                <c:pt idx="3">
                  <c:v>TGF-B</c:v>
                </c:pt>
                <c:pt idx="4">
                  <c:v>Epigenetic modification</c:v>
                </c:pt>
              </c:strCache>
            </c:strRef>
          </c:cat>
          <c:val>
            <c:numRef>
              <c:f>'[Figure (20190601-20221031).xlsx]★変異が多いシグナル伝達経路 (Primary)'!$C$43:$C$47</c:f>
              <c:numCache>
                <c:formatCode>0%</c:formatCode>
                <c:ptCount val="5"/>
                <c:pt idx="0">
                  <c:v>0.91</c:v>
                </c:pt>
                <c:pt idx="1">
                  <c:v>0.74</c:v>
                </c:pt>
                <c:pt idx="2">
                  <c:v>0.52</c:v>
                </c:pt>
                <c:pt idx="3">
                  <c:v>0.38</c:v>
                </c:pt>
                <c:pt idx="4">
                  <c:v>0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4E1-4667-B477-2D0C9F269DB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551181304"/>
        <c:axId val="551181944"/>
      </c:barChart>
      <c:catAx>
        <c:axId val="551181304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51181944"/>
        <c:crosses val="autoZero"/>
        <c:auto val="1"/>
        <c:lblAlgn val="ctr"/>
        <c:lblOffset val="100"/>
        <c:noMultiLvlLbl val="0"/>
      </c:catAx>
      <c:valAx>
        <c:axId val="551181944"/>
        <c:scaling>
          <c:orientation val="minMax"/>
        </c:scaling>
        <c:delete val="0"/>
        <c:axPos val="t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511813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4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Biliary tract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4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'[Figure (20190601-20221031).xlsx]★変異が多いシグナル伝達経路 (Primary)'!$B$51:$B$54</c:f>
              <c:strCache>
                <c:ptCount val="4"/>
                <c:pt idx="0">
                  <c:v>TP53</c:v>
                </c:pt>
                <c:pt idx="1">
                  <c:v>Cell cycle</c:v>
                </c:pt>
                <c:pt idx="2">
                  <c:v>Epigenetic modification</c:v>
                </c:pt>
                <c:pt idx="3">
                  <c:v>Ras/Raf/MEK/ERK</c:v>
                </c:pt>
              </c:strCache>
            </c:strRef>
          </c:cat>
          <c:val>
            <c:numRef>
              <c:f>'[Figure (20190601-20221031).xlsx]★変異が多いシグナル伝達経路 (Primary)'!$C$51:$C$54</c:f>
              <c:numCache>
                <c:formatCode>0%</c:formatCode>
                <c:ptCount val="4"/>
                <c:pt idx="0">
                  <c:v>0.56000000000000005</c:v>
                </c:pt>
                <c:pt idx="1">
                  <c:v>0.47</c:v>
                </c:pt>
                <c:pt idx="2">
                  <c:v>0.43</c:v>
                </c:pt>
                <c:pt idx="3">
                  <c:v>0.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604-41FA-B2CF-3879BE4432D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551186744"/>
        <c:axId val="551192824"/>
      </c:barChart>
      <c:catAx>
        <c:axId val="551186744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51192824"/>
        <c:crosses val="autoZero"/>
        <c:auto val="1"/>
        <c:lblAlgn val="ctr"/>
        <c:lblOffset val="100"/>
        <c:noMultiLvlLbl val="0"/>
      </c:catAx>
      <c:valAx>
        <c:axId val="551192824"/>
        <c:scaling>
          <c:orientation val="minMax"/>
          <c:max val="1"/>
        </c:scaling>
        <c:delete val="0"/>
        <c:axPos val="t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5118674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4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Esophagus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4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'[Figure (20190601-20221031).xlsx]★変異が多い遺伝子 (Primary)'!$B$4:$B$13</c:f>
              <c:strCache>
                <c:ptCount val="10"/>
                <c:pt idx="0">
                  <c:v>TP53</c:v>
                </c:pt>
                <c:pt idx="1">
                  <c:v>CDKN2A</c:v>
                </c:pt>
                <c:pt idx="2">
                  <c:v>CDKN2B</c:v>
                </c:pt>
                <c:pt idx="3">
                  <c:v>CCND1</c:v>
                </c:pt>
                <c:pt idx="4">
                  <c:v>FGF3</c:v>
                </c:pt>
                <c:pt idx="5">
                  <c:v>FGF4</c:v>
                </c:pt>
                <c:pt idx="6">
                  <c:v>FGF19</c:v>
                </c:pt>
                <c:pt idx="7">
                  <c:v>MTAP</c:v>
                </c:pt>
                <c:pt idx="8">
                  <c:v>PIK3CA</c:v>
                </c:pt>
                <c:pt idx="9">
                  <c:v>RB1</c:v>
                </c:pt>
              </c:strCache>
            </c:strRef>
          </c:cat>
          <c:val>
            <c:numRef>
              <c:f>'[Figure (20190601-20221031).xlsx]★変異が多い遺伝子 (Primary)'!$C$4:$C$13</c:f>
              <c:numCache>
                <c:formatCode>0%</c:formatCode>
                <c:ptCount val="10"/>
                <c:pt idx="0">
                  <c:v>0.85</c:v>
                </c:pt>
                <c:pt idx="1">
                  <c:v>0.59</c:v>
                </c:pt>
                <c:pt idx="2">
                  <c:v>0.41</c:v>
                </c:pt>
                <c:pt idx="3">
                  <c:v>0.37</c:v>
                </c:pt>
                <c:pt idx="4">
                  <c:v>0.33</c:v>
                </c:pt>
                <c:pt idx="5">
                  <c:v>0.33</c:v>
                </c:pt>
                <c:pt idx="6">
                  <c:v>0.3</c:v>
                </c:pt>
                <c:pt idx="7">
                  <c:v>0.3</c:v>
                </c:pt>
                <c:pt idx="8">
                  <c:v>0.22</c:v>
                </c:pt>
                <c:pt idx="9">
                  <c:v>0.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293-4FD6-BF4B-4C331953755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487809864"/>
        <c:axId val="487810824"/>
      </c:barChart>
      <c:catAx>
        <c:axId val="487809864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87810824"/>
        <c:crosses val="autoZero"/>
        <c:auto val="1"/>
        <c:lblAlgn val="ctr"/>
        <c:lblOffset val="100"/>
        <c:noMultiLvlLbl val="0"/>
      </c:catAx>
      <c:valAx>
        <c:axId val="487810824"/>
        <c:scaling>
          <c:orientation val="minMax"/>
          <c:max val="1"/>
        </c:scaling>
        <c:delete val="0"/>
        <c:axPos val="t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878098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4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Stomach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4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'[Figure (20190601-20221031).xlsx]★変異が多い遺伝子 (Primary)'!$B$17:$B$19</c:f>
              <c:strCache>
                <c:ptCount val="3"/>
                <c:pt idx="0">
                  <c:v>TP53</c:v>
                </c:pt>
                <c:pt idx="1">
                  <c:v>ERBB2</c:v>
                </c:pt>
                <c:pt idx="2">
                  <c:v>CCNE1</c:v>
                </c:pt>
              </c:strCache>
            </c:strRef>
          </c:cat>
          <c:val>
            <c:numRef>
              <c:f>'[Figure (20190601-20221031).xlsx]★変異が多い遺伝子 (Primary)'!$C$17:$C$19</c:f>
              <c:numCache>
                <c:formatCode>0%</c:formatCode>
                <c:ptCount val="3"/>
                <c:pt idx="0">
                  <c:v>0.7</c:v>
                </c:pt>
                <c:pt idx="1">
                  <c:v>0.28000000000000003</c:v>
                </c:pt>
                <c:pt idx="2">
                  <c:v>0.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A88-49A1-8A31-BE61DEEA09C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554509240"/>
        <c:axId val="554510840"/>
      </c:barChart>
      <c:catAx>
        <c:axId val="554509240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54510840"/>
        <c:crosses val="autoZero"/>
        <c:auto val="1"/>
        <c:lblAlgn val="ctr"/>
        <c:lblOffset val="100"/>
        <c:noMultiLvlLbl val="0"/>
      </c:catAx>
      <c:valAx>
        <c:axId val="554510840"/>
        <c:scaling>
          <c:orientation val="minMax"/>
          <c:max val="1"/>
        </c:scaling>
        <c:delete val="0"/>
        <c:axPos val="t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545092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0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2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3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4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5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6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7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8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9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0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2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2FB0079-ABEB-45CA-9BD4-FB1B46EDFB64}" type="datetimeFigureOut">
              <a:rPr kumimoji="1" lang="ja-JP" altLang="en-US" smtClean="0"/>
              <a:t>2024/4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09575" y="1233488"/>
            <a:ext cx="591661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748163"/>
            <a:ext cx="5388610" cy="388486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3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508510-567B-45FA-922F-940EE87660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09994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Sup-Figure 1.</a:t>
            </a:r>
            <a:r>
              <a:rPr kumimoji="1" lang="ja-JP" altLang="en-US" dirty="0"/>
              <a:t>　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Workflow of genomic profiling test at Keio university hospital and other related facilities</a:t>
            </a:r>
            <a:endParaRPr kumimoji="1" lang="en-US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1F3B2226-482F-4736-9DE9-329B8A0F192D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09662687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Sup-Figure 2.</a:t>
            </a:r>
            <a:r>
              <a:rPr kumimoji="1" lang="ja-JP" altLang="en-US" dirty="0"/>
              <a:t>　</a:t>
            </a:r>
            <a:r>
              <a:rPr kumimoji="1" lang="en-US" altLang="ja-JP" dirty="0"/>
              <a:t>Genomic alteration plots of 547 digestive cancers</a:t>
            </a:r>
          </a:p>
          <a:p>
            <a:endParaRPr kumimoji="1" lang="en-US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D508510-567B-45FA-922F-940EE8766015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734016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Sup-Figure 3.</a:t>
            </a:r>
            <a:r>
              <a:rPr kumimoji="1" lang="ja-JP" altLang="en-US" dirty="0"/>
              <a:t>　</a:t>
            </a:r>
            <a:r>
              <a:rPr kumimoji="1" lang="en-US" altLang="ja-JP" sz="10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</a:t>
            </a:r>
            <a:r>
              <a:rPr lang="en-US" altLang="ja-JP" sz="10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he detection rate of 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ignaling pathway</a:t>
            </a:r>
            <a:r>
              <a:rPr lang="en-US" altLang="ja-JP" sz="1200" dirty="0">
                <a:effectLst/>
                <a:latin typeface="游明朝" panose="02020400000000000000" pitchFamily="18" charset="-128"/>
                <a:cs typeface="Times New Roman" panose="02020603050405020304" pitchFamily="18" charset="0"/>
              </a:rPr>
              <a:t>s with genomic alterations</a:t>
            </a:r>
            <a:r>
              <a:rPr kumimoji="1" lang="ja-JP" altLang="en-US" sz="1200" dirty="0">
                <a:effectLst/>
                <a:latin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effectLst/>
                <a:latin typeface="游明朝" panose="02020400000000000000" pitchFamily="18" charset="-128"/>
                <a:cs typeface="Times New Roman" panose="02020603050405020304" pitchFamily="18" charset="0"/>
              </a:rPr>
              <a:t>in digestive</a:t>
            </a:r>
            <a:r>
              <a:rPr kumimoji="1" lang="ja-JP" altLang="en-US" sz="1200" dirty="0">
                <a:effectLst/>
                <a:latin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effectLst/>
                <a:latin typeface="游明朝" panose="02020400000000000000" pitchFamily="18" charset="-128"/>
                <a:cs typeface="Times New Roman" panose="02020603050405020304" pitchFamily="18" charset="0"/>
              </a:rPr>
              <a:t>cancers</a:t>
            </a:r>
            <a:endParaRPr kumimoji="1" lang="en-US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D508510-567B-45FA-922F-940EE8766015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806654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Sup-Figure 4.</a:t>
            </a:r>
            <a:r>
              <a:rPr kumimoji="1" lang="ja-JP" altLang="en-US" dirty="0"/>
              <a:t>　</a:t>
            </a:r>
            <a:r>
              <a:rPr kumimoji="1" lang="en-US" altLang="ja-JP" sz="12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</a:t>
            </a:r>
            <a:r>
              <a:rPr lang="en-US" altLang="ja-JP" sz="12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he detection rate of </a:t>
            </a:r>
            <a:r>
              <a:rPr kumimoji="1" lang="en-US" altLang="ja-JP" sz="12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g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enomic alterations </a:t>
            </a:r>
            <a:r>
              <a:rPr kumimoji="1" lang="en-US" altLang="ja-JP" sz="1200" dirty="0">
                <a:effectLst/>
                <a:latin typeface="游明朝" panose="02020400000000000000" pitchFamily="18" charset="-128"/>
                <a:cs typeface="Times New Roman" panose="02020603050405020304" pitchFamily="18" charset="0"/>
              </a:rPr>
              <a:t>in digestive</a:t>
            </a:r>
            <a:r>
              <a:rPr kumimoji="1" lang="ja-JP" altLang="en-US" sz="1200" dirty="0">
                <a:effectLst/>
                <a:latin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effectLst/>
                <a:latin typeface="游明朝" panose="02020400000000000000" pitchFamily="18" charset="-128"/>
                <a:cs typeface="Times New Roman" panose="02020603050405020304" pitchFamily="18" charset="0"/>
              </a:rPr>
              <a:t>cancers</a:t>
            </a:r>
            <a:endParaRPr kumimoji="1" lang="en-US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D508510-567B-45FA-922F-940EE8766015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065297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dirty="0"/>
              <a:t>Figure 3.</a:t>
            </a:r>
            <a:r>
              <a:rPr kumimoji="1" lang="ja-JP" altLang="en-US" dirty="0"/>
              <a:t>　</a:t>
            </a:r>
            <a:r>
              <a:rPr kumimoji="1" lang="en-US" altLang="ja-JP" sz="12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</a:t>
            </a:r>
            <a:r>
              <a:rPr lang="en-US" altLang="ja-JP" sz="12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he detection rate of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ignaling pathway</a:t>
            </a:r>
            <a:r>
              <a:rPr lang="en-US" altLang="ja-JP" sz="1800" dirty="0">
                <a:effectLst/>
                <a:latin typeface="游明朝" panose="02020400000000000000" pitchFamily="18" charset="-128"/>
                <a:cs typeface="Times New Roman" panose="02020603050405020304" pitchFamily="18" charset="0"/>
              </a:rPr>
              <a:t>s with genomic alterations</a:t>
            </a:r>
            <a:r>
              <a:rPr kumimoji="1" lang="ja-JP" altLang="en-US" sz="1800" dirty="0">
                <a:effectLst/>
                <a:latin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kumimoji="1" lang="en-US" altLang="ja-JP" sz="1800" dirty="0">
                <a:effectLst/>
                <a:latin typeface="游明朝" panose="02020400000000000000" pitchFamily="18" charset="-128"/>
                <a:cs typeface="Times New Roman" panose="02020603050405020304" pitchFamily="18" charset="0"/>
              </a:rPr>
              <a:t>in digestive</a:t>
            </a:r>
            <a:r>
              <a:rPr kumimoji="1" lang="ja-JP" altLang="en-US" sz="1800" dirty="0">
                <a:effectLst/>
                <a:latin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kumimoji="1" lang="en-US" altLang="ja-JP" sz="1800" dirty="0">
                <a:effectLst/>
                <a:latin typeface="游明朝" panose="02020400000000000000" pitchFamily="18" charset="-128"/>
                <a:cs typeface="Times New Roman" panose="02020603050405020304" pitchFamily="18" charset="0"/>
              </a:rPr>
              <a:t>adenocarcinomas</a:t>
            </a:r>
            <a:endParaRPr kumimoji="1" lang="en-US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D508510-567B-45FA-922F-940EE8766015}" type="slidenum">
              <a:rPr kumimoji="1" lang="ja-JP" altLang="en-US" smtClean="0"/>
              <a:t>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30889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Figure 4.</a:t>
            </a:r>
            <a:r>
              <a:rPr kumimoji="1" lang="ja-JP" altLang="en-US" dirty="0"/>
              <a:t>　</a:t>
            </a:r>
            <a:r>
              <a:rPr kumimoji="1" lang="en-US" altLang="ja-JP" sz="12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</a:t>
            </a:r>
            <a:r>
              <a:rPr lang="en-US" altLang="ja-JP" sz="12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he detection rate of </a:t>
            </a:r>
            <a:r>
              <a:rPr kumimoji="1" lang="en-US" altLang="ja-JP" sz="12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g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enomic alterations </a:t>
            </a:r>
            <a:r>
              <a:rPr kumimoji="1" lang="en-US" altLang="ja-JP" sz="1200" dirty="0">
                <a:effectLst/>
                <a:latin typeface="游明朝" panose="02020400000000000000" pitchFamily="18" charset="-128"/>
                <a:cs typeface="Times New Roman" panose="02020603050405020304" pitchFamily="18" charset="0"/>
              </a:rPr>
              <a:t>in digestive</a:t>
            </a:r>
            <a:r>
              <a:rPr kumimoji="1" lang="ja-JP" altLang="en-US" sz="1200" dirty="0">
                <a:effectLst/>
                <a:latin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effectLst/>
                <a:latin typeface="游明朝" panose="02020400000000000000" pitchFamily="18" charset="-128"/>
                <a:cs typeface="Times New Roman" panose="02020603050405020304" pitchFamily="18" charset="0"/>
              </a:rPr>
              <a:t>adenocarcinomas</a:t>
            </a:r>
            <a:endParaRPr kumimoji="1" lang="en-US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D508510-567B-45FA-922F-940EE8766015}" type="slidenum">
              <a:rPr kumimoji="1" lang="ja-JP" altLang="en-US" smtClean="0"/>
              <a:t>6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8981768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dirty="0"/>
              <a:t>Sup-Figure 6.</a:t>
            </a:r>
            <a:r>
              <a:rPr kumimoji="1" lang="ja-JP" altLang="en-US" dirty="0"/>
              <a:t>　</a:t>
            </a:r>
            <a:r>
              <a:rPr kumimoji="1" lang="en-US" altLang="ja-JP" dirty="0"/>
              <a:t>Breakdown of digestive adenocarcinoma in each gene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D508510-567B-45FA-922F-940EE8766015}" type="slidenum">
              <a:rPr kumimoji="1" lang="ja-JP" altLang="en-US" smtClean="0"/>
              <a:t>7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5956969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dirty="0"/>
              <a:t>Sup-Figure 5.</a:t>
            </a:r>
            <a:r>
              <a:rPr kumimoji="1" lang="ja-JP" altLang="en-US" dirty="0"/>
              <a:t>　</a:t>
            </a:r>
            <a:r>
              <a:rPr kumimoji="1" lang="en-US" altLang="ja-JP" dirty="0"/>
              <a:t>Process of d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iagnostic flow chart of digestive adenocarcinoma</a:t>
            </a:r>
            <a:endParaRPr kumimoji="1" lang="ja-JP" alt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en-US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D508510-567B-45FA-922F-940EE8766015}" type="slidenum">
              <a:rPr kumimoji="1" lang="ja-JP" altLang="en-US" smtClean="0"/>
              <a:t>8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36984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D4AB13C-55F1-4E5A-8601-BE5149BAD1D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91F09331-3CAE-4547-9CF7-0311B899598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5D8D2F8-8C74-4D9F-AACB-C7CEA97825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799CF-3A76-4D7B-BD4A-55306CAC41D3}" type="datetimeFigureOut">
              <a:rPr kumimoji="1" lang="ja-JP" altLang="en-US" smtClean="0"/>
              <a:t>2024/4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3093663-213C-4CA0-B170-2C8566506F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FA6B774-A3DC-4675-86FF-90F97487F5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5F1F0B-E1F6-4B56-98A2-281829F933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19516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E2C546D-79C2-469A-9D01-9D0D9C87A7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5B825C2-2A0D-41A0-9F17-28A6C37DE8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F268A9C-B2B1-4798-96FB-B7D88D6BDA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799CF-3A76-4D7B-BD4A-55306CAC41D3}" type="datetimeFigureOut">
              <a:rPr kumimoji="1" lang="ja-JP" altLang="en-US" smtClean="0"/>
              <a:t>2024/4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3C3AA01-FF8C-4E2C-A883-35266F464A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2D670D2-4BBB-4413-BBC2-5BA874431E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5F1F0B-E1F6-4B56-98A2-281829F933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92133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04C2DBFC-F051-46B6-945E-27A566CFCD5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78CE38A-1E3F-4D21-A6F5-ED77B5A178F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558570A-AE33-4B2D-8F93-01D79F24B5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799CF-3A76-4D7B-BD4A-55306CAC41D3}" type="datetimeFigureOut">
              <a:rPr kumimoji="1" lang="ja-JP" altLang="en-US" smtClean="0"/>
              <a:t>2024/4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26B42B7-4B81-45C7-BFF8-AAEE69C411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9708042-4314-49BA-8D79-DFCC1A6968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5F1F0B-E1F6-4B56-98A2-281829F933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39099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C618EDC-25F8-43E6-8532-A813C7F80A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39D7441-3A4A-4021-AEB2-599D512D64B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2438535-143B-49DD-8D2E-DA9F2266EC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799CF-3A76-4D7B-BD4A-55306CAC41D3}" type="datetimeFigureOut">
              <a:rPr kumimoji="1" lang="ja-JP" altLang="en-US" smtClean="0"/>
              <a:t>2024/4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5E13003-BCAF-4208-99EB-9AF0A9E89A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1252A79-004F-406D-8FC5-BC04510C63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5F1F0B-E1F6-4B56-98A2-281829F933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71814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F2D72A4-8BFA-4365-8D70-090BED2087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A2A75B8-92C1-4D60-B801-7126620204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6B87430-9555-4FE6-BF1F-58C1852B72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799CF-3A76-4D7B-BD4A-55306CAC41D3}" type="datetimeFigureOut">
              <a:rPr kumimoji="1" lang="ja-JP" altLang="en-US" smtClean="0"/>
              <a:t>2024/4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6C0508A-42BF-4056-A4AB-1609E3FA43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6E851D3-E073-4B9B-A035-C03FE0E3C0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5F1F0B-E1F6-4B56-98A2-281829F933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83747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F54CE1D-FB94-440C-9CDC-10571EADE2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FE75983-57CF-4A51-B268-B8114610D99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D931F72-3BBF-4BAA-9018-4DC814A138B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D95807B-0868-4219-ACD9-6B283FA969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799CF-3A76-4D7B-BD4A-55306CAC41D3}" type="datetimeFigureOut">
              <a:rPr kumimoji="1" lang="ja-JP" altLang="en-US" smtClean="0"/>
              <a:t>2024/4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D9C098C-B4C6-4A6E-B2E1-27CB8CB28C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7762503-7DB0-48B5-953A-44182F4989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5F1F0B-E1F6-4B56-98A2-281829F933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64910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D4FACEC-A34E-4742-AFC6-A3095BDFCD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017D237-87BE-45D5-AD11-92DAB978E2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B5F2DE5-60E3-412A-A5EC-5C020E135E1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69FC61AA-9030-4B89-A3CB-22F36F0407A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4D1CA999-079D-4B59-890E-8974B793CDA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5E42FABF-4818-4B47-BE01-B8F83E82AC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799CF-3A76-4D7B-BD4A-55306CAC41D3}" type="datetimeFigureOut">
              <a:rPr kumimoji="1" lang="ja-JP" altLang="en-US" smtClean="0"/>
              <a:t>2024/4/1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C343A2B5-29C8-4786-A320-FF2DA5718E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16270767-E872-40B5-9372-BB6B7004CB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5F1F0B-E1F6-4B56-98A2-281829F933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89732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48CFF3B-2887-43ED-BDC1-FC851189A5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1DBC7AD-15FC-4AC5-B49F-C4273B38EE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799CF-3A76-4D7B-BD4A-55306CAC41D3}" type="datetimeFigureOut">
              <a:rPr kumimoji="1" lang="ja-JP" altLang="en-US" smtClean="0"/>
              <a:t>2024/4/1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F4AB12C0-E009-4365-A306-387EE76BB9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4B52DF3C-FAE2-487F-8684-6075FA00B9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5F1F0B-E1F6-4B56-98A2-281829F933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54643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B76CF997-E293-4B42-8656-F2C478BF00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799CF-3A76-4D7B-BD4A-55306CAC41D3}" type="datetimeFigureOut">
              <a:rPr kumimoji="1" lang="ja-JP" altLang="en-US" smtClean="0"/>
              <a:t>2024/4/1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4C80E8D4-1260-4016-8AD0-0ED3325091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9ABF98C-89CA-4192-B038-58D449795A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5F1F0B-E1F6-4B56-98A2-281829F933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14192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C4A4DC2-0A2B-4197-BE25-6F3A494B0B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75AF2B9-7707-410B-AC19-E3F17493320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3EDCE23-EA67-47A7-99D5-DC3D30816B7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8E7482F-3C16-4454-8E20-CFD407F87C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799CF-3A76-4D7B-BD4A-55306CAC41D3}" type="datetimeFigureOut">
              <a:rPr kumimoji="1" lang="ja-JP" altLang="en-US" smtClean="0"/>
              <a:t>2024/4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D700644-1D24-4B66-A573-922764B338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C1084E6-E0FF-4B51-923E-03B6C68443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5F1F0B-E1F6-4B56-98A2-281829F933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87197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0A40462-53B1-422F-819F-0B302B5144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5DFA2291-8898-42BA-834C-DF0ADCD4166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AA63AEE-6CFA-4AF4-8B17-9BE76D05807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3EEB9D8-1D9E-4F85-A390-E85DB799DA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799CF-3A76-4D7B-BD4A-55306CAC41D3}" type="datetimeFigureOut">
              <a:rPr kumimoji="1" lang="ja-JP" altLang="en-US" smtClean="0"/>
              <a:t>2024/4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643FC2C-9A55-4581-85BE-5305B86AAD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4278293-3573-40B9-BEEA-079D5FE5AC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5F1F0B-E1F6-4B56-98A2-281829F933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27269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73215035-AA91-4993-8C5C-ACD73347D7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F921056-B80B-493A-8434-27C7B4A889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4D5E32A-E100-4B44-97F9-59C24F1977D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9799CF-3A76-4D7B-BD4A-55306CAC41D3}" type="datetimeFigureOut">
              <a:rPr kumimoji="1" lang="ja-JP" altLang="en-US" smtClean="0"/>
              <a:t>2024/4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C15AF0F-B097-4BE5-8CB3-6A5C65CA238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AF24903-9958-44F0-9DC6-4ECA838E62C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5F1F0B-E1F6-4B56-98A2-281829F933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24063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1.xml"/><Relationship Id="rId5" Type="http://schemas.openxmlformats.org/officeDocument/2006/relationships/image" Target="../media/image2.png"/><Relationship Id="rId4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Relationship Id="rId9" Type="http://schemas.openxmlformats.org/officeDocument/2006/relationships/chart" Target="../charts/char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3.xml"/><Relationship Id="rId3" Type="http://schemas.openxmlformats.org/officeDocument/2006/relationships/chart" Target="../charts/chart8.xml"/><Relationship Id="rId7" Type="http://schemas.openxmlformats.org/officeDocument/2006/relationships/chart" Target="../charts/chart12.xml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11.xml"/><Relationship Id="rId5" Type="http://schemas.openxmlformats.org/officeDocument/2006/relationships/chart" Target="../charts/chart10.xml"/><Relationship Id="rId4" Type="http://schemas.openxmlformats.org/officeDocument/2006/relationships/chart" Target="../charts/chart9.xml"/><Relationship Id="rId9" Type="http://schemas.openxmlformats.org/officeDocument/2006/relationships/chart" Target="../charts/chart14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chart" Target="../charts/chart20.xml"/><Relationship Id="rId3" Type="http://schemas.openxmlformats.org/officeDocument/2006/relationships/chart" Target="../charts/chart15.xml"/><Relationship Id="rId7" Type="http://schemas.openxmlformats.org/officeDocument/2006/relationships/chart" Target="../charts/chart19.xml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8.xml"/><Relationship Id="rId5" Type="http://schemas.openxmlformats.org/officeDocument/2006/relationships/chart" Target="../charts/chart17.xml"/><Relationship Id="rId4" Type="http://schemas.openxmlformats.org/officeDocument/2006/relationships/chart" Target="../charts/chart16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chart" Target="../charts/chart26.xml"/><Relationship Id="rId3" Type="http://schemas.openxmlformats.org/officeDocument/2006/relationships/chart" Target="../charts/chart21.xml"/><Relationship Id="rId7" Type="http://schemas.openxmlformats.org/officeDocument/2006/relationships/chart" Target="../charts/chart25.xml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24.xml"/><Relationship Id="rId5" Type="http://schemas.openxmlformats.org/officeDocument/2006/relationships/chart" Target="../charts/chart23.xml"/><Relationship Id="rId4" Type="http://schemas.openxmlformats.org/officeDocument/2006/relationships/chart" Target="../charts/chart22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chart" Target="../charts/chart32.xml"/><Relationship Id="rId3" Type="http://schemas.openxmlformats.org/officeDocument/2006/relationships/chart" Target="../charts/chart27.xml"/><Relationship Id="rId7" Type="http://schemas.openxmlformats.org/officeDocument/2006/relationships/chart" Target="../charts/chart31.xml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30.xml"/><Relationship Id="rId5" Type="http://schemas.openxmlformats.org/officeDocument/2006/relationships/chart" Target="../charts/chart29.xml"/><Relationship Id="rId4" Type="http://schemas.openxmlformats.org/officeDocument/2006/relationships/chart" Target="../charts/chart28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メモ 10"/>
          <p:cNvSpPr/>
          <p:nvPr/>
        </p:nvSpPr>
        <p:spPr>
          <a:xfrm>
            <a:off x="3687415" y="3817557"/>
            <a:ext cx="744543" cy="495377"/>
          </a:xfrm>
          <a:prstGeom prst="foldedCorner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 anchor="ctr"/>
          <a:lstStyle/>
          <a:p>
            <a:pPr algn="ctr">
              <a:defRPr/>
            </a:pP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rPr>
              <a:t>Analysis</a:t>
            </a:r>
          </a:p>
          <a:p>
            <a:pPr algn="ctr">
              <a:defRPr/>
            </a:pP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rPr>
              <a:t>report</a:t>
            </a:r>
            <a:endParaRPr lang="ja-JP" altLang="en-US" sz="1200" dirty="0">
              <a:solidFill>
                <a:prstClr val="black"/>
              </a:solidFill>
              <a:latin typeface="Arial" panose="020B0604020202020204" pitchFamily="34" charset="0"/>
              <a:ea typeface="HG丸ｺﾞｼｯｸM-PRO" panose="020F06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2" name="メモ 11"/>
          <p:cNvSpPr/>
          <p:nvPr/>
        </p:nvSpPr>
        <p:spPr>
          <a:xfrm>
            <a:off x="3624054" y="4544452"/>
            <a:ext cx="870261" cy="529546"/>
          </a:xfrm>
          <a:prstGeom prst="foldedCorner">
            <a:avLst/>
          </a:prstGeom>
          <a:noFill/>
          <a:ln w="12700">
            <a:solidFill>
              <a:schemeClr val="tx1"/>
            </a:solidFill>
          </a:ln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wrap="none" rtlCol="0" anchor="ctr"/>
          <a:lstStyle/>
          <a:p>
            <a:pPr algn="ctr">
              <a:defRPr/>
            </a:pP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rPr>
              <a:t>Curation </a:t>
            </a:r>
          </a:p>
          <a:p>
            <a:pPr algn="ctr">
              <a:defRPr/>
            </a:pP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rPr>
              <a:t>sheet</a:t>
            </a:r>
            <a:endParaRPr lang="ja-JP" altLang="en-US" sz="1200" dirty="0">
              <a:solidFill>
                <a:prstClr val="black"/>
              </a:solidFill>
              <a:latin typeface="Arial" panose="020B0604020202020204" pitchFamily="34" charset="0"/>
              <a:ea typeface="HG丸ｺﾞｼｯｸM-PRO" panose="020F06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3" name="メモ 12"/>
          <p:cNvSpPr/>
          <p:nvPr/>
        </p:nvSpPr>
        <p:spPr>
          <a:xfrm>
            <a:off x="3624054" y="5104163"/>
            <a:ext cx="870261" cy="529546"/>
          </a:xfrm>
          <a:prstGeom prst="foldedCorner">
            <a:avLst/>
          </a:prstGeom>
          <a:noFill/>
          <a:ln w="12700">
            <a:solidFill>
              <a:schemeClr val="tx1"/>
            </a:solidFill>
          </a:ln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wrap="none" rtlCol="0" anchor="ctr"/>
          <a:lstStyle/>
          <a:p>
            <a:pPr algn="ctr">
              <a:defRPr/>
            </a:pP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rPr>
              <a:t>Conference</a:t>
            </a:r>
          </a:p>
          <a:p>
            <a:pPr algn="ctr">
              <a:defRPr/>
            </a:pP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rPr>
              <a:t>sheet</a:t>
            </a:r>
          </a:p>
        </p:txBody>
      </p:sp>
      <p:sp>
        <p:nvSpPr>
          <p:cNvPr id="17" name="メモ 16"/>
          <p:cNvSpPr/>
          <p:nvPr/>
        </p:nvSpPr>
        <p:spPr>
          <a:xfrm>
            <a:off x="7216084" y="5104163"/>
            <a:ext cx="870261" cy="529546"/>
          </a:xfrm>
          <a:prstGeom prst="foldedCorner">
            <a:avLst/>
          </a:prstGeom>
          <a:noFill/>
          <a:ln w="12700">
            <a:solidFill>
              <a:schemeClr val="tx1"/>
            </a:solidFill>
          </a:ln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wrap="none" rtlCol="0" anchor="ctr"/>
          <a:lstStyle/>
          <a:p>
            <a:pPr algn="ctr">
              <a:defRPr/>
            </a:pP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rPr>
              <a:t>Drug</a:t>
            </a:r>
          </a:p>
          <a:p>
            <a:pPr algn="ctr">
              <a:defRPr/>
            </a:pP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rPr>
              <a:t>information</a:t>
            </a: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4741691" y="4697597"/>
            <a:ext cx="232952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  <a:defRPr/>
            </a:pP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rPr>
              <a:t>Review of genomic alterations</a:t>
            </a:r>
          </a:p>
          <a:p>
            <a:pPr marL="285750" indent="-285750">
              <a:buFont typeface="Arial" panose="020B0604020202020204" pitchFamily="34" charset="0"/>
              <a:buChar char="•"/>
              <a:defRPr/>
            </a:pP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rPr>
              <a:t>Determination of potentially actionable and actionable genomic alterations </a:t>
            </a:r>
          </a:p>
          <a:p>
            <a:pPr marL="285750" indent="-285750">
              <a:buFont typeface="Arial" panose="020B0604020202020204" pitchFamily="34" charset="0"/>
              <a:buChar char="•"/>
              <a:defRPr/>
            </a:pP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rPr>
              <a:t>Determination of germline variants</a:t>
            </a: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8091566" y="4705835"/>
            <a:ext cx="248415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  <a:defRPr/>
            </a:pP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rPr>
              <a:t>Merging C-CAT report</a:t>
            </a:r>
          </a:p>
          <a:p>
            <a:pPr marL="285750" indent="-285750">
              <a:buFont typeface="Arial" panose="020B0604020202020204" pitchFamily="34" charset="0"/>
              <a:buChar char="•"/>
              <a:defRPr/>
            </a:pP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rPr>
              <a:t>Review of treatment evidence</a:t>
            </a:r>
          </a:p>
          <a:p>
            <a:pPr marL="285750" indent="-285750">
              <a:buFont typeface="Arial" panose="020B0604020202020204" pitchFamily="34" charset="0"/>
              <a:buChar char="•"/>
              <a:defRPr/>
            </a:pP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rPr>
              <a:t>Determination of actionable genomic alterations </a:t>
            </a:r>
          </a:p>
          <a:p>
            <a:pPr marL="285750" indent="-285750">
              <a:buFont typeface="Arial" panose="020B0604020202020204" pitchFamily="34" charset="0"/>
              <a:buChar char="•"/>
              <a:defRPr/>
            </a:pP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rPr>
              <a:t>Recommend genomic based treatment</a:t>
            </a:r>
            <a:endParaRPr lang="ja-JP" altLang="en-US" sz="1200" dirty="0">
              <a:solidFill>
                <a:prstClr val="black"/>
              </a:solidFill>
              <a:latin typeface="Arial" panose="020B0604020202020204" pitchFamily="34" charset="0"/>
              <a:ea typeface="HG丸ｺﾞｼｯｸM-PRO" panose="020F06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6" name="右矢印 45"/>
          <p:cNvSpPr/>
          <p:nvPr/>
        </p:nvSpPr>
        <p:spPr>
          <a:xfrm>
            <a:off x="6656716" y="4151860"/>
            <a:ext cx="1476570" cy="447353"/>
          </a:xfrm>
          <a:prstGeom prst="rightArrow">
            <a:avLst/>
          </a:prstGeom>
          <a:solidFill>
            <a:srgbClr val="FFC000"/>
          </a:solidFill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>
              <a:defRPr/>
            </a:pPr>
            <a:endParaRPr lang="ja-JP" altLang="en-US" sz="1200">
              <a:solidFill>
                <a:prstClr val="black"/>
              </a:solidFill>
              <a:latin typeface="Arial" panose="020B0604020202020204" pitchFamily="34" charset="0"/>
              <a:ea typeface="HG丸ｺﾞｼｯｸM-PRO" panose="020F06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8" name="右矢印 47"/>
          <p:cNvSpPr/>
          <p:nvPr/>
        </p:nvSpPr>
        <p:spPr>
          <a:xfrm>
            <a:off x="9800301" y="4150428"/>
            <a:ext cx="269495" cy="447353"/>
          </a:xfrm>
          <a:prstGeom prst="rightArrow">
            <a:avLst/>
          </a:prstGeom>
          <a:solidFill>
            <a:srgbClr val="FFC000"/>
          </a:solidFill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>
              <a:defRPr/>
            </a:pPr>
            <a:endParaRPr lang="ja-JP" altLang="en-US" sz="1600">
              <a:solidFill>
                <a:prstClr val="black"/>
              </a:solidFill>
              <a:latin typeface="Arial" panose="020B0604020202020204" pitchFamily="34" charset="0"/>
              <a:ea typeface="HG丸ｺﾞｼｯｸM-PRO" panose="020F06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9" name="円柱 48"/>
          <p:cNvSpPr/>
          <p:nvPr/>
        </p:nvSpPr>
        <p:spPr>
          <a:xfrm>
            <a:off x="3600312" y="2848753"/>
            <a:ext cx="911174" cy="566995"/>
          </a:xfrm>
          <a:prstGeom prst="can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 anchor="ctr"/>
          <a:lstStyle/>
          <a:p>
            <a:pPr algn="ctr">
              <a:defRPr/>
            </a:pPr>
            <a:r>
              <a:rPr lang="en-US" altLang="ja-JP" sz="1600" dirty="0">
                <a:solidFill>
                  <a:prstClr val="black"/>
                </a:solidFill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rPr>
              <a:t>C-CAT</a:t>
            </a: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8199579" y="4050611"/>
            <a:ext cx="1515980" cy="646986"/>
          </a:xfrm>
          <a:prstGeom prst="roundRect">
            <a:avLst/>
          </a:prstGeom>
          <a:solidFill>
            <a:schemeClr val="accent5">
              <a:lumMod val="20000"/>
              <a:lumOff val="80000"/>
            </a:schemeClr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>
              <a:defRPr/>
            </a:pPr>
            <a:r>
              <a:rPr lang="en-US" altLang="ja-JP" sz="1600" dirty="0">
                <a:solidFill>
                  <a:prstClr val="black"/>
                </a:solidFill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rPr>
              <a:t>CTB (Clinical</a:t>
            </a:r>
          </a:p>
          <a:p>
            <a:pPr algn="ctr">
              <a:defRPr/>
            </a:pPr>
            <a:r>
              <a:rPr lang="en-US" altLang="ja-JP" sz="1600" dirty="0">
                <a:solidFill>
                  <a:prstClr val="black"/>
                </a:solidFill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rPr>
              <a:t>Tumor Board)</a:t>
            </a:r>
            <a:endParaRPr lang="ja-JP" altLang="en-US" sz="1600" dirty="0">
              <a:solidFill>
                <a:prstClr val="black"/>
              </a:solidFill>
              <a:latin typeface="Arial" panose="020B0604020202020204" pitchFamily="34" charset="0"/>
              <a:ea typeface="HG丸ｺﾞｼｯｸM-PRO" panose="020F06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3475346" y="6133375"/>
            <a:ext cx="1156817" cy="476071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>
              <a:defRPr/>
            </a:pPr>
            <a:r>
              <a:rPr lang="en-US" altLang="ja-JP" sz="1600" dirty="0">
                <a:solidFill>
                  <a:prstClr val="black"/>
                </a:solidFill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rPr>
              <a:t>MESW</a:t>
            </a:r>
            <a:endParaRPr lang="ja-JP" altLang="en-US" sz="1600" dirty="0">
              <a:solidFill>
                <a:prstClr val="black"/>
              </a:solidFill>
              <a:latin typeface="Arial" panose="020B0604020202020204" pitchFamily="34" charset="0"/>
              <a:ea typeface="HG丸ｺﾞｼｯｸM-PRO" panose="020F06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4826235" y="4041430"/>
            <a:ext cx="1745738" cy="646986"/>
          </a:xfrm>
          <a:prstGeom prst="roundRect">
            <a:avLst/>
          </a:prstGeom>
          <a:solidFill>
            <a:schemeClr val="accent6">
              <a:lumMod val="20000"/>
              <a:lumOff val="80000"/>
            </a:schemeClr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>
              <a:defRPr/>
            </a:pPr>
            <a:r>
              <a:rPr lang="en-US" altLang="ja-JP" sz="1600" dirty="0">
                <a:solidFill>
                  <a:prstClr val="black"/>
                </a:solidFill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rPr>
              <a:t>MTB (Molecular</a:t>
            </a:r>
          </a:p>
          <a:p>
            <a:pPr algn="ctr">
              <a:defRPr/>
            </a:pPr>
            <a:r>
              <a:rPr lang="en-US" altLang="ja-JP" sz="1600" dirty="0">
                <a:solidFill>
                  <a:prstClr val="black"/>
                </a:solidFill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rPr>
              <a:t>Tumor Board)</a:t>
            </a:r>
            <a:endParaRPr lang="ja-JP" altLang="en-US" sz="1600" dirty="0">
              <a:solidFill>
                <a:prstClr val="black"/>
              </a:solidFill>
              <a:latin typeface="Arial" panose="020B0604020202020204" pitchFamily="34" charset="0"/>
              <a:ea typeface="HG丸ｺﾞｼｯｸM-PRO" panose="020F06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10137859" y="4041430"/>
            <a:ext cx="1777203" cy="646986"/>
          </a:xfrm>
          <a:prstGeom prst="roundRect">
            <a:avLst/>
          </a:prstGeom>
          <a:solidFill>
            <a:schemeClr val="accent4">
              <a:lumMod val="20000"/>
              <a:lumOff val="80000"/>
            </a:schemeClr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>
              <a:defRPr/>
            </a:pPr>
            <a:r>
              <a:rPr lang="en-US" altLang="ja-JP" sz="1600" dirty="0">
                <a:solidFill>
                  <a:prstClr val="black"/>
                </a:solidFill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rPr>
              <a:t>CGB (Cancer</a:t>
            </a:r>
          </a:p>
          <a:p>
            <a:pPr algn="ctr">
              <a:defRPr/>
            </a:pPr>
            <a:r>
              <a:rPr lang="en-US" altLang="ja-JP" sz="1600" dirty="0">
                <a:solidFill>
                  <a:prstClr val="black"/>
                </a:solidFill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rPr>
              <a:t>Genomic Board)</a:t>
            </a:r>
            <a:endParaRPr lang="ja-JP" altLang="en-US" sz="1600" dirty="0">
              <a:solidFill>
                <a:prstClr val="black"/>
              </a:solidFill>
              <a:latin typeface="Arial" panose="020B0604020202020204" pitchFamily="34" charset="0"/>
              <a:ea typeface="HG丸ｺﾞｼｯｸM-PRO" panose="020F06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C7F7994C-0BDD-4F04-BCEA-DCC19E1A2B25}"/>
              </a:ext>
            </a:extLst>
          </p:cNvPr>
          <p:cNvSpPr txBox="1"/>
          <p:nvPr/>
        </p:nvSpPr>
        <p:spPr>
          <a:xfrm>
            <a:off x="8313144" y="6161744"/>
            <a:ext cx="388271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altLang="ja-JP" sz="1000" dirty="0"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rPr>
              <a:t>C-CAT: Center for Cancer Genomics and Advanced Therapeutics</a:t>
            </a:r>
          </a:p>
          <a:p>
            <a:pPr>
              <a:defRPr/>
            </a:pPr>
            <a:r>
              <a:rPr lang="en-US" altLang="ja-JP" sz="1000" dirty="0"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rPr>
              <a:t>MESW: Mitsubishi Electric Software Corporation</a:t>
            </a: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6C3276E6-93E9-48F8-8BA9-6F044F6841B9}"/>
              </a:ext>
            </a:extLst>
          </p:cNvPr>
          <p:cNvSpPr txBox="1"/>
          <p:nvPr/>
        </p:nvSpPr>
        <p:spPr>
          <a:xfrm>
            <a:off x="7069588" y="6133375"/>
            <a:ext cx="1156817" cy="476071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>
              <a:defRPr/>
            </a:pPr>
            <a:r>
              <a:rPr lang="en-US" altLang="ja-JP" sz="1600" dirty="0">
                <a:solidFill>
                  <a:prstClr val="black"/>
                </a:solidFill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rPr>
              <a:t>MESW</a:t>
            </a:r>
            <a:endParaRPr lang="ja-JP" altLang="en-US" sz="1600" dirty="0">
              <a:solidFill>
                <a:prstClr val="black"/>
              </a:solidFill>
              <a:latin typeface="Arial" panose="020B0604020202020204" pitchFamily="34" charset="0"/>
              <a:ea typeface="HG丸ｺﾞｼｯｸM-PRO" panose="020F0600000000000000" pitchFamily="50" charset="-128"/>
              <a:cs typeface="Arial" panose="020B0604020202020204" pitchFamily="34" charset="0"/>
            </a:endParaRPr>
          </a:p>
        </p:txBody>
      </p:sp>
      <p:cxnSp>
        <p:nvCxnSpPr>
          <p:cNvPr id="5" name="直線矢印コネクタ 4">
            <a:extLst>
              <a:ext uri="{FF2B5EF4-FFF2-40B4-BE49-F238E27FC236}">
                <a16:creationId xmlns:a16="http://schemas.microsoft.com/office/drawing/2014/main" id="{A41ADD3F-48C4-436D-8F1E-4BB22E3E9811}"/>
              </a:ext>
            </a:extLst>
          </p:cNvPr>
          <p:cNvCxnSpPr>
            <a:stCxn id="49" idx="3"/>
            <a:endCxn id="11" idx="0"/>
          </p:cNvCxnSpPr>
          <p:nvPr/>
        </p:nvCxnSpPr>
        <p:spPr>
          <a:xfrm>
            <a:off x="4055899" y="3415748"/>
            <a:ext cx="3788" cy="401809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線矢印コネクタ 36">
            <a:extLst>
              <a:ext uri="{FF2B5EF4-FFF2-40B4-BE49-F238E27FC236}">
                <a16:creationId xmlns:a16="http://schemas.microsoft.com/office/drawing/2014/main" id="{C2AED033-D2B7-4739-B3B1-E8F20D01B7D1}"/>
              </a:ext>
            </a:extLst>
          </p:cNvPr>
          <p:cNvCxnSpPr>
            <a:cxnSpLocks/>
            <a:stCxn id="7" idx="0"/>
            <a:endCxn id="13" idx="2"/>
          </p:cNvCxnSpPr>
          <p:nvPr/>
        </p:nvCxnSpPr>
        <p:spPr>
          <a:xfrm flipV="1">
            <a:off x="4053755" y="5633709"/>
            <a:ext cx="5430" cy="49966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線矢印コネクタ 37">
            <a:extLst>
              <a:ext uri="{FF2B5EF4-FFF2-40B4-BE49-F238E27FC236}">
                <a16:creationId xmlns:a16="http://schemas.microsoft.com/office/drawing/2014/main" id="{245DAAA0-073A-40FB-B72A-B666954B4442}"/>
              </a:ext>
            </a:extLst>
          </p:cNvPr>
          <p:cNvCxnSpPr>
            <a:cxnSpLocks/>
            <a:stCxn id="58" idx="0"/>
            <a:endCxn id="17" idx="2"/>
          </p:cNvCxnSpPr>
          <p:nvPr/>
        </p:nvCxnSpPr>
        <p:spPr>
          <a:xfrm flipV="1">
            <a:off x="7647997" y="5633709"/>
            <a:ext cx="3218" cy="49966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右矢印 47">
            <a:extLst>
              <a:ext uri="{FF2B5EF4-FFF2-40B4-BE49-F238E27FC236}">
                <a16:creationId xmlns:a16="http://schemas.microsoft.com/office/drawing/2014/main" id="{0B2421CB-1B87-4B3C-9B4E-C5E972D09DB5}"/>
              </a:ext>
            </a:extLst>
          </p:cNvPr>
          <p:cNvSpPr/>
          <p:nvPr/>
        </p:nvSpPr>
        <p:spPr>
          <a:xfrm rot="16200000">
            <a:off x="7384646" y="4574563"/>
            <a:ext cx="529544" cy="447353"/>
          </a:xfrm>
          <a:prstGeom prst="rightArrow">
            <a:avLst/>
          </a:prstGeom>
          <a:solidFill>
            <a:srgbClr val="FFC000"/>
          </a:solidFill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>
              <a:defRPr/>
            </a:pPr>
            <a:endParaRPr lang="ja-JP" altLang="en-US" sz="1600">
              <a:solidFill>
                <a:prstClr val="black"/>
              </a:solidFill>
              <a:latin typeface="Arial" panose="020B0604020202020204" pitchFamily="34" charset="0"/>
              <a:ea typeface="HG丸ｺﾞｼｯｸM-PRO" panose="020F06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1" name="右矢印 47">
            <a:extLst>
              <a:ext uri="{FF2B5EF4-FFF2-40B4-BE49-F238E27FC236}">
                <a16:creationId xmlns:a16="http://schemas.microsoft.com/office/drawing/2014/main" id="{B666869B-A67F-4D30-8AB1-E78FAEB624F1}"/>
              </a:ext>
            </a:extLst>
          </p:cNvPr>
          <p:cNvSpPr/>
          <p:nvPr/>
        </p:nvSpPr>
        <p:spPr>
          <a:xfrm>
            <a:off x="4544921" y="4141246"/>
            <a:ext cx="221047" cy="447353"/>
          </a:xfrm>
          <a:prstGeom prst="rightArrow">
            <a:avLst/>
          </a:prstGeom>
          <a:solidFill>
            <a:srgbClr val="FFC000"/>
          </a:solidFill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>
              <a:defRPr/>
            </a:pPr>
            <a:endParaRPr lang="ja-JP" altLang="en-US" sz="1600">
              <a:solidFill>
                <a:prstClr val="black"/>
              </a:solidFill>
              <a:latin typeface="Arial" panose="020B0604020202020204" pitchFamily="34" charset="0"/>
              <a:ea typeface="HG丸ｺﾞｼｯｸM-PRO" panose="020F06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DDF714F3-FCA5-438A-8587-F5AE831F9BA0}"/>
              </a:ext>
            </a:extLst>
          </p:cNvPr>
          <p:cNvSpPr/>
          <p:nvPr/>
        </p:nvSpPr>
        <p:spPr>
          <a:xfrm>
            <a:off x="5173114" y="3646459"/>
            <a:ext cx="1074170" cy="338554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ration</a:t>
            </a:r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正方形/長方形 41">
            <a:extLst>
              <a:ext uri="{FF2B5EF4-FFF2-40B4-BE49-F238E27FC236}">
                <a16:creationId xmlns:a16="http://schemas.microsoft.com/office/drawing/2014/main" id="{4B9B495A-F3D4-4B65-AAED-45FABE338FAF}"/>
              </a:ext>
            </a:extLst>
          </p:cNvPr>
          <p:cNvSpPr/>
          <p:nvPr/>
        </p:nvSpPr>
        <p:spPr>
          <a:xfrm>
            <a:off x="10375121" y="3647600"/>
            <a:ext cx="1288210" cy="338554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scussion</a:t>
            </a:r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正方形/長方形 43">
            <a:extLst>
              <a:ext uri="{FF2B5EF4-FFF2-40B4-BE49-F238E27FC236}">
                <a16:creationId xmlns:a16="http://schemas.microsoft.com/office/drawing/2014/main" id="{CBA1883B-3516-4531-BB35-C8887DE3FACE}"/>
              </a:ext>
            </a:extLst>
          </p:cNvPr>
          <p:cNvSpPr/>
          <p:nvPr/>
        </p:nvSpPr>
        <p:spPr>
          <a:xfrm>
            <a:off x="8313144" y="3655984"/>
            <a:ext cx="1288848" cy="338554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notation</a:t>
            </a:r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矢印: 折線 17">
            <a:extLst>
              <a:ext uri="{FF2B5EF4-FFF2-40B4-BE49-F238E27FC236}">
                <a16:creationId xmlns:a16="http://schemas.microsoft.com/office/drawing/2014/main" id="{E21DCAB7-D704-4915-816C-7EA9D971447D}"/>
              </a:ext>
            </a:extLst>
          </p:cNvPr>
          <p:cNvSpPr/>
          <p:nvPr/>
        </p:nvSpPr>
        <p:spPr>
          <a:xfrm flipV="1">
            <a:off x="5667574" y="6133375"/>
            <a:ext cx="1342398" cy="367274"/>
          </a:xfrm>
          <a:prstGeom prst="bentArrow">
            <a:avLst>
              <a:gd name="adj1" fmla="val 19034"/>
              <a:gd name="adj2" fmla="val 25577"/>
              <a:gd name="adj3" fmla="val 25000"/>
              <a:gd name="adj4" fmla="val 43750"/>
            </a:avLst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pic>
        <p:nvPicPr>
          <p:cNvPr id="62" name="図 61">
            <a:extLst>
              <a:ext uri="{FF2B5EF4-FFF2-40B4-BE49-F238E27FC236}">
                <a16:creationId xmlns:a16="http://schemas.microsoft.com/office/drawing/2014/main" id="{D7DCA5E4-7B43-4492-B98F-7D507B585ABD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2820" y="2318345"/>
            <a:ext cx="249181" cy="343424"/>
          </a:xfrm>
          <a:prstGeom prst="rect">
            <a:avLst/>
          </a:prstGeom>
        </p:spPr>
      </p:pic>
      <p:grpSp>
        <p:nvGrpSpPr>
          <p:cNvPr id="63" name="グループ化 62">
            <a:extLst>
              <a:ext uri="{FF2B5EF4-FFF2-40B4-BE49-F238E27FC236}">
                <a16:creationId xmlns:a16="http://schemas.microsoft.com/office/drawing/2014/main" id="{4E40880F-608E-4956-9868-53A1C80F52BC}"/>
              </a:ext>
            </a:extLst>
          </p:cNvPr>
          <p:cNvGrpSpPr/>
          <p:nvPr/>
        </p:nvGrpSpPr>
        <p:grpSpPr>
          <a:xfrm>
            <a:off x="921887" y="2332933"/>
            <a:ext cx="326250" cy="354562"/>
            <a:chOff x="4149217" y="1059543"/>
            <a:chExt cx="524868" cy="528550"/>
          </a:xfrm>
        </p:grpSpPr>
        <p:sp>
          <p:nvSpPr>
            <p:cNvPr id="64" name="直方体 63">
              <a:extLst>
                <a:ext uri="{FF2B5EF4-FFF2-40B4-BE49-F238E27FC236}">
                  <a16:creationId xmlns:a16="http://schemas.microsoft.com/office/drawing/2014/main" id="{25734779-6F56-4D6C-81FB-4D943D178D6C}"/>
                </a:ext>
              </a:extLst>
            </p:cNvPr>
            <p:cNvSpPr/>
            <p:nvPr/>
          </p:nvSpPr>
          <p:spPr>
            <a:xfrm>
              <a:off x="4149217" y="1320163"/>
              <a:ext cx="519400" cy="267930"/>
            </a:xfrm>
            <a:prstGeom prst="cube">
              <a:avLst>
                <a:gd name="adj" fmla="val 92488"/>
              </a:avLst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endParaRPr lang="ja-JP" altLang="en-US" sz="2000">
                <a:solidFill>
                  <a:prstClr val="black"/>
                </a:solidFill>
                <a:latin typeface="Calibri"/>
                <a:ea typeface="ＭＳ Ｐゴシック" panose="020B0600070205080204" pitchFamily="50" charset="-128"/>
              </a:endParaRPr>
            </a:p>
          </p:txBody>
        </p:sp>
        <p:sp>
          <p:nvSpPr>
            <p:cNvPr id="65" name="直方体 64">
              <a:extLst>
                <a:ext uri="{FF2B5EF4-FFF2-40B4-BE49-F238E27FC236}">
                  <a16:creationId xmlns:a16="http://schemas.microsoft.com/office/drawing/2014/main" id="{D6E11CCE-2AF3-4E35-AC11-2D5E4ECF512A}"/>
                </a:ext>
              </a:extLst>
            </p:cNvPr>
            <p:cNvSpPr/>
            <p:nvPr/>
          </p:nvSpPr>
          <p:spPr>
            <a:xfrm>
              <a:off x="4150584" y="1255008"/>
              <a:ext cx="519400" cy="267930"/>
            </a:xfrm>
            <a:prstGeom prst="cube">
              <a:avLst>
                <a:gd name="adj" fmla="val 92488"/>
              </a:avLst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endParaRPr lang="ja-JP" altLang="en-US" sz="2000">
                <a:solidFill>
                  <a:prstClr val="black"/>
                </a:solidFill>
                <a:latin typeface="Calibri"/>
                <a:ea typeface="ＭＳ Ｐゴシック" panose="020B0600070205080204" pitchFamily="50" charset="-128"/>
              </a:endParaRPr>
            </a:p>
          </p:txBody>
        </p:sp>
        <p:sp>
          <p:nvSpPr>
            <p:cNvPr id="66" name="直方体 65">
              <a:extLst>
                <a:ext uri="{FF2B5EF4-FFF2-40B4-BE49-F238E27FC236}">
                  <a16:creationId xmlns:a16="http://schemas.microsoft.com/office/drawing/2014/main" id="{F200C6A2-14A4-44E7-A4C9-42DC288534DE}"/>
                </a:ext>
              </a:extLst>
            </p:cNvPr>
            <p:cNvSpPr/>
            <p:nvPr/>
          </p:nvSpPr>
          <p:spPr>
            <a:xfrm>
              <a:off x="4151951" y="1189853"/>
              <a:ext cx="519400" cy="267930"/>
            </a:xfrm>
            <a:prstGeom prst="cube">
              <a:avLst>
                <a:gd name="adj" fmla="val 92488"/>
              </a:avLst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endParaRPr lang="ja-JP" altLang="en-US" sz="2000">
                <a:solidFill>
                  <a:prstClr val="black"/>
                </a:solidFill>
                <a:latin typeface="Calibri"/>
                <a:ea typeface="ＭＳ Ｐゴシック" panose="020B0600070205080204" pitchFamily="50" charset="-128"/>
              </a:endParaRPr>
            </a:p>
          </p:txBody>
        </p:sp>
        <p:sp>
          <p:nvSpPr>
            <p:cNvPr id="67" name="直方体 66">
              <a:extLst>
                <a:ext uri="{FF2B5EF4-FFF2-40B4-BE49-F238E27FC236}">
                  <a16:creationId xmlns:a16="http://schemas.microsoft.com/office/drawing/2014/main" id="{10F22EFB-1560-42F0-87DB-1913C503FB1C}"/>
                </a:ext>
              </a:extLst>
            </p:cNvPr>
            <p:cNvSpPr/>
            <p:nvPr/>
          </p:nvSpPr>
          <p:spPr>
            <a:xfrm>
              <a:off x="4153318" y="1124698"/>
              <a:ext cx="519400" cy="267930"/>
            </a:xfrm>
            <a:prstGeom prst="cube">
              <a:avLst>
                <a:gd name="adj" fmla="val 92488"/>
              </a:avLst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endParaRPr lang="ja-JP" altLang="en-US" sz="2000">
                <a:solidFill>
                  <a:prstClr val="black"/>
                </a:solidFill>
                <a:latin typeface="Calibri"/>
                <a:ea typeface="ＭＳ Ｐゴシック" panose="020B0600070205080204" pitchFamily="50" charset="-128"/>
              </a:endParaRPr>
            </a:p>
          </p:txBody>
        </p:sp>
        <p:sp>
          <p:nvSpPr>
            <p:cNvPr id="68" name="直方体 67">
              <a:extLst>
                <a:ext uri="{FF2B5EF4-FFF2-40B4-BE49-F238E27FC236}">
                  <a16:creationId xmlns:a16="http://schemas.microsoft.com/office/drawing/2014/main" id="{7CFC82A5-5E6B-4CA9-9485-77FF1C40E607}"/>
                </a:ext>
              </a:extLst>
            </p:cNvPr>
            <p:cNvSpPr/>
            <p:nvPr/>
          </p:nvSpPr>
          <p:spPr>
            <a:xfrm>
              <a:off x="4154685" y="1059543"/>
              <a:ext cx="519400" cy="267930"/>
            </a:xfrm>
            <a:prstGeom prst="cube">
              <a:avLst>
                <a:gd name="adj" fmla="val 92488"/>
              </a:avLst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endParaRPr lang="ja-JP" altLang="en-US" sz="2000">
                <a:solidFill>
                  <a:prstClr val="black"/>
                </a:solidFill>
                <a:latin typeface="Calibri"/>
                <a:ea typeface="ＭＳ Ｐゴシック" panose="020B0600070205080204" pitchFamily="50" charset="-128"/>
              </a:endParaRPr>
            </a:p>
          </p:txBody>
        </p:sp>
      </p:grpSp>
      <p:pic>
        <p:nvPicPr>
          <p:cNvPr id="70" name="Picture 4" descr="http://1.bp.blogspot.com/-xO7DZCmQ4mo/VSufqqdxlrI/AAAAAAAAtAE/yBZhnyA6Kfs/s800/monshin_woman_doctor.png">
            <a:extLst>
              <a:ext uri="{FF2B5EF4-FFF2-40B4-BE49-F238E27FC236}">
                <a16:creationId xmlns:a16="http://schemas.microsoft.com/office/drawing/2014/main" id="{0CF9370F-FC40-435D-A784-44CB16DAEF5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4163" y="1072033"/>
            <a:ext cx="782051" cy="78205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5CD066FE-8514-46E8-83F3-C04A3E66F54B}"/>
              </a:ext>
            </a:extLst>
          </p:cNvPr>
          <p:cNvSpPr txBox="1"/>
          <p:nvPr/>
        </p:nvSpPr>
        <p:spPr>
          <a:xfrm>
            <a:off x="792534" y="2052829"/>
            <a:ext cx="10294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FFPE</a:t>
            </a:r>
            <a:r>
              <a:rPr lang="ja-JP" altLang="en-US" sz="1200" dirty="0">
                <a:solidFill>
                  <a:prstClr val="black"/>
                </a:solidFill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・</a:t>
            </a: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blood</a:t>
            </a:r>
            <a:endParaRPr lang="ja-JP" altLang="en-US" sz="1200" dirty="0">
              <a:solidFill>
                <a:prstClr val="black"/>
              </a:solidFill>
              <a:latin typeface="Arial" panose="020B0604020202020204" pitchFamily="34" charset="0"/>
              <a:ea typeface="ＭＳ Ｐゴシック" charset="-128"/>
              <a:cs typeface="Arial" panose="020B0604020202020204" pitchFamily="34" charset="0"/>
            </a:endParaRPr>
          </a:p>
        </p:txBody>
      </p:sp>
      <p:sp>
        <p:nvSpPr>
          <p:cNvPr id="19" name="直方体 18">
            <a:extLst>
              <a:ext uri="{FF2B5EF4-FFF2-40B4-BE49-F238E27FC236}">
                <a16:creationId xmlns:a16="http://schemas.microsoft.com/office/drawing/2014/main" id="{BE1F15C8-C74B-41CD-886C-00818B3398B5}"/>
              </a:ext>
            </a:extLst>
          </p:cNvPr>
          <p:cNvSpPr/>
          <p:nvPr/>
        </p:nvSpPr>
        <p:spPr>
          <a:xfrm>
            <a:off x="703361" y="3680516"/>
            <a:ext cx="1061480" cy="749373"/>
          </a:xfrm>
          <a:prstGeom prst="cub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200" dirty="0">
                <a:solidFill>
                  <a:schemeClr val="tx1"/>
                </a:solidFill>
                <a:latin typeface="arial" panose="020B0604020202020204" pitchFamily="34" charset="0"/>
              </a:rPr>
              <a:t>I</a:t>
            </a:r>
            <a:r>
              <a:rPr lang="en-US" altLang="ja-JP" sz="1200" b="0" i="0" dirty="0"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nstitute for health</a:t>
            </a:r>
            <a:endParaRPr kumimoji="1" lang="ja-JP" altLang="en-US" sz="1200" dirty="0">
              <a:solidFill>
                <a:schemeClr val="tx1"/>
              </a:solidFill>
            </a:endParaRPr>
          </a:p>
        </p:txBody>
      </p:sp>
      <p:sp>
        <p:nvSpPr>
          <p:cNvPr id="72" name="直方体 71">
            <a:extLst>
              <a:ext uri="{FF2B5EF4-FFF2-40B4-BE49-F238E27FC236}">
                <a16:creationId xmlns:a16="http://schemas.microsoft.com/office/drawing/2014/main" id="{710F6629-4A41-422C-A6F2-DBA1832BF85A}"/>
              </a:ext>
            </a:extLst>
          </p:cNvPr>
          <p:cNvSpPr/>
          <p:nvPr/>
        </p:nvSpPr>
        <p:spPr>
          <a:xfrm>
            <a:off x="2159132" y="3680802"/>
            <a:ext cx="1061480" cy="749373"/>
          </a:xfrm>
          <a:prstGeom prst="cub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quence center</a:t>
            </a:r>
            <a:endParaRPr kumimoji="1" lang="ja-JP" altLang="en-US"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4" name="直線矢印コネクタ 73">
            <a:extLst>
              <a:ext uri="{FF2B5EF4-FFF2-40B4-BE49-F238E27FC236}">
                <a16:creationId xmlns:a16="http://schemas.microsoft.com/office/drawing/2014/main" id="{D23FACA5-2BAB-4C55-A25B-0D33B77896E0}"/>
              </a:ext>
            </a:extLst>
          </p:cNvPr>
          <p:cNvCxnSpPr>
            <a:cxnSpLocks/>
            <a:stCxn id="19" idx="3"/>
          </p:cNvCxnSpPr>
          <p:nvPr/>
        </p:nvCxnSpPr>
        <p:spPr>
          <a:xfrm>
            <a:off x="1140429" y="4429889"/>
            <a:ext cx="0" cy="28645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4" name="グループ化 23">
            <a:extLst>
              <a:ext uri="{FF2B5EF4-FFF2-40B4-BE49-F238E27FC236}">
                <a16:creationId xmlns:a16="http://schemas.microsoft.com/office/drawing/2014/main" id="{603311E7-F6EE-42D7-978E-BF894966BD6E}"/>
              </a:ext>
            </a:extLst>
          </p:cNvPr>
          <p:cNvGrpSpPr/>
          <p:nvPr/>
        </p:nvGrpSpPr>
        <p:grpSpPr>
          <a:xfrm>
            <a:off x="995221" y="4769264"/>
            <a:ext cx="103078" cy="338554"/>
            <a:chOff x="4007603" y="1334530"/>
            <a:chExt cx="161968" cy="407334"/>
          </a:xfrm>
        </p:grpSpPr>
        <p:sp>
          <p:nvSpPr>
            <p:cNvPr id="22" name="フローチャート: 論理積ゲート 21">
              <a:extLst>
                <a:ext uri="{FF2B5EF4-FFF2-40B4-BE49-F238E27FC236}">
                  <a16:creationId xmlns:a16="http://schemas.microsoft.com/office/drawing/2014/main" id="{CCE3AAAF-0AD6-465C-A06E-2BA251F2520D}"/>
                </a:ext>
              </a:extLst>
            </p:cNvPr>
            <p:cNvSpPr/>
            <p:nvPr/>
          </p:nvSpPr>
          <p:spPr>
            <a:xfrm rot="5400000">
              <a:off x="3919310" y="1491603"/>
              <a:ext cx="338554" cy="161967"/>
            </a:xfrm>
            <a:prstGeom prst="flowChartDelay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3" name="四角形: 角を丸くする 22">
              <a:extLst>
                <a:ext uri="{FF2B5EF4-FFF2-40B4-BE49-F238E27FC236}">
                  <a16:creationId xmlns:a16="http://schemas.microsoft.com/office/drawing/2014/main" id="{5594171F-D695-4925-A5C4-65C344D434C5}"/>
                </a:ext>
              </a:extLst>
            </p:cNvPr>
            <p:cNvSpPr/>
            <p:nvPr/>
          </p:nvSpPr>
          <p:spPr>
            <a:xfrm>
              <a:off x="4007603" y="1334530"/>
              <a:ext cx="161968" cy="68779"/>
            </a:xfrm>
            <a:prstGeom prst="round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D0E5B145-248F-4D98-9236-E6471DD2D9E7}"/>
              </a:ext>
            </a:extLst>
          </p:cNvPr>
          <p:cNvSpPr txBox="1"/>
          <p:nvPr/>
        </p:nvSpPr>
        <p:spPr>
          <a:xfrm>
            <a:off x="1082869" y="4733131"/>
            <a:ext cx="5338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NA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5" name="直線矢印コネクタ 74">
            <a:extLst>
              <a:ext uri="{FF2B5EF4-FFF2-40B4-BE49-F238E27FC236}">
                <a16:creationId xmlns:a16="http://schemas.microsoft.com/office/drawing/2014/main" id="{47A718ED-4E75-4924-8C5A-8907268933BE}"/>
              </a:ext>
            </a:extLst>
          </p:cNvPr>
          <p:cNvCxnSpPr>
            <a:cxnSpLocks/>
            <a:stCxn id="72" idx="3"/>
          </p:cNvCxnSpPr>
          <p:nvPr/>
        </p:nvCxnSpPr>
        <p:spPr>
          <a:xfrm>
            <a:off x="2596200" y="4430175"/>
            <a:ext cx="0" cy="28617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メモ 10">
            <a:extLst>
              <a:ext uri="{FF2B5EF4-FFF2-40B4-BE49-F238E27FC236}">
                <a16:creationId xmlns:a16="http://schemas.microsoft.com/office/drawing/2014/main" id="{39FD4A84-B15B-4A4A-B063-4EEF0E75972E}"/>
              </a:ext>
            </a:extLst>
          </p:cNvPr>
          <p:cNvSpPr/>
          <p:nvPr/>
        </p:nvSpPr>
        <p:spPr>
          <a:xfrm>
            <a:off x="2223928" y="4716345"/>
            <a:ext cx="744543" cy="495377"/>
          </a:xfrm>
          <a:prstGeom prst="foldedCorner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 anchor="ctr"/>
          <a:lstStyle/>
          <a:p>
            <a:pPr algn="ctr">
              <a:defRPr/>
            </a:pP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rPr>
              <a:t>Sequence</a:t>
            </a:r>
          </a:p>
          <a:p>
            <a:pPr algn="ctr">
              <a:defRPr/>
            </a:pP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rPr>
              <a:t>data</a:t>
            </a:r>
            <a:endParaRPr lang="ja-JP" altLang="en-US" sz="1200" dirty="0">
              <a:solidFill>
                <a:prstClr val="black"/>
              </a:solidFill>
              <a:latin typeface="Arial" panose="020B0604020202020204" pitchFamily="34" charset="0"/>
              <a:ea typeface="HG丸ｺﾞｼｯｸM-PRO" panose="020F06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7" name="右矢印 47">
            <a:extLst>
              <a:ext uri="{FF2B5EF4-FFF2-40B4-BE49-F238E27FC236}">
                <a16:creationId xmlns:a16="http://schemas.microsoft.com/office/drawing/2014/main" id="{62EFC6AA-4EC2-4A06-A93E-19B00545ADAB}"/>
              </a:ext>
            </a:extLst>
          </p:cNvPr>
          <p:cNvSpPr/>
          <p:nvPr/>
        </p:nvSpPr>
        <p:spPr>
          <a:xfrm>
            <a:off x="3313473" y="4146639"/>
            <a:ext cx="221047" cy="447353"/>
          </a:xfrm>
          <a:prstGeom prst="rightArrow">
            <a:avLst/>
          </a:prstGeom>
          <a:solidFill>
            <a:srgbClr val="FFC000"/>
          </a:solidFill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>
              <a:defRPr/>
            </a:pPr>
            <a:endParaRPr lang="ja-JP" altLang="en-US" sz="1600">
              <a:solidFill>
                <a:prstClr val="black"/>
              </a:solidFill>
              <a:latin typeface="Arial" panose="020B0604020202020204" pitchFamily="34" charset="0"/>
              <a:ea typeface="HG丸ｺﾞｼｯｸM-PRO" panose="020F06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8" name="右矢印 47">
            <a:extLst>
              <a:ext uri="{FF2B5EF4-FFF2-40B4-BE49-F238E27FC236}">
                <a16:creationId xmlns:a16="http://schemas.microsoft.com/office/drawing/2014/main" id="{648A90D2-8EEA-426C-90AA-AFA31A791DA8}"/>
              </a:ext>
            </a:extLst>
          </p:cNvPr>
          <p:cNvSpPr/>
          <p:nvPr/>
        </p:nvSpPr>
        <p:spPr>
          <a:xfrm>
            <a:off x="1858024" y="4150428"/>
            <a:ext cx="221047" cy="447353"/>
          </a:xfrm>
          <a:prstGeom prst="rightArrow">
            <a:avLst/>
          </a:prstGeom>
          <a:solidFill>
            <a:srgbClr val="FFC000"/>
          </a:solidFill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>
              <a:defRPr/>
            </a:pPr>
            <a:endParaRPr lang="ja-JP" altLang="en-US" sz="1600">
              <a:solidFill>
                <a:prstClr val="black"/>
              </a:solidFill>
              <a:latin typeface="Arial" panose="020B0604020202020204" pitchFamily="34" charset="0"/>
              <a:ea typeface="HG丸ｺﾞｼｯｸM-PRO" panose="020F06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9" name="正方形/長方形 78">
            <a:extLst>
              <a:ext uri="{FF2B5EF4-FFF2-40B4-BE49-F238E27FC236}">
                <a16:creationId xmlns:a16="http://schemas.microsoft.com/office/drawing/2014/main" id="{A3A3F553-EFCA-4653-B67D-6C90F767FDAD}"/>
              </a:ext>
            </a:extLst>
          </p:cNvPr>
          <p:cNvSpPr/>
          <p:nvPr/>
        </p:nvSpPr>
        <p:spPr>
          <a:xfrm>
            <a:off x="2081228" y="3300524"/>
            <a:ext cx="1253344" cy="338554"/>
          </a:xfrm>
          <a:prstGeom prst="rect">
            <a:avLst/>
          </a:prstGeom>
          <a:solidFill>
            <a:srgbClr val="FFDDFF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quence</a:t>
            </a:r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正方形/長方形 79">
            <a:extLst>
              <a:ext uri="{FF2B5EF4-FFF2-40B4-BE49-F238E27FC236}">
                <a16:creationId xmlns:a16="http://schemas.microsoft.com/office/drawing/2014/main" id="{F557E565-0E89-4106-BE3B-61A7622384DC}"/>
              </a:ext>
            </a:extLst>
          </p:cNvPr>
          <p:cNvSpPr/>
          <p:nvPr/>
        </p:nvSpPr>
        <p:spPr>
          <a:xfrm>
            <a:off x="643642" y="3297797"/>
            <a:ext cx="1253344" cy="338554"/>
          </a:xfrm>
          <a:prstGeom prst="rect">
            <a:avLst/>
          </a:prstGeom>
          <a:solidFill>
            <a:srgbClr val="CCCC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xtraction</a:t>
            </a:r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正方形/長方形 80">
            <a:extLst>
              <a:ext uri="{FF2B5EF4-FFF2-40B4-BE49-F238E27FC236}">
                <a16:creationId xmlns:a16="http://schemas.microsoft.com/office/drawing/2014/main" id="{A41DFEDC-81E9-46E0-B3A3-7AAF1B4AB39E}"/>
              </a:ext>
            </a:extLst>
          </p:cNvPr>
          <p:cNvSpPr/>
          <p:nvPr/>
        </p:nvSpPr>
        <p:spPr>
          <a:xfrm>
            <a:off x="317753" y="719055"/>
            <a:ext cx="1974870" cy="338554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formed consent</a:t>
            </a:r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右矢印 47">
            <a:extLst>
              <a:ext uri="{FF2B5EF4-FFF2-40B4-BE49-F238E27FC236}">
                <a16:creationId xmlns:a16="http://schemas.microsoft.com/office/drawing/2014/main" id="{9802581F-8CAC-4E14-8EA7-78177353DF77}"/>
              </a:ext>
            </a:extLst>
          </p:cNvPr>
          <p:cNvSpPr/>
          <p:nvPr/>
        </p:nvSpPr>
        <p:spPr>
          <a:xfrm rot="5400000">
            <a:off x="1102385" y="2653628"/>
            <a:ext cx="335854" cy="447353"/>
          </a:xfrm>
          <a:prstGeom prst="rightArrow">
            <a:avLst/>
          </a:prstGeom>
          <a:solidFill>
            <a:srgbClr val="FFC000"/>
          </a:solidFill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>
              <a:defRPr/>
            </a:pPr>
            <a:endParaRPr lang="ja-JP" altLang="en-US" sz="1600">
              <a:solidFill>
                <a:prstClr val="black"/>
              </a:solidFill>
              <a:latin typeface="Arial" panose="020B0604020202020204" pitchFamily="34" charset="0"/>
              <a:ea typeface="HG丸ｺﾞｼｯｸM-PRO" panose="020F0600000000000000" pitchFamily="50" charset="-128"/>
              <a:cs typeface="Arial" panose="020B0604020202020204" pitchFamily="34" charset="0"/>
            </a:endParaRPr>
          </a:p>
        </p:txBody>
      </p:sp>
      <p:cxnSp>
        <p:nvCxnSpPr>
          <p:cNvPr id="83" name="直線矢印コネクタ 82">
            <a:extLst>
              <a:ext uri="{FF2B5EF4-FFF2-40B4-BE49-F238E27FC236}">
                <a16:creationId xmlns:a16="http://schemas.microsoft.com/office/drawing/2014/main" id="{54294E10-D591-4B39-8C20-384D70203B79}"/>
              </a:ext>
            </a:extLst>
          </p:cNvPr>
          <p:cNvCxnSpPr>
            <a:cxnSpLocks/>
            <a:stCxn id="70" idx="2"/>
            <a:endCxn id="71" idx="0"/>
          </p:cNvCxnSpPr>
          <p:nvPr/>
        </p:nvCxnSpPr>
        <p:spPr>
          <a:xfrm>
            <a:off x="1305189" y="1854084"/>
            <a:ext cx="2070" cy="198745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右矢印 47">
            <a:extLst>
              <a:ext uri="{FF2B5EF4-FFF2-40B4-BE49-F238E27FC236}">
                <a16:creationId xmlns:a16="http://schemas.microsoft.com/office/drawing/2014/main" id="{3034E08C-7952-4ECA-90A8-24980EBFA0C8}"/>
              </a:ext>
            </a:extLst>
          </p:cNvPr>
          <p:cNvSpPr/>
          <p:nvPr/>
        </p:nvSpPr>
        <p:spPr>
          <a:xfrm rot="16200000">
            <a:off x="10431074" y="2485966"/>
            <a:ext cx="1176309" cy="447353"/>
          </a:xfrm>
          <a:prstGeom prst="rightArrow">
            <a:avLst/>
          </a:prstGeom>
          <a:solidFill>
            <a:srgbClr val="FFC000"/>
          </a:solidFill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>
              <a:defRPr/>
            </a:pPr>
            <a:endParaRPr lang="ja-JP" altLang="en-US" sz="1600">
              <a:solidFill>
                <a:prstClr val="black"/>
              </a:solidFill>
              <a:latin typeface="Arial" panose="020B0604020202020204" pitchFamily="34" charset="0"/>
              <a:ea typeface="HG丸ｺﾞｼｯｸM-PRO" panose="020F0600000000000000" pitchFamily="50" charset="-128"/>
              <a:cs typeface="Arial" panose="020B0604020202020204" pitchFamily="34" charset="0"/>
            </a:endParaRPr>
          </a:p>
        </p:txBody>
      </p:sp>
      <p:pic>
        <p:nvPicPr>
          <p:cNvPr id="92" name="Picture 4" descr="http://1.bp.blogspot.com/-xO7DZCmQ4mo/VSufqqdxlrI/AAAAAAAAtAE/yBZhnyA6Kfs/s800/monshin_woman_doctor.png">
            <a:extLst>
              <a:ext uri="{FF2B5EF4-FFF2-40B4-BE49-F238E27FC236}">
                <a16:creationId xmlns:a16="http://schemas.microsoft.com/office/drawing/2014/main" id="{82985EA7-E683-48A4-A33D-B994702239D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635434" y="1253616"/>
            <a:ext cx="782051" cy="78205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4" name="正方形/長方形 93">
            <a:extLst>
              <a:ext uri="{FF2B5EF4-FFF2-40B4-BE49-F238E27FC236}">
                <a16:creationId xmlns:a16="http://schemas.microsoft.com/office/drawing/2014/main" id="{04894735-6143-4EFB-A135-B9975905AEA9}"/>
              </a:ext>
            </a:extLst>
          </p:cNvPr>
          <p:cNvSpPr/>
          <p:nvPr/>
        </p:nvSpPr>
        <p:spPr>
          <a:xfrm>
            <a:off x="10350517" y="888332"/>
            <a:ext cx="1405115" cy="338554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xplanation</a:t>
            </a:r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正方形/長方形 95">
            <a:extLst>
              <a:ext uri="{FF2B5EF4-FFF2-40B4-BE49-F238E27FC236}">
                <a16:creationId xmlns:a16="http://schemas.microsoft.com/office/drawing/2014/main" id="{ABA4CCA7-7B66-4225-BC56-3D1CB7393D22}"/>
              </a:ext>
            </a:extLst>
          </p:cNvPr>
          <p:cNvSpPr/>
          <p:nvPr/>
        </p:nvSpPr>
        <p:spPr>
          <a:xfrm>
            <a:off x="4620971" y="3564788"/>
            <a:ext cx="2420531" cy="2517804"/>
          </a:xfrm>
          <a:prstGeom prst="rect">
            <a:avLst/>
          </a:prstGeom>
          <a:noFill/>
          <a:ln w="381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F6E135B9-1F12-7094-1B7F-556CE2B449AB}"/>
              </a:ext>
            </a:extLst>
          </p:cNvPr>
          <p:cNvSpPr txBox="1"/>
          <p:nvPr/>
        </p:nvSpPr>
        <p:spPr>
          <a:xfrm>
            <a:off x="4380764" y="3091313"/>
            <a:ext cx="283532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ja-JP" sz="14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 the Genomics Unit, Keio University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9DA08A07-8F9D-5650-E1C5-6B5FCC6447FF}"/>
              </a:ext>
            </a:extLst>
          </p:cNvPr>
          <p:cNvSpPr txBox="1"/>
          <p:nvPr/>
        </p:nvSpPr>
        <p:spPr>
          <a:xfrm>
            <a:off x="8226405" y="3338142"/>
            <a:ext cx="14891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t e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ch hospital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134F2AD5-87D6-9479-91F8-410B8EF4FF76}"/>
              </a:ext>
            </a:extLst>
          </p:cNvPr>
          <p:cNvSpPr txBox="1"/>
          <p:nvPr/>
        </p:nvSpPr>
        <p:spPr>
          <a:xfrm>
            <a:off x="641928" y="2990020"/>
            <a:ext cx="26926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t inspection companies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A7054260-45EA-0F94-6395-6BD976893A86}"/>
              </a:ext>
            </a:extLst>
          </p:cNvPr>
          <p:cNvSpPr txBox="1"/>
          <p:nvPr/>
        </p:nvSpPr>
        <p:spPr>
          <a:xfrm>
            <a:off x="317752" y="410757"/>
            <a:ext cx="19748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t e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ch hospital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498B54B8-89D4-BB33-262A-D72F18BAF543}"/>
              </a:ext>
            </a:extLst>
          </p:cNvPr>
          <p:cNvSpPr txBox="1"/>
          <p:nvPr/>
        </p:nvSpPr>
        <p:spPr>
          <a:xfrm>
            <a:off x="10230160" y="563136"/>
            <a:ext cx="16406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t e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ch hospital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ABEC47D9-7633-2EFE-4993-93153E1BC8C7}"/>
              </a:ext>
            </a:extLst>
          </p:cNvPr>
          <p:cNvSpPr txBox="1"/>
          <p:nvPr/>
        </p:nvSpPr>
        <p:spPr>
          <a:xfrm>
            <a:off x="10137859" y="3324527"/>
            <a:ext cx="17772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ia web conference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矢印: 環状 20">
            <a:extLst>
              <a:ext uri="{FF2B5EF4-FFF2-40B4-BE49-F238E27FC236}">
                <a16:creationId xmlns:a16="http://schemas.microsoft.com/office/drawing/2014/main" id="{199BE5CC-1621-37AC-EE08-5182B3344B11}"/>
              </a:ext>
            </a:extLst>
          </p:cNvPr>
          <p:cNvSpPr/>
          <p:nvPr/>
        </p:nvSpPr>
        <p:spPr>
          <a:xfrm flipV="1">
            <a:off x="2472117" y="998754"/>
            <a:ext cx="7878400" cy="2021178"/>
          </a:xfrm>
          <a:prstGeom prst="circularArrow">
            <a:avLst>
              <a:gd name="adj1" fmla="val 6051"/>
              <a:gd name="adj2" fmla="val 164517"/>
              <a:gd name="adj3" fmla="val 233161"/>
              <a:gd name="adj4" fmla="val 10392777"/>
              <a:gd name="adj5" fmla="val 11989"/>
            </a:avLst>
          </a:prstGeom>
          <a:solidFill>
            <a:srgbClr val="FFC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36F002FE-6D69-7225-8F19-03010EE39CD8}"/>
              </a:ext>
            </a:extLst>
          </p:cNvPr>
          <p:cNvSpPr txBox="1"/>
          <p:nvPr/>
        </p:nvSpPr>
        <p:spPr>
          <a:xfrm>
            <a:off x="3175354" y="1495112"/>
            <a:ext cx="638098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The d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uration between obtaining informed consent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explanation of results was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approximately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4 weeks </a:t>
            </a:r>
          </a:p>
          <a:p>
            <a:pPr algn="ctr"/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7D08F9E-1210-0F78-553D-115AB6EB3AEE}"/>
              </a:ext>
            </a:extLst>
          </p:cNvPr>
          <p:cNvSpPr txBox="1"/>
          <p:nvPr/>
        </p:nvSpPr>
        <p:spPr>
          <a:xfrm>
            <a:off x="624965" y="5897926"/>
            <a:ext cx="12330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1</a:t>
            </a: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447685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68A2A34-8994-8E5C-982A-041B15B891E4}"/>
              </a:ext>
            </a:extLst>
          </p:cNvPr>
          <p:cNvSpPr txBox="1"/>
          <p:nvPr/>
        </p:nvSpPr>
        <p:spPr>
          <a:xfrm>
            <a:off x="2217683" y="2238703"/>
            <a:ext cx="709448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Due to the large amount of data, it is created in Supplementary Figure S2 of the Excel file.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14515273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E18325A2-1820-E043-A284-975E068C929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86845935"/>
              </p:ext>
            </p:extLst>
          </p:nvPr>
        </p:nvGraphicFramePr>
        <p:xfrm>
          <a:off x="0" y="0"/>
          <a:ext cx="4290646" cy="22508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464C39CA-A14A-8DF9-F4FC-3DCF1219325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34145352"/>
              </p:ext>
            </p:extLst>
          </p:nvPr>
        </p:nvGraphicFramePr>
        <p:xfrm>
          <a:off x="4290646" y="53559"/>
          <a:ext cx="3982915" cy="24178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21856FE8-3386-EC7E-E188-27082A49C8C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10050025"/>
              </p:ext>
            </p:extLst>
          </p:nvPr>
        </p:nvGraphicFramePr>
        <p:xfrm>
          <a:off x="8269793" y="4798"/>
          <a:ext cx="3922207" cy="25154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09FFD5C0-2BA0-CC08-59A6-38B0D0DC35F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68574380"/>
              </p:ext>
            </p:extLst>
          </p:nvPr>
        </p:nvGraphicFramePr>
        <p:xfrm>
          <a:off x="0" y="2303584"/>
          <a:ext cx="4290646" cy="22508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042C91B3-A751-0BE8-777B-4DBB806FEA7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6842274"/>
              </p:ext>
            </p:extLst>
          </p:nvPr>
        </p:nvGraphicFramePr>
        <p:xfrm>
          <a:off x="4478215" y="2520204"/>
          <a:ext cx="3795346" cy="20519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id="{F58D31C5-7D1B-4C71-2649-C7A3A57FF7D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90439134"/>
              </p:ext>
            </p:extLst>
          </p:nvPr>
        </p:nvGraphicFramePr>
        <p:xfrm>
          <a:off x="0" y="4482818"/>
          <a:ext cx="4290646" cy="24241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8" name="グラフ 7">
            <a:extLst>
              <a:ext uri="{FF2B5EF4-FFF2-40B4-BE49-F238E27FC236}">
                <a16:creationId xmlns:a16="http://schemas.microsoft.com/office/drawing/2014/main" id="{FDF66F0C-F2CA-2CFB-348C-1F99E27F522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18190692"/>
              </p:ext>
            </p:extLst>
          </p:nvPr>
        </p:nvGraphicFramePr>
        <p:xfrm>
          <a:off x="4286878" y="4603176"/>
          <a:ext cx="3982915" cy="23235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992ABF1B-24B2-472B-A464-1A4D6FB14FD8}"/>
              </a:ext>
            </a:extLst>
          </p:cNvPr>
          <p:cNvSpPr txBox="1"/>
          <p:nvPr/>
        </p:nvSpPr>
        <p:spPr>
          <a:xfrm>
            <a:off x="9473402" y="5694901"/>
            <a:ext cx="12330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3</a:t>
            </a:r>
          </a:p>
        </p:txBody>
      </p:sp>
    </p:spTree>
    <p:extLst>
      <p:ext uri="{BB962C8B-B14F-4D97-AF65-F5344CB8AC3E}">
        <p14:creationId xmlns:p14="http://schemas.microsoft.com/office/powerpoint/2010/main" val="309870308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D09B54CC-E85A-82E0-E8BC-EA87E673AB5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95640445"/>
              </p:ext>
            </p:extLst>
          </p:nvPr>
        </p:nvGraphicFramePr>
        <p:xfrm>
          <a:off x="0" y="87922"/>
          <a:ext cx="3921369" cy="247691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29470230-E339-70B9-58BF-EA991EDA28B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17568937"/>
              </p:ext>
            </p:extLst>
          </p:nvPr>
        </p:nvGraphicFramePr>
        <p:xfrm>
          <a:off x="4275574" y="87922"/>
          <a:ext cx="3921369" cy="22659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0602FC49-2481-E23A-5D2D-FD2A297A2DA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86150696"/>
              </p:ext>
            </p:extLst>
          </p:nvPr>
        </p:nvGraphicFramePr>
        <p:xfrm>
          <a:off x="8423031" y="0"/>
          <a:ext cx="3840188" cy="50555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A0EAE5D2-966C-DE12-F553-B2C5AE4317D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81988619"/>
              </p:ext>
            </p:extLst>
          </p:nvPr>
        </p:nvGraphicFramePr>
        <p:xfrm>
          <a:off x="131884" y="2506207"/>
          <a:ext cx="3789486" cy="22742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9F1DD313-1037-504A-52B6-CF8F292735B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81598866"/>
              </p:ext>
            </p:extLst>
          </p:nvPr>
        </p:nvGraphicFramePr>
        <p:xfrm>
          <a:off x="4335236" y="2353825"/>
          <a:ext cx="3861707" cy="235593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id="{CB6E56A3-43FC-C138-4F35-938A2D742A5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32344564"/>
              </p:ext>
            </p:extLst>
          </p:nvPr>
        </p:nvGraphicFramePr>
        <p:xfrm>
          <a:off x="0" y="4647790"/>
          <a:ext cx="3921369" cy="22742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8" name="グラフ 7">
            <a:extLst>
              <a:ext uri="{FF2B5EF4-FFF2-40B4-BE49-F238E27FC236}">
                <a16:creationId xmlns:a16="http://schemas.microsoft.com/office/drawing/2014/main" id="{10FA36D0-2452-E2EF-252E-A47062BB1FC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02308081"/>
              </p:ext>
            </p:extLst>
          </p:nvPr>
        </p:nvGraphicFramePr>
        <p:xfrm>
          <a:off x="4147457" y="4709764"/>
          <a:ext cx="4049486" cy="22123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DDB08796-27FD-1E0F-0D59-07FE8FD08837}"/>
              </a:ext>
            </a:extLst>
          </p:cNvPr>
          <p:cNvSpPr txBox="1"/>
          <p:nvPr/>
        </p:nvSpPr>
        <p:spPr>
          <a:xfrm>
            <a:off x="9351854" y="5934871"/>
            <a:ext cx="12330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4</a:t>
            </a:r>
          </a:p>
        </p:txBody>
      </p:sp>
    </p:spTree>
    <p:extLst>
      <p:ext uri="{BB962C8B-B14F-4D97-AF65-F5344CB8AC3E}">
        <p14:creationId xmlns:p14="http://schemas.microsoft.com/office/powerpoint/2010/main" val="268224518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" name="グラフ 12">
            <a:extLst>
              <a:ext uri="{FF2B5EF4-FFF2-40B4-BE49-F238E27FC236}">
                <a16:creationId xmlns:a16="http://schemas.microsoft.com/office/drawing/2014/main" id="{6476A253-286A-E25C-0DA0-C6F7339E4F8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19183818"/>
              </p:ext>
            </p:extLst>
          </p:nvPr>
        </p:nvGraphicFramePr>
        <p:xfrm>
          <a:off x="4006788" y="50818"/>
          <a:ext cx="3972442" cy="23694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4" name="グラフ 13">
            <a:extLst>
              <a:ext uri="{FF2B5EF4-FFF2-40B4-BE49-F238E27FC236}">
                <a16:creationId xmlns:a16="http://schemas.microsoft.com/office/drawing/2014/main" id="{57E46507-8120-7C7A-874E-88518BB60BA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65884015"/>
              </p:ext>
            </p:extLst>
          </p:nvPr>
        </p:nvGraphicFramePr>
        <p:xfrm>
          <a:off x="8097940" y="82558"/>
          <a:ext cx="4094059" cy="23694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5" name="グラフ 14">
            <a:extLst>
              <a:ext uri="{FF2B5EF4-FFF2-40B4-BE49-F238E27FC236}">
                <a16:creationId xmlns:a16="http://schemas.microsoft.com/office/drawing/2014/main" id="{9E2435AD-3E48-1ED8-4DAC-33111A2F115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9332665"/>
              </p:ext>
            </p:extLst>
          </p:nvPr>
        </p:nvGraphicFramePr>
        <p:xfrm>
          <a:off x="97973" y="2959637"/>
          <a:ext cx="4114799" cy="24578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6" name="グラフ 15">
            <a:extLst>
              <a:ext uri="{FF2B5EF4-FFF2-40B4-BE49-F238E27FC236}">
                <a16:creationId xmlns:a16="http://schemas.microsoft.com/office/drawing/2014/main" id="{69C250F8-37C4-F471-5606-6839E9A5E37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8755106"/>
              </p:ext>
            </p:extLst>
          </p:nvPr>
        </p:nvGraphicFramePr>
        <p:xfrm>
          <a:off x="4041532" y="2945422"/>
          <a:ext cx="3937698" cy="23699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7" name="グラフ 16">
            <a:extLst>
              <a:ext uri="{FF2B5EF4-FFF2-40B4-BE49-F238E27FC236}">
                <a16:creationId xmlns:a16="http://schemas.microsoft.com/office/drawing/2014/main" id="{A17525E9-F48C-84C1-5035-9AA4F3D0F26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88470727"/>
              </p:ext>
            </p:extLst>
          </p:nvPr>
        </p:nvGraphicFramePr>
        <p:xfrm>
          <a:off x="7871330" y="2837745"/>
          <a:ext cx="4320669" cy="257974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CFCAF575-69D7-5AAF-A328-B803A072174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86229066"/>
              </p:ext>
            </p:extLst>
          </p:nvPr>
        </p:nvGraphicFramePr>
        <p:xfrm>
          <a:off x="0" y="114300"/>
          <a:ext cx="4114800" cy="230598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27151AFC-5815-AE62-2276-5FBFBD625215}"/>
              </a:ext>
            </a:extLst>
          </p:cNvPr>
          <p:cNvSpPr txBox="1"/>
          <p:nvPr/>
        </p:nvSpPr>
        <p:spPr>
          <a:xfrm>
            <a:off x="624965" y="5897926"/>
            <a:ext cx="12330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5</a:t>
            </a:r>
          </a:p>
        </p:txBody>
      </p:sp>
    </p:spTree>
    <p:extLst>
      <p:ext uri="{BB962C8B-B14F-4D97-AF65-F5344CB8AC3E}">
        <p14:creationId xmlns:p14="http://schemas.microsoft.com/office/powerpoint/2010/main" val="85873766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873B2130-BEC2-254F-0600-D55E1F0C68A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11846233"/>
              </p:ext>
            </p:extLst>
          </p:nvPr>
        </p:nvGraphicFramePr>
        <p:xfrm>
          <a:off x="0" y="0"/>
          <a:ext cx="3991708" cy="24003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id="{A271792B-B4AA-2594-0753-34767768DB1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68787375"/>
              </p:ext>
            </p:extLst>
          </p:nvPr>
        </p:nvGraphicFramePr>
        <p:xfrm>
          <a:off x="4251614" y="-63543"/>
          <a:ext cx="3309771" cy="46463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8" name="グラフ 7">
            <a:extLst>
              <a:ext uri="{FF2B5EF4-FFF2-40B4-BE49-F238E27FC236}">
                <a16:creationId xmlns:a16="http://schemas.microsoft.com/office/drawing/2014/main" id="{78D4C85D-590E-FB7C-2104-05766C03BC4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59438990"/>
              </p:ext>
            </p:extLst>
          </p:nvPr>
        </p:nvGraphicFramePr>
        <p:xfrm>
          <a:off x="7620001" y="-7877"/>
          <a:ext cx="3309770" cy="43395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9" name="グラフ 8">
            <a:extLst>
              <a:ext uri="{FF2B5EF4-FFF2-40B4-BE49-F238E27FC236}">
                <a16:creationId xmlns:a16="http://schemas.microsoft.com/office/drawing/2014/main" id="{519089B1-7349-C2AD-A42F-7B0906FDFF0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72145397"/>
              </p:ext>
            </p:extLst>
          </p:nvPr>
        </p:nvGraphicFramePr>
        <p:xfrm>
          <a:off x="57150" y="2603256"/>
          <a:ext cx="3934558" cy="22650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0" name="グラフ 9">
            <a:extLst>
              <a:ext uri="{FF2B5EF4-FFF2-40B4-BE49-F238E27FC236}">
                <a16:creationId xmlns:a16="http://schemas.microsoft.com/office/drawing/2014/main" id="{6A5F46D7-242D-4A35-9C67-316857DD0E5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96170015"/>
              </p:ext>
            </p:extLst>
          </p:nvPr>
        </p:nvGraphicFramePr>
        <p:xfrm>
          <a:off x="2537114" y="4459963"/>
          <a:ext cx="3429000" cy="23090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1" name="グラフ 10">
            <a:extLst>
              <a:ext uri="{FF2B5EF4-FFF2-40B4-BE49-F238E27FC236}">
                <a16:creationId xmlns:a16="http://schemas.microsoft.com/office/drawing/2014/main" id="{2C760C48-B862-7B5D-C870-65D18E629F8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75104260"/>
              </p:ext>
            </p:extLst>
          </p:nvPr>
        </p:nvGraphicFramePr>
        <p:xfrm>
          <a:off x="6596230" y="4387379"/>
          <a:ext cx="3309770" cy="24290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B4514270-B034-7667-B0FE-1E1455A44665}"/>
              </a:ext>
            </a:extLst>
          </p:cNvPr>
          <p:cNvSpPr txBox="1"/>
          <p:nvPr/>
        </p:nvSpPr>
        <p:spPr>
          <a:xfrm>
            <a:off x="624965" y="5897926"/>
            <a:ext cx="12330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6</a:t>
            </a:r>
          </a:p>
        </p:txBody>
      </p:sp>
    </p:spTree>
    <p:extLst>
      <p:ext uri="{BB962C8B-B14F-4D97-AF65-F5344CB8AC3E}">
        <p14:creationId xmlns:p14="http://schemas.microsoft.com/office/powerpoint/2010/main" val="289652586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F6DB63ED-BC53-23A7-818F-A173850DA08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65575958"/>
              </p:ext>
            </p:extLst>
          </p:nvPr>
        </p:nvGraphicFramePr>
        <p:xfrm>
          <a:off x="0" y="0"/>
          <a:ext cx="5283200" cy="3111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D166DBAA-8AC9-1651-ED7A-554470235C8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95176921"/>
              </p:ext>
            </p:extLst>
          </p:nvPr>
        </p:nvGraphicFramePr>
        <p:xfrm>
          <a:off x="3810000" y="0"/>
          <a:ext cx="5168900" cy="3111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B54AE93B-BCB0-E95B-455D-7BF94943041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13630020"/>
              </p:ext>
            </p:extLst>
          </p:nvPr>
        </p:nvGraphicFramePr>
        <p:xfrm>
          <a:off x="7620000" y="0"/>
          <a:ext cx="5168900" cy="3111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D97ADE8F-48CB-6853-9FC5-7D7616F1B8E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4302471"/>
              </p:ext>
            </p:extLst>
          </p:nvPr>
        </p:nvGraphicFramePr>
        <p:xfrm>
          <a:off x="0" y="3429000"/>
          <a:ext cx="5283200" cy="3327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FC397976-6FEC-DA8F-B572-E36CAA3198F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20813853"/>
              </p:ext>
            </p:extLst>
          </p:nvPr>
        </p:nvGraphicFramePr>
        <p:xfrm>
          <a:off x="3810000" y="3429000"/>
          <a:ext cx="5168900" cy="3327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id="{25906AEE-503F-38AE-6740-4C5D7FCE4A7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26364913"/>
              </p:ext>
            </p:extLst>
          </p:nvPr>
        </p:nvGraphicFramePr>
        <p:xfrm>
          <a:off x="7620000" y="3429000"/>
          <a:ext cx="5168900" cy="3327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5E1F4B3E-6DF8-B7BE-8CE3-444B8B2F5B09}"/>
              </a:ext>
            </a:extLst>
          </p:cNvPr>
          <p:cNvSpPr txBox="1"/>
          <p:nvPr/>
        </p:nvSpPr>
        <p:spPr>
          <a:xfrm>
            <a:off x="520700" y="101600"/>
            <a:ext cx="317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B87B18C0-33A4-F40A-47B3-43F27D38DEBE}"/>
              </a:ext>
            </a:extLst>
          </p:cNvPr>
          <p:cNvSpPr txBox="1"/>
          <p:nvPr/>
        </p:nvSpPr>
        <p:spPr>
          <a:xfrm>
            <a:off x="4406900" y="101600"/>
            <a:ext cx="317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2296BD55-7C43-8614-BF8E-69231EE7EFED}"/>
              </a:ext>
            </a:extLst>
          </p:cNvPr>
          <p:cNvSpPr txBox="1"/>
          <p:nvPr/>
        </p:nvSpPr>
        <p:spPr>
          <a:xfrm>
            <a:off x="8366550" y="102632"/>
            <a:ext cx="317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72526FE5-97C1-F5B4-B7DE-7636B9F9EF6E}"/>
              </a:ext>
            </a:extLst>
          </p:cNvPr>
          <p:cNvSpPr txBox="1"/>
          <p:nvPr/>
        </p:nvSpPr>
        <p:spPr>
          <a:xfrm>
            <a:off x="520700" y="3606800"/>
            <a:ext cx="317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D19922C5-1BBA-A42D-3E62-76F210C024D4}"/>
              </a:ext>
            </a:extLst>
          </p:cNvPr>
          <p:cNvSpPr txBox="1"/>
          <p:nvPr/>
        </p:nvSpPr>
        <p:spPr>
          <a:xfrm>
            <a:off x="4406900" y="3606800"/>
            <a:ext cx="317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9A74B6CA-FE54-705D-6131-0F2185137CC8}"/>
              </a:ext>
            </a:extLst>
          </p:cNvPr>
          <p:cNvSpPr txBox="1"/>
          <p:nvPr/>
        </p:nvSpPr>
        <p:spPr>
          <a:xfrm>
            <a:off x="8366550" y="3606800"/>
            <a:ext cx="317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A852E60-BCA8-2579-75EF-0F0AAFBE6A9B}"/>
              </a:ext>
            </a:extLst>
          </p:cNvPr>
          <p:cNvSpPr txBox="1"/>
          <p:nvPr/>
        </p:nvSpPr>
        <p:spPr>
          <a:xfrm>
            <a:off x="240141" y="5971817"/>
            <a:ext cx="12330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7</a:t>
            </a:r>
          </a:p>
        </p:txBody>
      </p:sp>
    </p:spTree>
    <p:extLst>
      <p:ext uri="{BB962C8B-B14F-4D97-AF65-F5344CB8AC3E}">
        <p14:creationId xmlns:p14="http://schemas.microsoft.com/office/powerpoint/2010/main" val="40903147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56736EEA-B915-4429-AEB8-86C944986510}"/>
              </a:ext>
            </a:extLst>
          </p:cNvPr>
          <p:cNvSpPr/>
          <p:nvPr/>
        </p:nvSpPr>
        <p:spPr>
          <a:xfrm>
            <a:off x="3044756" y="713975"/>
            <a:ext cx="1942869" cy="369331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PC </a:t>
            </a:r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lteration</a:t>
            </a:r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四角形: 角を丸くする 6">
            <a:extLst>
              <a:ext uri="{FF2B5EF4-FFF2-40B4-BE49-F238E27FC236}">
                <a16:creationId xmlns:a16="http://schemas.microsoft.com/office/drawing/2014/main" id="{229A0036-544C-46C1-9E67-397C5720FEE4}"/>
              </a:ext>
            </a:extLst>
          </p:cNvPr>
          <p:cNvSpPr/>
          <p:nvPr/>
        </p:nvSpPr>
        <p:spPr>
          <a:xfrm>
            <a:off x="119262" y="1815709"/>
            <a:ext cx="3157337" cy="1261871"/>
          </a:xfrm>
          <a:prstGeom prst="round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omach: 1/40 (2.5%)</a:t>
            </a:r>
          </a:p>
          <a:p>
            <a:r>
              <a:rPr kumimoji="1" lang="en-US" altLang="ja-JP" u="sng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lorectal: 169/209 (80.9%)</a:t>
            </a:r>
          </a:p>
          <a:p>
            <a:r>
              <a:rPr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ncreas: 2/115 (1.7%)</a:t>
            </a:r>
          </a:p>
          <a:p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iliary tract: 2/119 (1.7%)</a:t>
            </a:r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0DE30369-6ECF-4BD3-8C1F-F5CADB5E0E43}"/>
              </a:ext>
            </a:extLst>
          </p:cNvPr>
          <p:cNvSpPr/>
          <p:nvPr/>
        </p:nvSpPr>
        <p:spPr>
          <a:xfrm>
            <a:off x="5770740" y="1812979"/>
            <a:ext cx="1942868" cy="369332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RAS </a:t>
            </a:r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lteration</a:t>
            </a:r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8F6806AA-0428-47FE-A109-6F7BEDE0DDB3}"/>
              </a:ext>
            </a:extLst>
          </p:cNvPr>
          <p:cNvSpPr/>
          <p:nvPr/>
        </p:nvSpPr>
        <p:spPr>
          <a:xfrm>
            <a:off x="7749150" y="3238936"/>
            <a:ext cx="2168644" cy="369333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KN2A </a:t>
            </a:r>
            <a:r>
              <a:rPr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lteration</a:t>
            </a:r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四角形: 角を丸くする 12">
            <a:extLst>
              <a:ext uri="{FF2B5EF4-FFF2-40B4-BE49-F238E27FC236}">
                <a16:creationId xmlns:a16="http://schemas.microsoft.com/office/drawing/2014/main" id="{A603AD9B-7C77-4110-A0C4-937511269EE9}"/>
              </a:ext>
            </a:extLst>
          </p:cNvPr>
          <p:cNvSpPr/>
          <p:nvPr/>
        </p:nvSpPr>
        <p:spPr>
          <a:xfrm>
            <a:off x="2801540" y="3246664"/>
            <a:ext cx="3157336" cy="1261871"/>
          </a:xfrm>
          <a:prstGeom prst="round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omach: 8/40 (20.0%)</a:t>
            </a:r>
          </a:p>
          <a:p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lorectal: 17/209 (8.1%)</a:t>
            </a:r>
          </a:p>
          <a:p>
            <a:r>
              <a:rPr lang="en-US" altLang="ja-JP" u="sng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ncreas: 104/115 (90.4%)</a:t>
            </a:r>
          </a:p>
          <a:p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iliary tract: 25/119 (21.2%)</a:t>
            </a:r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四角形: 角を丸くする 13">
            <a:extLst>
              <a:ext uri="{FF2B5EF4-FFF2-40B4-BE49-F238E27FC236}">
                <a16:creationId xmlns:a16="http://schemas.microsoft.com/office/drawing/2014/main" id="{7628CF84-22A0-41C2-95EE-924ED2A7AD7D}"/>
              </a:ext>
            </a:extLst>
          </p:cNvPr>
          <p:cNvSpPr/>
          <p:nvPr/>
        </p:nvSpPr>
        <p:spPr>
          <a:xfrm>
            <a:off x="5543162" y="4798335"/>
            <a:ext cx="3157335" cy="1261870"/>
          </a:xfrm>
          <a:prstGeom prst="round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omach: 6/40 (15.0%)</a:t>
            </a:r>
          </a:p>
          <a:p>
            <a:r>
              <a:rPr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lorectal: 0/209 (0.0%)</a:t>
            </a:r>
          </a:p>
          <a:p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ncreas: 2/115 (1.7%)</a:t>
            </a:r>
          </a:p>
          <a:p>
            <a:r>
              <a:rPr kumimoji="1" lang="en-US" altLang="ja-JP" u="sng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iliary tract: 24/119 (20.3%)</a:t>
            </a:r>
            <a:endParaRPr kumimoji="1" lang="ja-JP" altLang="en-US" u="sng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四角形: 角を丸くする 14">
            <a:extLst>
              <a:ext uri="{FF2B5EF4-FFF2-40B4-BE49-F238E27FC236}">
                <a16:creationId xmlns:a16="http://schemas.microsoft.com/office/drawing/2014/main" id="{6A5BF148-60F4-4036-BA2A-0099478C8253}"/>
              </a:ext>
            </a:extLst>
          </p:cNvPr>
          <p:cNvSpPr/>
          <p:nvPr/>
        </p:nvSpPr>
        <p:spPr>
          <a:xfrm>
            <a:off x="8957309" y="4798334"/>
            <a:ext cx="3157335" cy="1261869"/>
          </a:xfrm>
          <a:prstGeom prst="round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omach: 25/40 (62.5%)</a:t>
            </a:r>
          </a:p>
          <a:p>
            <a:r>
              <a:rPr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lorectal: 23/209 (11.0%)</a:t>
            </a:r>
          </a:p>
          <a:p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ncreas: 7/115 (6.1%)</a:t>
            </a:r>
          </a:p>
          <a:p>
            <a:r>
              <a:rPr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iliary tract: 68/119 (57.1%)</a:t>
            </a:r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コネクタ: カギ線 16">
            <a:extLst>
              <a:ext uri="{FF2B5EF4-FFF2-40B4-BE49-F238E27FC236}">
                <a16:creationId xmlns:a16="http://schemas.microsoft.com/office/drawing/2014/main" id="{157B3B00-59FD-403D-B1B5-BC9018A7BADB}"/>
              </a:ext>
            </a:extLst>
          </p:cNvPr>
          <p:cNvCxnSpPr>
            <a:cxnSpLocks/>
            <a:stCxn id="12" idx="2"/>
            <a:endCxn id="14" idx="0"/>
          </p:cNvCxnSpPr>
          <p:nvPr/>
        </p:nvCxnSpPr>
        <p:spPr>
          <a:xfrm rot="5400000">
            <a:off x="7382618" y="3347481"/>
            <a:ext cx="1190066" cy="1711642"/>
          </a:xfrm>
          <a:prstGeom prst="bentConnector3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コネクタ: カギ線 20">
            <a:extLst>
              <a:ext uri="{FF2B5EF4-FFF2-40B4-BE49-F238E27FC236}">
                <a16:creationId xmlns:a16="http://schemas.microsoft.com/office/drawing/2014/main" id="{8C2E1130-A145-4449-A346-BA597420D04F}"/>
              </a:ext>
            </a:extLst>
          </p:cNvPr>
          <p:cNvCxnSpPr>
            <a:cxnSpLocks/>
            <a:stCxn id="12" idx="2"/>
            <a:endCxn id="15" idx="0"/>
          </p:cNvCxnSpPr>
          <p:nvPr/>
        </p:nvCxnSpPr>
        <p:spPr>
          <a:xfrm rot="16200000" flipH="1">
            <a:off x="9089692" y="3352048"/>
            <a:ext cx="1190065" cy="1702505"/>
          </a:xfrm>
          <a:prstGeom prst="bentConnector3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コネクタ: カギ線 21">
            <a:extLst>
              <a:ext uri="{FF2B5EF4-FFF2-40B4-BE49-F238E27FC236}">
                <a16:creationId xmlns:a16="http://schemas.microsoft.com/office/drawing/2014/main" id="{5D36EF52-22BA-4066-9AC2-DFCE69C57F1B}"/>
              </a:ext>
            </a:extLst>
          </p:cNvPr>
          <p:cNvCxnSpPr>
            <a:cxnSpLocks/>
            <a:stCxn id="11" idx="2"/>
            <a:endCxn id="12" idx="0"/>
          </p:cNvCxnSpPr>
          <p:nvPr/>
        </p:nvCxnSpPr>
        <p:spPr>
          <a:xfrm rot="16200000" flipH="1">
            <a:off x="7259511" y="1664974"/>
            <a:ext cx="1056625" cy="2091298"/>
          </a:xfrm>
          <a:prstGeom prst="bentConnector3">
            <a:avLst>
              <a:gd name="adj1" fmla="val 50000"/>
            </a:avLst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コネクタ: カギ線 22">
            <a:extLst>
              <a:ext uri="{FF2B5EF4-FFF2-40B4-BE49-F238E27FC236}">
                <a16:creationId xmlns:a16="http://schemas.microsoft.com/office/drawing/2014/main" id="{0BD45DEB-6052-42CE-96C7-40DA2B9DA046}"/>
              </a:ext>
            </a:extLst>
          </p:cNvPr>
          <p:cNvCxnSpPr>
            <a:cxnSpLocks/>
            <a:stCxn id="4" idx="2"/>
            <a:endCxn id="11" idx="0"/>
          </p:cNvCxnSpPr>
          <p:nvPr/>
        </p:nvCxnSpPr>
        <p:spPr>
          <a:xfrm rot="16200000" flipH="1">
            <a:off x="5014346" y="85150"/>
            <a:ext cx="729673" cy="2725983"/>
          </a:xfrm>
          <a:prstGeom prst="bentConnector3">
            <a:avLst>
              <a:gd name="adj1" fmla="val 50000"/>
            </a:avLst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コネクタ: カギ線 23">
            <a:extLst>
              <a:ext uri="{FF2B5EF4-FFF2-40B4-BE49-F238E27FC236}">
                <a16:creationId xmlns:a16="http://schemas.microsoft.com/office/drawing/2014/main" id="{6707DF80-327F-48B2-85C2-F83474D361E9}"/>
              </a:ext>
            </a:extLst>
          </p:cNvPr>
          <p:cNvCxnSpPr>
            <a:cxnSpLocks/>
            <a:stCxn id="4" idx="2"/>
            <a:endCxn id="7" idx="0"/>
          </p:cNvCxnSpPr>
          <p:nvPr/>
        </p:nvCxnSpPr>
        <p:spPr>
          <a:xfrm rot="5400000">
            <a:off x="2490860" y="290377"/>
            <a:ext cx="732403" cy="2318260"/>
          </a:xfrm>
          <a:prstGeom prst="bentConnector3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コネクタ: カギ線 24">
            <a:extLst>
              <a:ext uri="{FF2B5EF4-FFF2-40B4-BE49-F238E27FC236}">
                <a16:creationId xmlns:a16="http://schemas.microsoft.com/office/drawing/2014/main" id="{EDB0693C-CF8B-4060-A45A-96A1B1C09574}"/>
              </a:ext>
            </a:extLst>
          </p:cNvPr>
          <p:cNvCxnSpPr>
            <a:cxnSpLocks/>
            <a:stCxn id="11" idx="2"/>
            <a:endCxn id="13" idx="0"/>
          </p:cNvCxnSpPr>
          <p:nvPr/>
        </p:nvCxnSpPr>
        <p:spPr>
          <a:xfrm rot="5400000">
            <a:off x="5029015" y="1533504"/>
            <a:ext cx="1064353" cy="2361966"/>
          </a:xfrm>
          <a:prstGeom prst="bentConnector3">
            <a:avLst>
              <a:gd name="adj1" fmla="val 50000"/>
            </a:avLst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F789AB20-0D94-4427-A872-C36A4B2CA186}"/>
              </a:ext>
            </a:extLst>
          </p:cNvPr>
          <p:cNvSpPr txBox="1"/>
          <p:nvPr/>
        </p:nvSpPr>
        <p:spPr>
          <a:xfrm>
            <a:off x="744244" y="1100850"/>
            <a:ext cx="19570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esent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A9827C4A-5084-4FF5-9044-37CE6EF2FA08}"/>
              </a:ext>
            </a:extLst>
          </p:cNvPr>
          <p:cNvSpPr txBox="1"/>
          <p:nvPr/>
        </p:nvSpPr>
        <p:spPr>
          <a:xfrm>
            <a:off x="5772037" y="1100850"/>
            <a:ext cx="19428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sent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83E31F7E-F4B7-4B4D-A496-8F3977DD5404}"/>
              </a:ext>
            </a:extLst>
          </p:cNvPr>
          <p:cNvSpPr txBox="1"/>
          <p:nvPr/>
        </p:nvSpPr>
        <p:spPr>
          <a:xfrm>
            <a:off x="3453788" y="2348229"/>
            <a:ext cx="19488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esent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16B9DCFD-63CE-492F-9A32-91CFC5BAC816}"/>
              </a:ext>
            </a:extLst>
          </p:cNvPr>
          <p:cNvSpPr txBox="1"/>
          <p:nvPr/>
        </p:nvSpPr>
        <p:spPr>
          <a:xfrm>
            <a:off x="7831926" y="2348229"/>
            <a:ext cx="20194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sent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四角形: 角を丸くする 1">
            <a:extLst>
              <a:ext uri="{FF2B5EF4-FFF2-40B4-BE49-F238E27FC236}">
                <a16:creationId xmlns:a16="http://schemas.microsoft.com/office/drawing/2014/main" id="{F3CE3440-FD31-5983-8181-4BCF0C44F485}"/>
              </a:ext>
            </a:extLst>
          </p:cNvPr>
          <p:cNvSpPr/>
          <p:nvPr/>
        </p:nvSpPr>
        <p:spPr>
          <a:xfrm>
            <a:off x="2489929" y="41222"/>
            <a:ext cx="3052525" cy="488087"/>
          </a:xfrm>
          <a:prstGeom prst="round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kumimoji="1"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gestive adenocarcinomas: 483</a:t>
            </a:r>
            <a:endParaRPr kumimoji="1" lang="ja-JP" altLang="en-US" sz="16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直線矢印コネクタ 18">
            <a:extLst>
              <a:ext uri="{FF2B5EF4-FFF2-40B4-BE49-F238E27FC236}">
                <a16:creationId xmlns:a16="http://schemas.microsoft.com/office/drawing/2014/main" id="{DB430D86-99A7-0937-8C6D-2C3E31E36F41}"/>
              </a:ext>
            </a:extLst>
          </p:cNvPr>
          <p:cNvCxnSpPr>
            <a:cxnSpLocks/>
            <a:stCxn id="7" idx="2"/>
            <a:endCxn id="51" idx="0"/>
          </p:cNvCxnSpPr>
          <p:nvPr/>
        </p:nvCxnSpPr>
        <p:spPr>
          <a:xfrm flipH="1">
            <a:off x="1097778" y="3077580"/>
            <a:ext cx="600153" cy="344992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矢印コネクタ 19">
            <a:extLst>
              <a:ext uri="{FF2B5EF4-FFF2-40B4-BE49-F238E27FC236}">
                <a16:creationId xmlns:a16="http://schemas.microsoft.com/office/drawing/2014/main" id="{37D1896C-2C3B-0922-AE36-884CC10AAA55}"/>
              </a:ext>
            </a:extLst>
          </p:cNvPr>
          <p:cNvCxnSpPr>
            <a:cxnSpLocks/>
            <a:stCxn id="2" idx="2"/>
            <a:endCxn id="4" idx="0"/>
          </p:cNvCxnSpPr>
          <p:nvPr/>
        </p:nvCxnSpPr>
        <p:spPr>
          <a:xfrm flipH="1">
            <a:off x="4016191" y="529309"/>
            <a:ext cx="1" cy="18466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四角形: 角を丸くする 50">
            <a:extLst>
              <a:ext uri="{FF2B5EF4-FFF2-40B4-BE49-F238E27FC236}">
                <a16:creationId xmlns:a16="http://schemas.microsoft.com/office/drawing/2014/main" id="{FC355C19-4D85-382E-193C-E8DA68FE88B9}"/>
              </a:ext>
            </a:extLst>
          </p:cNvPr>
          <p:cNvSpPr/>
          <p:nvPr/>
        </p:nvSpPr>
        <p:spPr>
          <a:xfrm>
            <a:off x="119262" y="3422572"/>
            <a:ext cx="1957031" cy="357849"/>
          </a:xfrm>
          <a:prstGeom prst="round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lorectal</a:t>
            </a:r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1" name="直線矢印コネクタ 70">
            <a:extLst>
              <a:ext uri="{FF2B5EF4-FFF2-40B4-BE49-F238E27FC236}">
                <a16:creationId xmlns:a16="http://schemas.microsoft.com/office/drawing/2014/main" id="{35408BEB-EDC9-7D75-EB5A-57931DBFE1C6}"/>
              </a:ext>
            </a:extLst>
          </p:cNvPr>
          <p:cNvCxnSpPr>
            <a:cxnSpLocks/>
            <a:stCxn id="13" idx="2"/>
            <a:endCxn id="72" idx="0"/>
          </p:cNvCxnSpPr>
          <p:nvPr/>
        </p:nvCxnSpPr>
        <p:spPr>
          <a:xfrm flipH="1">
            <a:off x="3826996" y="4508535"/>
            <a:ext cx="553212" cy="360019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四角形: 角を丸くする 71">
            <a:extLst>
              <a:ext uri="{FF2B5EF4-FFF2-40B4-BE49-F238E27FC236}">
                <a16:creationId xmlns:a16="http://schemas.microsoft.com/office/drawing/2014/main" id="{354E191C-73DF-4556-C1F0-C993BF865ADC}"/>
              </a:ext>
            </a:extLst>
          </p:cNvPr>
          <p:cNvSpPr/>
          <p:nvPr/>
        </p:nvSpPr>
        <p:spPr>
          <a:xfrm>
            <a:off x="2848480" y="4868554"/>
            <a:ext cx="1957031" cy="357849"/>
          </a:xfrm>
          <a:prstGeom prst="round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ncreas</a:t>
            </a:r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0D08C79C-FC10-73BF-DC22-70B6EABE885A}"/>
              </a:ext>
            </a:extLst>
          </p:cNvPr>
          <p:cNvSpPr txBox="1"/>
          <p:nvPr/>
        </p:nvSpPr>
        <p:spPr>
          <a:xfrm>
            <a:off x="9522722" y="3854858"/>
            <a:ext cx="20194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sent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11BD0550-EDEC-E3EE-5947-9B74D1D218D6}"/>
              </a:ext>
            </a:extLst>
          </p:cNvPr>
          <p:cNvSpPr txBox="1"/>
          <p:nvPr/>
        </p:nvSpPr>
        <p:spPr>
          <a:xfrm>
            <a:off x="6159220" y="3851666"/>
            <a:ext cx="19488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esent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3" name="直線矢印コネクタ 82">
            <a:extLst>
              <a:ext uri="{FF2B5EF4-FFF2-40B4-BE49-F238E27FC236}">
                <a16:creationId xmlns:a16="http://schemas.microsoft.com/office/drawing/2014/main" id="{A7B248B5-D95D-D1C7-BF78-2E74A2A348DF}"/>
              </a:ext>
            </a:extLst>
          </p:cNvPr>
          <p:cNvCxnSpPr>
            <a:cxnSpLocks/>
            <a:stCxn id="14" idx="2"/>
            <a:endCxn id="84" idx="0"/>
          </p:cNvCxnSpPr>
          <p:nvPr/>
        </p:nvCxnSpPr>
        <p:spPr>
          <a:xfrm flipH="1">
            <a:off x="6520970" y="6060205"/>
            <a:ext cx="600860" cy="351419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四角形: 角を丸くする 83">
            <a:extLst>
              <a:ext uri="{FF2B5EF4-FFF2-40B4-BE49-F238E27FC236}">
                <a16:creationId xmlns:a16="http://schemas.microsoft.com/office/drawing/2014/main" id="{4D0E2CC9-038C-C819-CAC7-1A8DFA917A7B}"/>
              </a:ext>
            </a:extLst>
          </p:cNvPr>
          <p:cNvSpPr/>
          <p:nvPr/>
        </p:nvSpPr>
        <p:spPr>
          <a:xfrm>
            <a:off x="5542454" y="6411624"/>
            <a:ext cx="1957031" cy="357849"/>
          </a:xfrm>
          <a:prstGeom prst="round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iliary tract</a:t>
            </a:r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テキスト ボックス 126">
            <a:extLst>
              <a:ext uri="{FF2B5EF4-FFF2-40B4-BE49-F238E27FC236}">
                <a16:creationId xmlns:a16="http://schemas.microsoft.com/office/drawing/2014/main" id="{84FBDFA8-C55D-0B4A-FA59-FEBC7F6BF0A4}"/>
              </a:ext>
            </a:extLst>
          </p:cNvPr>
          <p:cNvSpPr txBox="1"/>
          <p:nvPr/>
        </p:nvSpPr>
        <p:spPr>
          <a:xfrm>
            <a:off x="73476" y="3826738"/>
            <a:ext cx="28934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ensitivity</a:t>
            </a:r>
            <a:r>
              <a: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80.9%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pecificity</a:t>
            </a:r>
            <a:r>
              <a: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98.2%</a:t>
            </a:r>
            <a:endParaRPr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ositive likelihood ratio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44.3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テキスト ボックス 128">
            <a:extLst>
              <a:ext uri="{FF2B5EF4-FFF2-40B4-BE49-F238E27FC236}">
                <a16:creationId xmlns:a16="http://schemas.microsoft.com/office/drawing/2014/main" id="{4EAF560A-7384-795D-9773-BA4D3557EE92}"/>
              </a:ext>
            </a:extLst>
          </p:cNvPr>
          <p:cNvSpPr txBox="1"/>
          <p:nvPr/>
        </p:nvSpPr>
        <p:spPr>
          <a:xfrm>
            <a:off x="2815571" y="5266293"/>
            <a:ext cx="28934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ensitivity</a:t>
            </a:r>
            <a:r>
              <a: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90.4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pecificity</a:t>
            </a:r>
            <a:r>
              <a: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86.4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  <a:endParaRPr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ositive likelihood ratio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6.6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テキスト ボックス 129">
            <a:extLst>
              <a:ext uri="{FF2B5EF4-FFF2-40B4-BE49-F238E27FC236}">
                <a16:creationId xmlns:a16="http://schemas.microsoft.com/office/drawing/2014/main" id="{0AFDBB23-0B86-A0EA-2F62-341856B478C7}"/>
              </a:ext>
            </a:extLst>
          </p:cNvPr>
          <p:cNvSpPr txBox="1"/>
          <p:nvPr/>
        </p:nvSpPr>
        <p:spPr>
          <a:xfrm>
            <a:off x="3509696" y="6268736"/>
            <a:ext cx="29404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ensitivity</a:t>
            </a:r>
            <a:r>
              <a: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20.2%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pecificity</a:t>
            </a:r>
            <a:r>
              <a: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97.8%</a:t>
            </a:r>
            <a:endParaRPr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ositive likelihood ratio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9.2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1" name="直線矢印コネクタ 130">
            <a:extLst>
              <a:ext uri="{FF2B5EF4-FFF2-40B4-BE49-F238E27FC236}">
                <a16:creationId xmlns:a16="http://schemas.microsoft.com/office/drawing/2014/main" id="{E80601C2-124B-F269-0279-035539287E9C}"/>
              </a:ext>
            </a:extLst>
          </p:cNvPr>
          <p:cNvCxnSpPr>
            <a:cxnSpLocks/>
            <a:stCxn id="15" idx="2"/>
            <a:endCxn id="132" idx="0"/>
          </p:cNvCxnSpPr>
          <p:nvPr/>
        </p:nvCxnSpPr>
        <p:spPr>
          <a:xfrm>
            <a:off x="10535977" y="6060203"/>
            <a:ext cx="445657" cy="276485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四角形: 角を丸くする 131">
            <a:extLst>
              <a:ext uri="{FF2B5EF4-FFF2-40B4-BE49-F238E27FC236}">
                <a16:creationId xmlns:a16="http://schemas.microsoft.com/office/drawing/2014/main" id="{2C18C86F-F5D0-80C0-55BD-A2B4AE499A3C}"/>
              </a:ext>
            </a:extLst>
          </p:cNvPr>
          <p:cNvSpPr/>
          <p:nvPr/>
        </p:nvSpPr>
        <p:spPr>
          <a:xfrm>
            <a:off x="10003118" y="6336688"/>
            <a:ext cx="1957031" cy="357849"/>
          </a:xfrm>
          <a:prstGeom prst="round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omach</a:t>
            </a:r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id="{5308715A-E8DB-EFFF-A201-AC5630A911F3}"/>
              </a:ext>
            </a:extLst>
          </p:cNvPr>
          <p:cNvSpPr txBox="1"/>
          <p:nvPr/>
        </p:nvSpPr>
        <p:spPr>
          <a:xfrm>
            <a:off x="7989336" y="6260570"/>
            <a:ext cx="281178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ensitivity</a:t>
            </a:r>
            <a:r>
              <a: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65.0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pecificity</a:t>
            </a:r>
            <a:r>
              <a: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77.8%</a:t>
            </a:r>
            <a:endParaRPr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ositive likelihood ratio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2.9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0E09654-8A60-E2AF-6C73-2401ED4DA318}"/>
              </a:ext>
            </a:extLst>
          </p:cNvPr>
          <p:cNvSpPr txBox="1"/>
          <p:nvPr/>
        </p:nvSpPr>
        <p:spPr>
          <a:xfrm>
            <a:off x="624965" y="5897926"/>
            <a:ext cx="12330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8</a:t>
            </a:r>
          </a:p>
        </p:txBody>
      </p:sp>
    </p:spTree>
    <p:extLst>
      <p:ext uri="{BB962C8B-B14F-4D97-AF65-F5344CB8AC3E}">
        <p14:creationId xmlns:p14="http://schemas.microsoft.com/office/powerpoint/2010/main" val="1737679525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IMING" val="|20.2"/>
</p:tagLst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480</TotalTime>
  <Words>583</Words>
  <Application>Microsoft Office PowerPoint</Application>
  <PresentationFormat>ワイド画面</PresentationFormat>
  <Paragraphs>171</Paragraphs>
  <Slides>8</Slides>
  <Notes>8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8</vt:i4>
      </vt:variant>
    </vt:vector>
  </HeadingPairs>
  <TitlesOfParts>
    <vt:vector size="15" baseType="lpstr">
      <vt:lpstr>游ゴシック</vt:lpstr>
      <vt:lpstr>游ゴシック Light</vt:lpstr>
      <vt:lpstr>游明朝</vt:lpstr>
      <vt:lpstr>Arial</vt:lpstr>
      <vt:lpstr>Arial</vt:lpstr>
      <vt:lpstr>Calibri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石川 麻倫</dc:creator>
  <cp:lastModifiedBy>Marin Ishikawa</cp:lastModifiedBy>
  <cp:revision>116</cp:revision>
  <cp:lastPrinted>2022-03-22T07:36:23Z</cp:lastPrinted>
  <dcterms:created xsi:type="dcterms:W3CDTF">2022-03-02T07:55:07Z</dcterms:created>
  <dcterms:modified xsi:type="dcterms:W3CDTF">2024-04-14T01:18:49Z</dcterms:modified>
</cp:coreProperties>
</file>